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56" r:id="rId2"/>
    <p:sldId id="302" r:id="rId3"/>
    <p:sldId id="270" r:id="rId4"/>
    <p:sldId id="283" r:id="rId5"/>
    <p:sldId id="284" r:id="rId6"/>
    <p:sldId id="280" r:id="rId7"/>
    <p:sldId id="263" r:id="rId8"/>
    <p:sldId id="264" r:id="rId9"/>
    <p:sldId id="265" r:id="rId10"/>
    <p:sldId id="267" r:id="rId11"/>
    <p:sldId id="300" r:id="rId12"/>
    <p:sldId id="301"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D9245CF4-7BCE-4844-8F84-F20216256583}" v="28" dt="2025-10-04T18:16:19.63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3896" autoAdjust="0"/>
    <p:restoredTop sz="95753"/>
  </p:normalViewPr>
  <p:slideViewPr>
    <p:cSldViewPr snapToGrid="0">
      <p:cViewPr varScale="1">
        <p:scale>
          <a:sx n="105" d="100"/>
          <a:sy n="105" d="100"/>
        </p:scale>
        <p:origin x="192" y="448"/>
      </p:cViewPr>
      <p:guideLst/>
    </p:cSldViewPr>
  </p:slideViewPr>
  <p:notesTextViewPr>
    <p:cViewPr>
      <p:scale>
        <a:sx n="1" d="1"/>
        <a:sy n="1" d="1"/>
      </p:scale>
      <p:origin x="0" y="0"/>
    </p:cViewPr>
  </p:notesTextViewPr>
  <p:notesViewPr>
    <p:cSldViewPr snapToGrid="0">
      <p:cViewPr>
        <p:scale>
          <a:sx n="160" d="100"/>
          <a:sy n="160" d="100"/>
        </p:scale>
        <p:origin x="2312" y="144"/>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19"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D285A7-89FA-2948-860F-FBEC3367B2A3}" type="datetimeFigureOut">
              <a:rPr lang="en-US" smtClean="0"/>
              <a:t>10/25/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976DE3B-0F45-D24B-842F-104A05C73C4B}" type="slidenum">
              <a:rPr lang="en-US" smtClean="0"/>
              <a:t>‹#›</a:t>
            </a:fld>
            <a:endParaRPr lang="en-US"/>
          </a:p>
        </p:txBody>
      </p:sp>
    </p:spTree>
    <p:extLst>
      <p:ext uri="{BB962C8B-B14F-4D97-AF65-F5344CB8AC3E}">
        <p14:creationId xmlns:p14="http://schemas.microsoft.com/office/powerpoint/2010/main" val="46940322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youtube.com/watch?v=iSDkvvY3SHc&amp;t=369s"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r>
              <a:rPr lang="en-US" sz="1800" dirty="0">
                <a:solidFill>
                  <a:srgbClr val="000000"/>
                </a:solidFill>
                <a:effectLst/>
                <a:latin typeface="Times New Roman" panose="02020603050405020304" pitchFamily="18" charset="0"/>
                <a:ea typeface="Calibri" panose="020F0502020204030204" pitchFamily="34" charset="0"/>
              </a:rPr>
              <a:t>Hello, everyone! Today's presentation is on Abscess Incision and Drainage (I&amp;D). We're here to cover the procedural steps involved in effectively managing abscesses using incision and drainage techniques. Our exploration will include techniques necessary for proficient execution. So, let's kick things off by diving into the fundamental elements and key components of Abscess I&amp;D.</a:t>
            </a:r>
            <a:r>
              <a:rPr lang="en-US" dirty="0">
                <a:effectLst/>
              </a:rPr>
              <a:t> </a:t>
            </a:r>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1</a:t>
            </a:fld>
            <a:endParaRPr lang="en-US"/>
          </a:p>
        </p:txBody>
      </p:sp>
    </p:spTree>
    <p:extLst>
      <p:ext uri="{BB962C8B-B14F-4D97-AF65-F5344CB8AC3E}">
        <p14:creationId xmlns:p14="http://schemas.microsoft.com/office/powerpoint/2010/main" val="352843010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st capsule removal: Locate and firmly grasp the capsule with a hemostat. Bluntly dissect and remove the entire capsule gently.”</a:t>
            </a:r>
          </a:p>
          <a:p>
            <a:pPr marL="342900" marR="0" lvl="0" indent="-342900">
              <a:spcBef>
                <a:spcPts val="0"/>
              </a:spcBef>
              <a:spcAft>
                <a:spcPts val="0"/>
              </a:spcAft>
              <a:buSzPts val="1000"/>
              <a:buFont typeface="Symbol" pitchFamily="2" charset="2"/>
              <a:buChar char=""/>
              <a:tabLst>
                <a:tab pos="457200" algn="l"/>
              </a:tabLst>
            </a:pPr>
            <a:r>
              <a:rPr lang="en-US" sz="18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acking considerations: For larger defects, contemplate iodoform gauze packing, leaving approximately 1-inch protruding. In select cases, the use of a drain may be appropriate."</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ressing application: Apply antibiotic ointment and the suitable dressing to the treated area."</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10</a:t>
            </a:fld>
            <a:endParaRPr lang="en-US"/>
          </a:p>
        </p:txBody>
      </p:sp>
    </p:spTree>
    <p:extLst>
      <p:ext uri="{BB962C8B-B14F-4D97-AF65-F5344CB8AC3E}">
        <p14:creationId xmlns:p14="http://schemas.microsoft.com/office/powerpoint/2010/main" val="5779903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 to the 'Abscess I&amp;D' YouTube video for a visual demonstration of the lecture's discussed steps on abscess incision and drainage."</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e video complements the lecture text, offering a practical visual component to reinforce the learned techniques."</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800" kern="0" dirty="0">
              <a:effectLst/>
              <a:latin typeface="Times New Roman" panose="02020603050405020304" pitchFamily="18" charset="0"/>
              <a:ea typeface="Times New Roman" panose="02020603050405020304" pitchFamily="18" charset="0"/>
              <a:cs typeface="Times New Roman" panose="02020603050405020304" pitchFamily="18"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0" dirty="0">
                <a:effectLst/>
                <a:latin typeface="Times New Roman" panose="02020603050405020304" pitchFamily="18" charset="0"/>
                <a:ea typeface="Times New Roman" panose="02020603050405020304" pitchFamily="18" charset="0"/>
                <a:cs typeface="Times New Roman" panose="02020603050405020304" pitchFamily="18" charset="0"/>
              </a:rPr>
              <a:t>Hippo Education. Urgent Care Bootcamp: Soft Tissue Abscess Drainage. In: Hippo Education. In: YouTube. </a:t>
            </a:r>
            <a:r>
              <a:rPr lang="en-US" sz="1800" u="sng" kern="0" dirty="0">
                <a:solidFill>
                  <a:srgbClr val="0000FF"/>
                </a:solidFill>
                <a:effectLst/>
                <a:latin typeface="Times New Roman" panose="02020603050405020304" pitchFamily="18" charset="0"/>
                <a:ea typeface="Times New Roman" panose="02020603050405020304" pitchFamily="18" charset="0"/>
                <a:cs typeface="Times New Roman" panose="02020603050405020304" pitchFamily="18" charset="0"/>
                <a:hlinkClick r:id="rId3"/>
              </a:rPr>
              <a:t>https://www.youtube.com/watch?v=iSDkvvY3SHc&amp;t=369s</a:t>
            </a:r>
            <a:r>
              <a:rPr lang="en-US" sz="1800" kern="0" dirty="0">
                <a:effectLst/>
                <a:latin typeface="Times New Roman" panose="02020603050405020304" pitchFamily="18" charset="0"/>
                <a:ea typeface="Times New Roman" panose="02020603050405020304" pitchFamily="18" charset="0"/>
                <a:cs typeface="Times New Roman" panose="02020603050405020304" pitchFamily="18" charset="0"/>
              </a:rPr>
              <a:t>  February 28, 2020. Copyright type: Not specified.</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11</a:t>
            </a:fld>
            <a:endParaRPr lang="en-US"/>
          </a:p>
        </p:txBody>
      </p:sp>
    </p:spTree>
    <p:extLst>
      <p:ext uri="{BB962C8B-B14F-4D97-AF65-F5344CB8AC3E}">
        <p14:creationId xmlns:p14="http://schemas.microsoft.com/office/powerpoint/2010/main" val="234693685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12</a:t>
            </a:fld>
            <a:endParaRPr lang="en-US"/>
          </a:p>
        </p:txBody>
      </p:sp>
    </p:spTree>
    <p:extLst>
      <p:ext uri="{BB962C8B-B14F-4D97-AF65-F5344CB8AC3E}">
        <p14:creationId xmlns:p14="http://schemas.microsoft.com/office/powerpoint/2010/main" val="19603600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701675" y="1143000"/>
            <a:ext cx="5486400" cy="3086100"/>
          </a:xfrm>
        </p:spPr>
        <p:txBody>
          <a:bodyPr/>
          <a:lstStyle/>
          <a:p>
            <a:endParaRPr lang="en-US"/>
          </a:p>
        </p:txBody>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u="none" strike="noStrike" kern="1200" dirty="0">
                <a:solidFill>
                  <a:schemeClr val="tx1"/>
                </a:solidFill>
                <a:effectLst/>
                <a:latin typeface="+mn-lt"/>
                <a:ea typeface="+mn-ea"/>
                <a:cs typeface="+mn-cs"/>
              </a:rPr>
              <a:t>*Methicillin-resistant Staphylococcus aureus</a:t>
            </a: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2</a:t>
            </a:fld>
            <a:endParaRPr lang="en-US"/>
          </a:p>
        </p:txBody>
      </p:sp>
    </p:spTree>
    <p:extLst>
      <p:ext uri="{BB962C8B-B14F-4D97-AF65-F5344CB8AC3E}">
        <p14:creationId xmlns:p14="http://schemas.microsoft.com/office/powerpoint/2010/main" val="13581061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a:spcBef>
                <a:spcPts val="0"/>
              </a:spcBef>
              <a:spcAft>
                <a:spcPts val="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Here is the lecture outline where we will be discussing the following topics starting with those in red font:</a:t>
            </a:r>
          </a:p>
          <a:p>
            <a:pPr marL="0" marR="0">
              <a:spcBef>
                <a:spcPts val="0"/>
              </a:spcBef>
              <a:spcAft>
                <a:spcPts val="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Local anesthetic use:</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We'll be exploring the significance of local anesthesia. It involves numbing specific body parts for painless procedures. Correct administration and potential risks will be emphasized."</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800" b="1" kern="100" dirty="0">
                <a:effectLst/>
                <a:latin typeface="Times New Roman" panose="02020603050405020304" pitchFamily="18" charset="0"/>
                <a:ea typeface="Calibri" panose="020F0502020204030204" pitchFamily="34" charset="0"/>
                <a:cs typeface="Times New Roman" panose="02020603050405020304" pitchFamily="18" charset="0"/>
              </a:rPr>
              <a:t>Field block:</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We'll discuss field blocks, which entail injecting anesthetic around a surgical area for broader numbing. Various techniques will be explained, highlighting precision and potential complications."</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3</a:t>
            </a:fld>
            <a:endParaRPr lang="en-US"/>
          </a:p>
        </p:txBody>
      </p:sp>
    </p:spTree>
    <p:extLst>
      <p:ext uri="{BB962C8B-B14F-4D97-AF65-F5344CB8AC3E}">
        <p14:creationId xmlns:p14="http://schemas.microsoft.com/office/powerpoint/2010/main" val="3222572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We're focusing on the process of drawing up anesthetic from a vial. It begins by wiping the top of the vial with alcohol. This step is necessary only if using a previously used vial."</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Next, draw air into the syringe, using an 18-gauge needle, to match the volume of fluid intended for withdrawal."</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Insert the needle into the vial, inject the drawn air, invert the vial, and proceed to withdraw the required fluid."</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Afterward, exchange the needle for a 27-30 gauge, 1 – 1.5 inches in size, and ensure any air in the syringe is cleared."</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800" kern="100" dirty="0">
                <a:effectLst/>
                <a:latin typeface="Times New Roman" panose="02020603050405020304" pitchFamily="18" charset="0"/>
                <a:ea typeface="Calibri" panose="020F0502020204030204" pitchFamily="34" charset="0"/>
                <a:cs typeface="Times New Roman" panose="02020603050405020304" pitchFamily="18" charset="0"/>
              </a:rPr>
              <a:t>"For sterile technique, a helper can assist in alcohol-wiping the vial and holding it upside down. They touch the rubber septum to the anesthetist’s needle, allowing the anesthetist to insert the needle and withdraw the fluid without direct contact with the vial."</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4</a:t>
            </a:fld>
            <a:endParaRPr lang="en-US"/>
          </a:p>
        </p:txBody>
      </p:sp>
    </p:spTree>
    <p:extLst>
      <p:ext uri="{BB962C8B-B14F-4D97-AF65-F5344CB8AC3E}">
        <p14:creationId xmlns:p14="http://schemas.microsoft.com/office/powerpoint/2010/main" val="18760061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a:xfrm>
            <a:off x="685800" y="4400549"/>
            <a:ext cx="5651390" cy="3932417"/>
          </a:xfrm>
        </p:spPr>
        <p:txBody>
          <a:bodyPr/>
          <a:lstStyle/>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Field Block is a technique used to provide anesthesia to a confined area by creating a 'wall' of anesthetic solution along the nerves supplying the operative field."</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To initiate a field block:</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spcBef>
                <a:spcPts val="0"/>
              </a:spcBef>
              <a:spcAft>
                <a:spcPts val="0"/>
              </a:spcAft>
              <a:buSzPts val="1000"/>
              <a:buFont typeface="Symbol" pitchFamily="2" charset="2"/>
              <a:buChar char=""/>
              <a:tabLst>
                <a:tab pos="9144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Begin by decontaminating the skin using an alcohol wipe or povidone-iodine.</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spcBef>
                <a:spcPts val="0"/>
              </a:spcBef>
              <a:spcAft>
                <a:spcPts val="0"/>
              </a:spcAft>
              <a:buSzPts val="1000"/>
              <a:buFont typeface="Symbol" pitchFamily="2" charset="2"/>
              <a:buChar char=""/>
              <a:tabLst>
                <a:tab pos="9144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Employ a needle (27-30 gauge) to access the subcutaneous tissue just below the dermi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Inject a small amount of fluid, typically lidocaine with or without epinephrine, and advance the needle while continuing the injection proces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Some providers fully advance the needle and inject while withdrawing. Alternatively, if there's a pre-existing laceration, enter the skin through the lacerated tissue's edge."</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Continue surrounding the area for excision or lesion, ensuring ample coverage without directly infiltrating the lesion itself."</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Ensure the block's width encompasses planned work (eg, sutures, excisions, incisions). Avoid using epinephrine on areas with limited blood supply (fingers, toes, penis, nose, earlobes, tissue flap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Advantages of field blocks include longer anesthesia duration and minimal distortion of the operative field. It's a suitable anesthesia method for many ambulatory procedure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5</a:t>
            </a:fld>
            <a:endParaRPr lang="en-US"/>
          </a:p>
        </p:txBody>
      </p:sp>
    </p:spTree>
    <p:extLst>
      <p:ext uri="{BB962C8B-B14F-4D97-AF65-F5344CB8AC3E}">
        <p14:creationId xmlns:p14="http://schemas.microsoft.com/office/powerpoint/2010/main" val="271930017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0" marR="0">
              <a:spcBef>
                <a:spcPts val="0"/>
              </a:spcBef>
              <a:spcAft>
                <a:spcPts val="0"/>
              </a:spcAft>
            </a:pPr>
            <a:r>
              <a:rPr lang="en-US" dirty="0"/>
              <a:t>“Now we will be moving on to: “</a:t>
            </a:r>
          </a:p>
          <a:p>
            <a:pPr marL="0" marR="0">
              <a:spcBef>
                <a:spcPts val="0"/>
              </a:spcBef>
              <a:spcAft>
                <a:spcPts val="0"/>
              </a:spcAft>
            </a:pP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Cysts and abscesse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Differentiating cysts and abscesses will be a focus. Causes, symptoms, and treatments for each condition will be outlined."</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Cyst excision:</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Cyst excision involves surgically removing cysts. Our discussion will cover pre-operative evaluation, excision techniques, post-operative care, and potential complications."</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spcBef>
                <a:spcPts val="0"/>
              </a:spcBef>
              <a:spcAft>
                <a:spcPts val="0"/>
              </a:spcAft>
            </a:pPr>
            <a:r>
              <a:rPr lang="en-US" sz="1200" b="1" kern="100" dirty="0">
                <a:effectLst/>
                <a:latin typeface="Times New Roman" panose="02020603050405020304" pitchFamily="18" charset="0"/>
                <a:ea typeface="Calibri" panose="020F0502020204030204" pitchFamily="34" charset="0"/>
                <a:cs typeface="Times New Roman" panose="02020603050405020304" pitchFamily="18" charset="0"/>
              </a:rPr>
              <a:t>Abscess incision and drainage:</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Arial" panose="020B0604020202020204" pitchFamily="34" charset="0"/>
              <a:buChar char="•"/>
              <a:tabLst>
                <a:tab pos="457200" algn="l"/>
              </a:tabLst>
            </a:pPr>
            <a:r>
              <a:rPr lang="en-US" sz="1200" kern="100" dirty="0">
                <a:effectLst/>
                <a:latin typeface="Times New Roman" panose="02020603050405020304" pitchFamily="18" charset="0"/>
                <a:ea typeface="Calibri" panose="020F0502020204030204" pitchFamily="34" charset="0"/>
                <a:cs typeface="Times New Roman" panose="02020603050405020304" pitchFamily="18" charset="0"/>
              </a:rPr>
              <a:t>"We'll explore abscess incision and drainage. This procedure involves making incisions to drain accumulated pus. Proper technique, post-procedure care, and potential complications will be detailed."</a:t>
            </a: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6</a:t>
            </a:fld>
            <a:endParaRPr lang="en-US"/>
          </a:p>
        </p:txBody>
      </p:sp>
    </p:spTree>
    <p:extLst>
      <p:ext uri="{BB962C8B-B14F-4D97-AF65-F5344CB8AC3E}">
        <p14:creationId xmlns:p14="http://schemas.microsoft.com/office/powerpoint/2010/main" val="276669152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sts manifest as tissue inclusions enveloped by a capsule containing fluid, tissue, secretions, or gas. They can be infected (termed an infected cyst or abscess) or non-infected."</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sts vary in nomenclature based on their location and the cells' function. Examples include sebaceous cysts (containing sebum), pilar cysts (associated with hair follicles), Meibomian cysts (located in the eyelid), and ganglion cysts (related to the synovium)."</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n abscess denotes a localized infection characterized by pus surrounded by inflamed tissue. It may be encapsulated and can encompass foreign bodies, sebum, or microbes."</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bscesses are named based on their location. Examples encompass furuncles/carbuncles or boils (on the skin), paronychia (around the nail), felon (on fingers or toes), and hordeolum/chalazion (occurring in the eyelid)."</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a:xfrm>
            <a:off x="3886200" y="8685213"/>
            <a:ext cx="2971800" cy="458787"/>
          </a:xfrm>
        </p:spPr>
        <p:txBody>
          <a:bodyPr/>
          <a:lstStyle/>
          <a:p>
            <a:fld id="{C976DE3B-0F45-D24B-842F-104A05C73C4B}" type="slidenum">
              <a:rPr lang="en-US" smtClean="0"/>
              <a:t>7</a:t>
            </a:fld>
            <a:endParaRPr lang="en-US"/>
          </a:p>
        </p:txBody>
      </p:sp>
    </p:spTree>
    <p:extLst>
      <p:ext uri="{BB962C8B-B14F-4D97-AF65-F5344CB8AC3E}">
        <p14:creationId xmlns:p14="http://schemas.microsoft.com/office/powerpoint/2010/main" val="20238653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e most common infecting organisms for abscesses are usually Staphylococcus aureus, occasionally Streptococcus, or a mix of species, varying by the abscess's location."</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or small, superficial abscesses (&lt; 5mm), initial conservative treatment involves warm, moist compresses to facilitate spontaneous drainage."</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200" b="0" kern="1200" dirty="0">
                <a:solidFill>
                  <a:schemeClr val="tx1"/>
                </a:solidFill>
                <a:effectLst/>
                <a:latin typeface="+mn-lt"/>
                <a:ea typeface="+mn-ea"/>
                <a:cs typeface="+mn-cs"/>
              </a:rPr>
              <a:t>“</a:t>
            </a:r>
            <a:r>
              <a:rPr lang="en-US" sz="1800" b="0" kern="1200" dirty="0">
                <a:solidFill>
                  <a:schemeClr val="tx1"/>
                </a:solidFill>
                <a:effectLst/>
                <a:latin typeface="Times New Roman" panose="02020603050405020304" pitchFamily="18" charset="0"/>
                <a:cs typeface="Times New Roman" panose="02020603050405020304" pitchFamily="18" charset="0"/>
              </a:rPr>
              <a:t>While purulence is often associated with MRSA, current Infectious Diseases Society of America  (IDSA) guidance emphasizes evaluating patient and community risk factors rather than assuming all purulent infections are MRSA.</a:t>
            </a:r>
            <a:r>
              <a:rPr lang="en-US" sz="1800" b="0" i="1" kern="1200" dirty="0">
                <a:solidFill>
                  <a:schemeClr val="tx1"/>
                </a:solidFill>
                <a:effectLst/>
                <a:latin typeface="Times New Roman" panose="02020603050405020304" pitchFamily="18" charset="0"/>
                <a:cs typeface="Times New Roman" panose="02020603050405020304" pitchFamily="18" charset="0"/>
              </a:rPr>
              <a:t>”</a:t>
            </a: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e primary treatment of choice remains incision and drainage (I&amp;D) for abscesses, promoting pus evacuation."</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SzPts val="1000"/>
              <a:buFont typeface="Symbol" pitchFamily="2" charset="2"/>
              <a:buChar char=""/>
              <a:tabLst>
                <a:tab pos="457200" algn="l"/>
              </a:tabLst>
            </a:pPr>
            <a:r>
              <a:rPr lang="en-US" sz="18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sess risks associated with abscess locations such as the facial triangle, axilla, or perianal areas. For instance, for perirectal abscesses, consider a CT pelvis with contrast to evaluate."</a:t>
            </a:r>
            <a:endParaRPr lang="en-US" sz="1800" kern="1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8</a:t>
            </a:fld>
            <a:endParaRPr lang="en-US"/>
          </a:p>
        </p:txBody>
      </p:sp>
    </p:spTree>
    <p:extLst>
      <p:ext uri="{BB962C8B-B14F-4D97-AF65-F5344CB8AC3E}">
        <p14:creationId xmlns:p14="http://schemas.microsoft.com/office/powerpoint/2010/main" val="260987823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pPr algn="l">
              <a:buFont typeface="Arial" panose="020B0604020202020204" pitchFamily="34" charset="0"/>
              <a:buChar char="•"/>
            </a:pPr>
            <a:r>
              <a:rPr lang="en-US" b="0" i="0" dirty="0">
                <a:effectLst/>
                <a:latin typeface="Söhne"/>
              </a:rPr>
              <a:t>"Perform the Abscess Incision and Drainage (I&amp;D) procedure aseptically: Begin by cleansing the area using alcohol or povidone-iodine, followed by applying a sterile drape. Utilize sterile instruments and gloves throughout the process."</a:t>
            </a:r>
          </a:p>
          <a:p>
            <a:pPr algn="l">
              <a:buFont typeface="Arial" panose="020B0604020202020204" pitchFamily="34" charset="0"/>
              <a:buChar char="•"/>
            </a:pPr>
            <a:r>
              <a:rPr lang="en-US" b="0" i="0" dirty="0">
                <a:effectLst/>
                <a:latin typeface="Söhne"/>
              </a:rPr>
              <a:t>"Anesthetize the area using a 1-2% lidocaine with or without epinephrine field block. This step can precede the sterile process initiation."</a:t>
            </a:r>
          </a:p>
          <a:p>
            <a:pPr algn="l">
              <a:buFont typeface="Arial" panose="020B0604020202020204" pitchFamily="34" charset="0"/>
              <a:buChar char="•"/>
            </a:pPr>
            <a:r>
              <a:rPr lang="en-US" b="0" i="0" dirty="0">
                <a:effectLst/>
                <a:latin typeface="Söhne"/>
              </a:rPr>
              <a:t>"Use a pointed no. 11 scalpel to create a straight incision of adequate size for drainage. Ensure protective gear, including face/eye shields, is worn. Larger lesions may require an elliptical incision."</a:t>
            </a:r>
          </a:p>
          <a:p>
            <a:pPr algn="l">
              <a:buFont typeface="Arial" panose="020B0604020202020204" pitchFamily="34" charset="0"/>
              <a:buChar char="•"/>
            </a:pPr>
            <a:r>
              <a:rPr lang="en-US" b="0" i="0" dirty="0">
                <a:effectLst/>
                <a:latin typeface="Söhne"/>
              </a:rPr>
              <a:t>"During drainage, as the blade enters the capsule, contents may self-release. Manual pressure might be necessary. Use a blunt tool to explore the capsule, disrupting loculations. Continue until only blood is observed."</a:t>
            </a:r>
          </a:p>
          <a:p>
            <a:pPr algn="l">
              <a:buFont typeface="Arial" panose="020B0604020202020204" pitchFamily="34" charset="0"/>
              <a:buChar char="•"/>
            </a:pPr>
            <a:r>
              <a:rPr lang="en-US" b="0" i="0" dirty="0">
                <a:effectLst/>
                <a:latin typeface="Söhne"/>
              </a:rPr>
              <a:t>"For culture and sensitivity (C&amp;S), obtain specimens from the expressed contents rather than the overlying skin."</a:t>
            </a:r>
          </a:p>
          <a:p>
            <a:endParaRPr lang="en-US" dirty="0"/>
          </a:p>
        </p:txBody>
      </p:sp>
      <p:sp>
        <p:nvSpPr>
          <p:cNvPr id="4" name="Slide Number Placeholder 3"/>
          <p:cNvSpPr>
            <a:spLocks noGrp="1"/>
          </p:cNvSpPr>
          <p:nvPr>
            <p:ph type="sldNum" sz="quarter" idx="5"/>
          </p:nvPr>
        </p:nvSpPr>
        <p:spPr/>
        <p:txBody>
          <a:bodyPr/>
          <a:lstStyle/>
          <a:p>
            <a:fld id="{C976DE3B-0F45-D24B-842F-104A05C73C4B}" type="slidenum">
              <a:rPr lang="en-US" smtClean="0"/>
              <a:t>9</a:t>
            </a:fld>
            <a:endParaRPr lang="en-US"/>
          </a:p>
        </p:txBody>
      </p:sp>
    </p:spTree>
    <p:extLst>
      <p:ext uri="{BB962C8B-B14F-4D97-AF65-F5344CB8AC3E}">
        <p14:creationId xmlns:p14="http://schemas.microsoft.com/office/powerpoint/2010/main" val="30213490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85E758-04B6-481E-B97D-D059F9AD633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2EF2AA8-3144-412F-9C36-333AD985DF4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315FEDC-736C-490A-877B-227B3B5A743A}"/>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5" name="Footer Placeholder 4">
            <a:extLst>
              <a:ext uri="{FF2B5EF4-FFF2-40B4-BE49-F238E27FC236}">
                <a16:creationId xmlns:a16="http://schemas.microsoft.com/office/drawing/2014/main" id="{65DC7832-D99F-4644-BA7C-6B684212C2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A47A520-4048-4FFD-8DD1-728C73A6EBDC}"/>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82085842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4739D9-2204-4637-9AB2-E1762AE42241}"/>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EA2D2287-7680-45BD-B22B-21FE7E8FDF95}"/>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B12097E-D0EB-4FB4-BB9B-9B181D0299F4}"/>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5" name="Footer Placeholder 4">
            <a:extLst>
              <a:ext uri="{FF2B5EF4-FFF2-40B4-BE49-F238E27FC236}">
                <a16:creationId xmlns:a16="http://schemas.microsoft.com/office/drawing/2014/main" id="{A7E317BC-6A02-469C-B44A-9AA530E4A4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21B29C-9931-4B19-BE49-1977AA37F7DC}"/>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230680756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0DD8046-539C-41B6-8418-E9A83139379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BABCF12-5D5D-4C00-AD74-628337EDBD44}"/>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E6EF270-9A5B-4CC3-A196-7DB8F5A4FA2B}"/>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5" name="Footer Placeholder 4">
            <a:extLst>
              <a:ext uri="{FF2B5EF4-FFF2-40B4-BE49-F238E27FC236}">
                <a16:creationId xmlns:a16="http://schemas.microsoft.com/office/drawing/2014/main" id="{D0602710-7B32-436B-BFE2-B6746F99F8E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13627DD-F39E-46CF-AAC8-98AD204015C3}"/>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17356616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1DF00F-786D-49DD-A287-E96DAC6D8A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3B60F52-06D3-4F08-A2E4-C5390BC22641}"/>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13DB344-1F49-46D2-A98D-9EBFC6996275}"/>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5" name="Footer Placeholder 4">
            <a:extLst>
              <a:ext uri="{FF2B5EF4-FFF2-40B4-BE49-F238E27FC236}">
                <a16:creationId xmlns:a16="http://schemas.microsoft.com/office/drawing/2014/main" id="{1BAED655-BD94-4081-B539-6EA933E1B2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5BD941-4FCC-4AF1-8741-C3979E096219}"/>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3719370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E7C0D1-41E9-4F6C-8695-768C4AEC6E8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0385022-FF61-41A9-9296-7A70A2C4D06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3E52912-AC32-47C7-8C3A-5D59FE4EAA15}"/>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5" name="Footer Placeholder 4">
            <a:extLst>
              <a:ext uri="{FF2B5EF4-FFF2-40B4-BE49-F238E27FC236}">
                <a16:creationId xmlns:a16="http://schemas.microsoft.com/office/drawing/2014/main" id="{B40A40AA-1DC6-4232-A923-36C27F1598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CA66AF8-A7EF-4101-88EA-195B8D510403}"/>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4050576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D4A32D-C1CF-4FC7-9C2F-BF32B165556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D6134FF-CF3F-4BE2-8940-07C06F3B623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162848F-ED62-4E0B-8E85-EA759FC3626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14A2158-0884-4C07-9CEF-33DB518A38FD}"/>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6" name="Footer Placeholder 5">
            <a:extLst>
              <a:ext uri="{FF2B5EF4-FFF2-40B4-BE49-F238E27FC236}">
                <a16:creationId xmlns:a16="http://schemas.microsoft.com/office/drawing/2014/main" id="{99F8D772-4C2C-470D-8BB5-30E00BBB8B0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A1130F4-AE2E-4B6F-A9E5-10EE7D048153}"/>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7627685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0D47EE-7359-47AE-8718-1866E8FD9FE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02857BB-6C6E-4EC3-9761-416CAE945EC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03273657-F4F6-4899-AF99-A6FE3CB12A2E}"/>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E3E4541-F902-461C-B32D-E9D4E6A8972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7F87E9DA-AD02-496D-A4FF-03713F253FF5}"/>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E0BFA51-F4A2-4AD9-8143-EAA8F82A6089}"/>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8" name="Footer Placeholder 7">
            <a:extLst>
              <a:ext uri="{FF2B5EF4-FFF2-40B4-BE49-F238E27FC236}">
                <a16:creationId xmlns:a16="http://schemas.microsoft.com/office/drawing/2014/main" id="{CA9190FE-150A-4A7B-A43C-C805E3898723}"/>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3092994-07A6-45A2-B3A1-B667878F407C}"/>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3408600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CD5D9D-FB29-40F3-B8C6-7AAA5A1AD14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9DE10F5-6D17-41CD-9000-14C03AF6011F}"/>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4" name="Footer Placeholder 3">
            <a:extLst>
              <a:ext uri="{FF2B5EF4-FFF2-40B4-BE49-F238E27FC236}">
                <a16:creationId xmlns:a16="http://schemas.microsoft.com/office/drawing/2014/main" id="{E4117A72-A426-4505-B295-E0EA4F34080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4CAB794-D61D-45C4-8683-9C03245BB287}"/>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34872346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94891F88-1CC4-41D2-899F-FCA3EAE6EF8A}"/>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3" name="Footer Placeholder 2">
            <a:extLst>
              <a:ext uri="{FF2B5EF4-FFF2-40B4-BE49-F238E27FC236}">
                <a16:creationId xmlns:a16="http://schemas.microsoft.com/office/drawing/2014/main" id="{B08701D1-162C-400C-B875-95938BB8113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7084B56-206E-45E0-922C-F8D295B67E6E}"/>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27208386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F1AB2F-432C-45DB-BB0D-549A0EFB20D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0B1804C-F5AB-4588-9FDD-4AA0C3A6588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46D328F-C73D-4D47-9385-76E33822511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9C71800A-1094-4284-AFB4-646234B606BC}"/>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6" name="Footer Placeholder 5">
            <a:extLst>
              <a:ext uri="{FF2B5EF4-FFF2-40B4-BE49-F238E27FC236}">
                <a16:creationId xmlns:a16="http://schemas.microsoft.com/office/drawing/2014/main" id="{955B7084-2F4E-4EDC-BF44-34AEEF7CF90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3AE4C01-0F33-4303-BFE3-9EC261AE55BA}"/>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161117390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3BE5F2-987A-4CB5-B171-AE7B5401748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A1B47EF-19CA-4429-B774-6CE1557499B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194230C-ADAC-49FE-AA69-0DEA14C63CE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C0278889-E75E-4432-8182-4B8A618BDB0A}"/>
              </a:ext>
            </a:extLst>
          </p:cNvPr>
          <p:cNvSpPr>
            <a:spLocks noGrp="1"/>
          </p:cNvSpPr>
          <p:nvPr>
            <p:ph type="dt" sz="half" idx="10"/>
          </p:nvPr>
        </p:nvSpPr>
        <p:spPr/>
        <p:txBody>
          <a:bodyPr/>
          <a:lstStyle/>
          <a:p>
            <a:fld id="{5FD38984-20D9-456C-9D17-F02DDB8520F6}" type="datetimeFigureOut">
              <a:rPr lang="en-US" smtClean="0"/>
              <a:t>10/25/25</a:t>
            </a:fld>
            <a:endParaRPr lang="en-US"/>
          </a:p>
        </p:txBody>
      </p:sp>
      <p:sp>
        <p:nvSpPr>
          <p:cNvPr id="6" name="Footer Placeholder 5">
            <a:extLst>
              <a:ext uri="{FF2B5EF4-FFF2-40B4-BE49-F238E27FC236}">
                <a16:creationId xmlns:a16="http://schemas.microsoft.com/office/drawing/2014/main" id="{0144535E-936F-4C58-895B-91DAE87C2E7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CF31032-13AA-43CB-AC91-9738691DF1FD}"/>
              </a:ext>
            </a:extLst>
          </p:cNvPr>
          <p:cNvSpPr>
            <a:spLocks noGrp="1"/>
          </p:cNvSpPr>
          <p:nvPr>
            <p:ph type="sldNum" sz="quarter" idx="12"/>
          </p:nvPr>
        </p:nvSpPr>
        <p:spPr/>
        <p:txBody>
          <a:bodyPr/>
          <a:lstStyle/>
          <a:p>
            <a:fld id="{D10ECE4A-8FC0-4A49-A782-2886EC3654BE}" type="slidenum">
              <a:rPr lang="en-US" smtClean="0"/>
              <a:t>‹#›</a:t>
            </a:fld>
            <a:endParaRPr lang="en-US"/>
          </a:p>
        </p:txBody>
      </p:sp>
    </p:spTree>
    <p:extLst>
      <p:ext uri="{BB962C8B-B14F-4D97-AF65-F5344CB8AC3E}">
        <p14:creationId xmlns:p14="http://schemas.microsoft.com/office/powerpoint/2010/main" val="4627451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BC57F01-E6E9-47A9-BB0D-A03DF9ABF07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D974C755-5E90-4C1E-ABDD-2A3468645BD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81BE3F8-C55A-4352-B225-4250A5E18EA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D38984-20D9-456C-9D17-F02DDB8520F6}" type="datetimeFigureOut">
              <a:rPr lang="en-US" smtClean="0"/>
              <a:t>10/25/25</a:t>
            </a:fld>
            <a:endParaRPr lang="en-US"/>
          </a:p>
        </p:txBody>
      </p:sp>
      <p:sp>
        <p:nvSpPr>
          <p:cNvPr id="5" name="Footer Placeholder 4">
            <a:extLst>
              <a:ext uri="{FF2B5EF4-FFF2-40B4-BE49-F238E27FC236}">
                <a16:creationId xmlns:a16="http://schemas.microsoft.com/office/drawing/2014/main" id="{87EA7615-DD68-4A97-B1B6-FEBACE51410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95C3745-2A9B-486B-8F8E-761F1264D6C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10ECE4A-8FC0-4A49-A782-2886EC3654BE}" type="slidenum">
              <a:rPr lang="en-US" smtClean="0"/>
              <a:t>‹#›</a:t>
            </a:fld>
            <a:endParaRPr lang="en-US"/>
          </a:p>
        </p:txBody>
      </p:sp>
    </p:spTree>
    <p:extLst>
      <p:ext uri="{BB962C8B-B14F-4D97-AF65-F5344CB8AC3E}">
        <p14:creationId xmlns:p14="http://schemas.microsoft.com/office/powerpoint/2010/main" val="1308830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image" Target="../media/image6.jpeg"/></Relationships>
</file>

<file path=ppt/slides/_rels/slide11.xml.rels><?xml version="1.0" encoding="UTF-8" standalone="yes"?>
<Relationships xmlns="http://schemas.openxmlformats.org/package/2006/relationships"><Relationship Id="rId3" Type="http://schemas.openxmlformats.org/officeDocument/2006/relationships/hyperlink" Target="https://www.youtube.com/watch?v=iSDkvvY3SHc&amp;t=5s"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www.youtube.com/watch?v=iSDkvvY3SHc&amp;t=369s"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009E4D-6762-40D7-95E0-C5A52B7C7D7E}"/>
              </a:ext>
            </a:extLst>
          </p:cNvPr>
          <p:cNvSpPr>
            <a:spLocks noGrp="1"/>
          </p:cNvSpPr>
          <p:nvPr>
            <p:ph type="ctrTitle"/>
          </p:nvPr>
        </p:nvSpPr>
        <p:spPr>
          <a:xfrm>
            <a:off x="860612" y="1097914"/>
            <a:ext cx="10470776" cy="2387600"/>
          </a:xfrm>
        </p:spPr>
        <p:txBody>
          <a:bodyPr>
            <a:normAutofit/>
          </a:bodyPr>
          <a:lstStyle/>
          <a:p>
            <a:r>
              <a:rPr lang="en-US" dirty="0"/>
              <a:t>Abscess I&amp;D</a:t>
            </a:r>
          </a:p>
        </p:txBody>
      </p:sp>
      <p:pic>
        <p:nvPicPr>
          <p:cNvPr id="3" name="Picture 2">
            <a:extLst>
              <a:ext uri="{FF2B5EF4-FFF2-40B4-BE49-F238E27FC236}">
                <a16:creationId xmlns:a16="http://schemas.microsoft.com/office/drawing/2014/main" id="{99A1096F-FDC0-C2B3-FB82-ACC28AEE72B3}"/>
              </a:ext>
            </a:extLst>
          </p:cNvPr>
          <p:cNvPicPr>
            <a:picLocks noChangeAspect="1"/>
          </p:cNvPicPr>
          <p:nvPr/>
        </p:nvPicPr>
        <p:blipFill>
          <a:blip r:embed="rId3"/>
          <a:stretch>
            <a:fillRect/>
          </a:stretch>
        </p:blipFill>
        <p:spPr>
          <a:xfrm>
            <a:off x="10542398" y="6212829"/>
            <a:ext cx="1422400" cy="482600"/>
          </a:xfrm>
          <a:prstGeom prst="rect">
            <a:avLst/>
          </a:prstGeom>
        </p:spPr>
      </p:pic>
    </p:spTree>
    <p:extLst>
      <p:ext uri="{BB962C8B-B14F-4D97-AF65-F5344CB8AC3E}">
        <p14:creationId xmlns:p14="http://schemas.microsoft.com/office/powerpoint/2010/main" val="387859576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4103" name="Rectangle 4102">
            <a:extLst>
              <a:ext uri="{FF2B5EF4-FFF2-40B4-BE49-F238E27FC236}">
                <a16:creationId xmlns:a16="http://schemas.microsoft.com/office/drawing/2014/main" id="{325166D1-1B21-4128-AC42-61745528E4D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tx1"/>
          </a:solidFill>
          <a:ln w="12700" cap="flat" cmpd="sng" algn="ctr">
            <a:noFill/>
            <a:prstDash val="solid"/>
            <a:miter lim="800000"/>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4105" name="Group 4104">
            <a:extLst>
              <a:ext uri="{FF2B5EF4-FFF2-40B4-BE49-F238E27FC236}">
                <a16:creationId xmlns:a16="http://schemas.microsoft.com/office/drawing/2014/main" id="{E6517BAC-C80F-4065-90D8-703493E0B353}"/>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5395368" y="0"/>
            <a:ext cx="874718" cy="6857455"/>
            <a:chOff x="5395368" y="0"/>
            <a:chExt cx="874718" cy="6857455"/>
          </a:xfrm>
        </p:grpSpPr>
        <p:sp>
          <p:nvSpPr>
            <p:cNvPr id="4106" name="Freeform: Shape 4105">
              <a:extLst>
                <a:ext uri="{FF2B5EF4-FFF2-40B4-BE49-F238E27FC236}">
                  <a16:creationId xmlns:a16="http://schemas.microsoft.com/office/drawing/2014/main" id="{984DCDA5-A261-4103-B44C-068DCEA03397}"/>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2404000" y="2991370"/>
              <a:ext cx="6857455" cy="874716"/>
            </a:xfrm>
            <a:custGeom>
              <a:avLst/>
              <a:gdLst>
                <a:gd name="connsiteX0" fmla="*/ 6857455 w 6857455"/>
                <a:gd name="connsiteY0" fmla="*/ 804643 h 874716"/>
                <a:gd name="connsiteX1" fmla="*/ 6857455 w 6857455"/>
                <a:gd name="connsiteY1" fmla="*/ 562246 h 874716"/>
                <a:gd name="connsiteX2" fmla="*/ 6829178 w 6857455"/>
                <a:gd name="connsiteY2" fmla="*/ 551284 h 874716"/>
                <a:gd name="connsiteX3" fmla="*/ 6766024 w 6857455"/>
                <a:gd name="connsiteY3" fmla="*/ 500372 h 874716"/>
                <a:gd name="connsiteX4" fmla="*/ 6734971 w 6857455"/>
                <a:gd name="connsiteY4" fmla="*/ 500944 h 874716"/>
                <a:gd name="connsiteX5" fmla="*/ 6683915 w 6857455"/>
                <a:gd name="connsiteY5" fmla="*/ 507040 h 874716"/>
                <a:gd name="connsiteX6" fmla="*/ 6628860 w 6857455"/>
                <a:gd name="connsiteY6" fmla="*/ 495418 h 874716"/>
                <a:gd name="connsiteX7" fmla="*/ 6588662 w 6857455"/>
                <a:gd name="connsiteY7" fmla="*/ 487227 h 874716"/>
                <a:gd name="connsiteX8" fmla="*/ 6476074 w 6857455"/>
                <a:gd name="connsiteY8" fmla="*/ 511230 h 874716"/>
                <a:gd name="connsiteX9" fmla="*/ 6382345 w 6857455"/>
                <a:gd name="connsiteY9" fmla="*/ 534853 h 874716"/>
                <a:gd name="connsiteX10" fmla="*/ 6369391 w 6857455"/>
                <a:gd name="connsiteY10" fmla="*/ 531615 h 874716"/>
                <a:gd name="connsiteX11" fmla="*/ 6244799 w 6857455"/>
                <a:gd name="connsiteY11" fmla="*/ 512182 h 874716"/>
                <a:gd name="connsiteX12" fmla="*/ 6190315 w 6857455"/>
                <a:gd name="connsiteY12" fmla="*/ 485703 h 874716"/>
                <a:gd name="connsiteX13" fmla="*/ 6115446 w 6857455"/>
                <a:gd name="connsiteY13" fmla="*/ 462270 h 874716"/>
                <a:gd name="connsiteX14" fmla="*/ 6032194 w 6857455"/>
                <a:gd name="connsiteY14" fmla="*/ 434266 h 874716"/>
                <a:gd name="connsiteX15" fmla="*/ 5971042 w 6857455"/>
                <a:gd name="connsiteY15" fmla="*/ 420738 h 874716"/>
                <a:gd name="connsiteX16" fmla="*/ 5880933 w 6857455"/>
                <a:gd name="connsiteY16" fmla="*/ 430646 h 874716"/>
                <a:gd name="connsiteX17" fmla="*/ 5862452 w 6857455"/>
                <a:gd name="connsiteY17" fmla="*/ 438648 h 874716"/>
                <a:gd name="connsiteX18" fmla="*/ 5685283 w 6857455"/>
                <a:gd name="connsiteY18" fmla="*/ 498658 h 874716"/>
                <a:gd name="connsiteX19" fmla="*/ 5567169 w 6857455"/>
                <a:gd name="connsiteY19" fmla="*/ 499420 h 874716"/>
                <a:gd name="connsiteX20" fmla="*/ 5527923 w 6857455"/>
                <a:gd name="connsiteY20" fmla="*/ 490466 h 874716"/>
                <a:gd name="connsiteX21" fmla="*/ 5456292 w 6857455"/>
                <a:gd name="connsiteY21" fmla="*/ 450650 h 874716"/>
                <a:gd name="connsiteX22" fmla="*/ 5424670 w 6857455"/>
                <a:gd name="connsiteY22" fmla="*/ 444934 h 874716"/>
                <a:gd name="connsiteX23" fmla="*/ 5368662 w 6857455"/>
                <a:gd name="connsiteY23" fmla="*/ 441124 h 874716"/>
                <a:gd name="connsiteX24" fmla="*/ 5247118 w 6857455"/>
                <a:gd name="connsiteY24" fmla="*/ 444934 h 874716"/>
                <a:gd name="connsiteX25" fmla="*/ 5088617 w 6857455"/>
                <a:gd name="connsiteY25" fmla="*/ 428742 h 874716"/>
                <a:gd name="connsiteX26" fmla="*/ 5025750 w 6857455"/>
                <a:gd name="connsiteY26" fmla="*/ 433694 h 874716"/>
                <a:gd name="connsiteX27" fmla="*/ 4957930 w 6857455"/>
                <a:gd name="connsiteY27" fmla="*/ 442268 h 874716"/>
                <a:gd name="connsiteX28" fmla="*/ 4938116 w 6857455"/>
                <a:gd name="connsiteY28" fmla="*/ 441886 h 874716"/>
                <a:gd name="connsiteX29" fmla="*/ 4833910 w 6857455"/>
                <a:gd name="connsiteY29" fmla="*/ 421693 h 874716"/>
                <a:gd name="connsiteX30" fmla="*/ 4810095 w 6857455"/>
                <a:gd name="connsiteY30" fmla="*/ 408167 h 874716"/>
                <a:gd name="connsiteX31" fmla="*/ 4747991 w 6857455"/>
                <a:gd name="connsiteY31" fmla="*/ 413691 h 874716"/>
                <a:gd name="connsiteX32" fmla="*/ 4692745 w 6857455"/>
                <a:gd name="connsiteY32" fmla="*/ 435790 h 874716"/>
                <a:gd name="connsiteX33" fmla="*/ 4375933 w 6857455"/>
                <a:gd name="connsiteY33" fmla="*/ 483417 h 874716"/>
                <a:gd name="connsiteX34" fmla="*/ 4185426 w 6857455"/>
                <a:gd name="connsiteY34" fmla="*/ 484179 h 874716"/>
                <a:gd name="connsiteX35" fmla="*/ 4052072 w 6857455"/>
                <a:gd name="connsiteY35" fmla="*/ 505134 h 874716"/>
                <a:gd name="connsiteX36" fmla="*/ 4029973 w 6857455"/>
                <a:gd name="connsiteY36" fmla="*/ 527233 h 874716"/>
                <a:gd name="connsiteX37" fmla="*/ 3948626 w 6857455"/>
                <a:gd name="connsiteY37" fmla="*/ 550666 h 874716"/>
                <a:gd name="connsiteX38" fmla="*/ 3871280 w 6857455"/>
                <a:gd name="connsiteY38" fmla="*/ 502275 h 874716"/>
                <a:gd name="connsiteX39" fmla="*/ 3774312 w 6857455"/>
                <a:gd name="connsiteY39" fmla="*/ 429122 h 874716"/>
                <a:gd name="connsiteX40" fmla="*/ 3721543 w 6857455"/>
                <a:gd name="connsiteY40" fmla="*/ 428552 h 874716"/>
                <a:gd name="connsiteX41" fmla="*/ 3612763 w 6857455"/>
                <a:gd name="connsiteY41" fmla="*/ 414263 h 874716"/>
                <a:gd name="connsiteX42" fmla="*/ 3537323 w 6857455"/>
                <a:gd name="connsiteY42" fmla="*/ 389878 h 874716"/>
                <a:gd name="connsiteX43" fmla="*/ 3431593 w 6857455"/>
                <a:gd name="connsiteY43" fmla="*/ 360921 h 874716"/>
                <a:gd name="connsiteX44" fmla="*/ 3392158 w 6857455"/>
                <a:gd name="connsiteY44" fmla="*/ 345681 h 874716"/>
                <a:gd name="connsiteX45" fmla="*/ 3297856 w 6857455"/>
                <a:gd name="connsiteY45" fmla="*/ 323010 h 874716"/>
                <a:gd name="connsiteX46" fmla="*/ 3219748 w 6857455"/>
                <a:gd name="connsiteY46" fmla="*/ 308151 h 874716"/>
                <a:gd name="connsiteX47" fmla="*/ 3156692 w 6857455"/>
                <a:gd name="connsiteY47" fmla="*/ 261668 h 874716"/>
                <a:gd name="connsiteX48" fmla="*/ 3136497 w 6857455"/>
                <a:gd name="connsiteY48" fmla="*/ 237663 h 874716"/>
                <a:gd name="connsiteX49" fmla="*/ 3119733 w 6857455"/>
                <a:gd name="connsiteY49" fmla="*/ 222233 h 874716"/>
                <a:gd name="connsiteX50" fmla="*/ 3045436 w 6857455"/>
                <a:gd name="connsiteY50" fmla="*/ 131742 h 874716"/>
                <a:gd name="connsiteX51" fmla="*/ 3037054 w 6857455"/>
                <a:gd name="connsiteY51" fmla="*/ 124121 h 874716"/>
                <a:gd name="connsiteX52" fmla="*/ 2936466 w 6857455"/>
                <a:gd name="connsiteY52" fmla="*/ 82400 h 874716"/>
                <a:gd name="connsiteX53" fmla="*/ 2901031 w 6857455"/>
                <a:gd name="connsiteY53" fmla="*/ 59731 h 874716"/>
                <a:gd name="connsiteX54" fmla="*/ 2828259 w 6857455"/>
                <a:gd name="connsiteY54" fmla="*/ 3149 h 874716"/>
                <a:gd name="connsiteX55" fmla="*/ 2799492 w 6857455"/>
                <a:gd name="connsiteY55" fmla="*/ 1245 h 874716"/>
                <a:gd name="connsiteX56" fmla="*/ 2693570 w 6857455"/>
                <a:gd name="connsiteY56" fmla="*/ 35154 h 874716"/>
                <a:gd name="connsiteX57" fmla="*/ 2639847 w 6857455"/>
                <a:gd name="connsiteY57" fmla="*/ 73448 h 874716"/>
                <a:gd name="connsiteX58" fmla="*/ 2621178 w 6857455"/>
                <a:gd name="connsiteY58" fmla="*/ 88688 h 874716"/>
                <a:gd name="connsiteX59" fmla="*/ 2489348 w 6857455"/>
                <a:gd name="connsiteY59" fmla="*/ 72304 h 874716"/>
                <a:gd name="connsiteX60" fmla="*/ 2452580 w 6857455"/>
                <a:gd name="connsiteY60" fmla="*/ 68683 h 874716"/>
                <a:gd name="connsiteX61" fmla="*/ 2326464 w 6857455"/>
                <a:gd name="connsiteY61" fmla="*/ 50395 h 874716"/>
                <a:gd name="connsiteX62" fmla="*/ 2300365 w 6857455"/>
                <a:gd name="connsiteY62" fmla="*/ 54777 h 874716"/>
                <a:gd name="connsiteX63" fmla="*/ 2130434 w 6857455"/>
                <a:gd name="connsiteY63" fmla="*/ 58397 h 874716"/>
                <a:gd name="connsiteX64" fmla="*/ 2118621 w 6857455"/>
                <a:gd name="connsiteY64" fmla="*/ 47919 h 874716"/>
                <a:gd name="connsiteX65" fmla="*/ 2057659 w 6857455"/>
                <a:gd name="connsiteY65" fmla="*/ 16866 h 874716"/>
                <a:gd name="connsiteX66" fmla="*/ 1976314 w 6857455"/>
                <a:gd name="connsiteY66" fmla="*/ 8865 h 874716"/>
                <a:gd name="connsiteX67" fmla="*/ 1961454 w 6857455"/>
                <a:gd name="connsiteY67" fmla="*/ 11724 h 874716"/>
                <a:gd name="connsiteX68" fmla="*/ 1906588 w 6857455"/>
                <a:gd name="connsiteY68" fmla="*/ 30964 h 874716"/>
                <a:gd name="connsiteX69" fmla="*/ 1783330 w 6857455"/>
                <a:gd name="connsiteY69" fmla="*/ 48871 h 874716"/>
                <a:gd name="connsiteX70" fmla="*/ 1759327 w 6857455"/>
                <a:gd name="connsiteY70" fmla="*/ 55349 h 874716"/>
                <a:gd name="connsiteX71" fmla="*/ 1716082 w 6857455"/>
                <a:gd name="connsiteY71" fmla="*/ 65445 h 874716"/>
                <a:gd name="connsiteX72" fmla="*/ 1598920 w 6857455"/>
                <a:gd name="connsiteY72" fmla="*/ 72114 h 874716"/>
                <a:gd name="connsiteX73" fmla="*/ 1542150 w 6857455"/>
                <a:gd name="connsiteY73" fmla="*/ 62207 h 874716"/>
                <a:gd name="connsiteX74" fmla="*/ 1516813 w 6857455"/>
                <a:gd name="connsiteY74" fmla="*/ 62779 h 874716"/>
                <a:gd name="connsiteX75" fmla="*/ 1432228 w 6857455"/>
                <a:gd name="connsiteY75" fmla="*/ 88116 h 874716"/>
                <a:gd name="connsiteX76" fmla="*/ 1224765 w 6857455"/>
                <a:gd name="connsiteY76" fmla="*/ 71924 h 874716"/>
                <a:gd name="connsiteX77" fmla="*/ 1159231 w 6857455"/>
                <a:gd name="connsiteY77" fmla="*/ 58207 h 874716"/>
                <a:gd name="connsiteX78" fmla="*/ 1124370 w 6857455"/>
                <a:gd name="connsiteY78" fmla="*/ 56301 h 874716"/>
                <a:gd name="connsiteX79" fmla="*/ 1075600 w 6857455"/>
                <a:gd name="connsiteY79" fmla="*/ 75542 h 874716"/>
                <a:gd name="connsiteX80" fmla="*/ 986633 w 6857455"/>
                <a:gd name="connsiteY80" fmla="*/ 79162 h 874716"/>
                <a:gd name="connsiteX81" fmla="*/ 861089 w 6857455"/>
                <a:gd name="connsiteY81" fmla="*/ 76304 h 874716"/>
                <a:gd name="connsiteX82" fmla="*/ 759168 w 6857455"/>
                <a:gd name="connsiteY82" fmla="*/ 104689 h 874716"/>
                <a:gd name="connsiteX83" fmla="*/ 723735 w 6857455"/>
                <a:gd name="connsiteY83" fmla="*/ 140696 h 874716"/>
                <a:gd name="connsiteX84" fmla="*/ 647532 w 6857455"/>
                <a:gd name="connsiteY84" fmla="*/ 147934 h 874716"/>
                <a:gd name="connsiteX85" fmla="*/ 552659 w 6857455"/>
                <a:gd name="connsiteY85" fmla="*/ 95926 h 874716"/>
                <a:gd name="connsiteX86" fmla="*/ 541800 w 6857455"/>
                <a:gd name="connsiteY86" fmla="*/ 97640 h 874716"/>
                <a:gd name="connsiteX87" fmla="*/ 375107 w 6857455"/>
                <a:gd name="connsiteY87" fmla="*/ 123169 h 874716"/>
                <a:gd name="connsiteX88" fmla="*/ 273567 w 6857455"/>
                <a:gd name="connsiteY88" fmla="*/ 145458 h 874716"/>
                <a:gd name="connsiteX89" fmla="*/ 264043 w 6857455"/>
                <a:gd name="connsiteY89" fmla="*/ 154792 h 874716"/>
                <a:gd name="connsiteX90" fmla="*/ 169360 w 6857455"/>
                <a:gd name="connsiteY90" fmla="*/ 177273 h 874716"/>
                <a:gd name="connsiteX91" fmla="*/ 89347 w 6857455"/>
                <a:gd name="connsiteY91" fmla="*/ 157460 h 874716"/>
                <a:gd name="connsiteX92" fmla="*/ 34291 w 6857455"/>
                <a:gd name="connsiteY92" fmla="*/ 145268 h 874716"/>
                <a:gd name="connsiteX93" fmla="*/ 0 w 6857455"/>
                <a:gd name="connsiteY93" fmla="*/ 142056 h 874716"/>
                <a:gd name="connsiteX94" fmla="*/ 0 w 6857455"/>
                <a:gd name="connsiteY94" fmla="*/ 849556 h 874716"/>
                <a:gd name="connsiteX95" fmla="*/ 60652 w 6857455"/>
                <a:gd name="connsiteY95" fmla="*/ 844783 h 874716"/>
                <a:gd name="connsiteX96" fmla="*/ 119068 w 6857455"/>
                <a:gd name="connsiteY96" fmla="*/ 827281 h 874716"/>
                <a:gd name="connsiteX97" fmla="*/ 171840 w 6857455"/>
                <a:gd name="connsiteY97" fmla="*/ 804420 h 874716"/>
                <a:gd name="connsiteX98" fmla="*/ 274329 w 6857455"/>
                <a:gd name="connsiteY98" fmla="*/ 794324 h 874716"/>
                <a:gd name="connsiteX99" fmla="*/ 306715 w 6857455"/>
                <a:gd name="connsiteY99" fmla="*/ 788798 h 874716"/>
                <a:gd name="connsiteX100" fmla="*/ 393967 w 6857455"/>
                <a:gd name="connsiteY100" fmla="*/ 765937 h 874716"/>
                <a:gd name="connsiteX101" fmla="*/ 493793 w 6857455"/>
                <a:gd name="connsiteY101" fmla="*/ 725549 h 874716"/>
                <a:gd name="connsiteX102" fmla="*/ 546373 w 6857455"/>
                <a:gd name="connsiteY102" fmla="*/ 740600 h 874716"/>
                <a:gd name="connsiteX103" fmla="*/ 730211 w 6857455"/>
                <a:gd name="connsiteY103" fmla="*/ 698116 h 874716"/>
                <a:gd name="connsiteX104" fmla="*/ 784889 w 6857455"/>
                <a:gd name="connsiteY104" fmla="*/ 676018 h 874716"/>
                <a:gd name="connsiteX105" fmla="*/ 800509 w 6857455"/>
                <a:gd name="connsiteY105" fmla="*/ 661349 h 874716"/>
                <a:gd name="connsiteX106" fmla="*/ 857661 w 6857455"/>
                <a:gd name="connsiteY106" fmla="*/ 626868 h 874716"/>
                <a:gd name="connsiteX107" fmla="*/ 949102 w 6857455"/>
                <a:gd name="connsiteY107" fmla="*/ 614676 h 874716"/>
                <a:gd name="connsiteX108" fmla="*/ 960342 w 6857455"/>
                <a:gd name="connsiteY108" fmla="*/ 607435 h 874716"/>
                <a:gd name="connsiteX109" fmla="*/ 977109 w 6857455"/>
                <a:gd name="connsiteY109" fmla="*/ 595815 h 874716"/>
                <a:gd name="connsiteX110" fmla="*/ 1071218 w 6857455"/>
                <a:gd name="connsiteY110" fmla="*/ 575240 h 874716"/>
                <a:gd name="connsiteX111" fmla="*/ 1091983 w 6857455"/>
                <a:gd name="connsiteY111" fmla="*/ 568764 h 874716"/>
                <a:gd name="connsiteX112" fmla="*/ 1109321 w 6857455"/>
                <a:gd name="connsiteY112" fmla="*/ 557904 h 874716"/>
                <a:gd name="connsiteX113" fmla="*/ 1162279 w 6857455"/>
                <a:gd name="connsiteY113" fmla="*/ 532949 h 874716"/>
                <a:gd name="connsiteX114" fmla="*/ 1206097 w 6857455"/>
                <a:gd name="connsiteY114" fmla="*/ 532187 h 874716"/>
                <a:gd name="connsiteX115" fmla="*/ 1266867 w 6857455"/>
                <a:gd name="connsiteY115" fmla="*/ 518088 h 874716"/>
                <a:gd name="connsiteX116" fmla="*/ 1380219 w 6857455"/>
                <a:gd name="connsiteY116" fmla="*/ 504182 h 874716"/>
                <a:gd name="connsiteX117" fmla="*/ 1403461 w 6857455"/>
                <a:gd name="connsiteY117" fmla="*/ 496180 h 874716"/>
                <a:gd name="connsiteX118" fmla="*/ 1544054 w 6857455"/>
                <a:gd name="connsiteY118" fmla="*/ 458268 h 874716"/>
                <a:gd name="connsiteX119" fmla="*/ 1656644 w 6857455"/>
                <a:gd name="connsiteY119" fmla="*/ 459032 h 874716"/>
                <a:gd name="connsiteX120" fmla="*/ 1665406 w 6857455"/>
                <a:gd name="connsiteY120" fmla="*/ 460747 h 874716"/>
                <a:gd name="connsiteX121" fmla="*/ 1708461 w 6857455"/>
                <a:gd name="connsiteY121" fmla="*/ 473318 h 874716"/>
                <a:gd name="connsiteX122" fmla="*/ 1775140 w 6857455"/>
                <a:gd name="connsiteY122" fmla="*/ 469891 h 874716"/>
                <a:gd name="connsiteX123" fmla="*/ 1821051 w 6857455"/>
                <a:gd name="connsiteY123" fmla="*/ 452554 h 874716"/>
                <a:gd name="connsiteX124" fmla="*/ 1878203 w 6857455"/>
                <a:gd name="connsiteY124" fmla="*/ 451792 h 874716"/>
                <a:gd name="connsiteX125" fmla="*/ 1943547 w 6857455"/>
                <a:gd name="connsiteY125" fmla="*/ 462651 h 874716"/>
                <a:gd name="connsiteX126" fmla="*/ 1972884 w 6857455"/>
                <a:gd name="connsiteY126" fmla="*/ 464937 h 874716"/>
                <a:gd name="connsiteX127" fmla="*/ 2053469 w 6857455"/>
                <a:gd name="connsiteY127" fmla="*/ 487417 h 874716"/>
                <a:gd name="connsiteX128" fmla="*/ 2101477 w 6857455"/>
                <a:gd name="connsiteY128" fmla="*/ 481893 h 874716"/>
                <a:gd name="connsiteX129" fmla="*/ 2148722 w 6857455"/>
                <a:gd name="connsiteY129" fmla="*/ 467033 h 874716"/>
                <a:gd name="connsiteX130" fmla="*/ 2179011 w 6857455"/>
                <a:gd name="connsiteY130" fmla="*/ 452744 h 874716"/>
                <a:gd name="connsiteX131" fmla="*/ 2240165 w 6857455"/>
                <a:gd name="connsiteY131" fmla="*/ 442648 h 874716"/>
                <a:gd name="connsiteX132" fmla="*/ 2251404 w 6857455"/>
                <a:gd name="connsiteY132" fmla="*/ 444172 h 874716"/>
                <a:gd name="connsiteX133" fmla="*/ 2433912 w 6857455"/>
                <a:gd name="connsiteY133" fmla="*/ 456746 h 874716"/>
                <a:gd name="connsiteX134" fmla="*/ 2506302 w 6857455"/>
                <a:gd name="connsiteY134" fmla="*/ 476939 h 874716"/>
                <a:gd name="connsiteX135" fmla="*/ 2521735 w 6857455"/>
                <a:gd name="connsiteY135" fmla="*/ 479415 h 874716"/>
                <a:gd name="connsiteX136" fmla="*/ 2675854 w 6857455"/>
                <a:gd name="connsiteY136" fmla="*/ 502086 h 874716"/>
                <a:gd name="connsiteX137" fmla="*/ 2692998 w 6857455"/>
                <a:gd name="connsiteY137" fmla="*/ 503038 h 874716"/>
                <a:gd name="connsiteX138" fmla="*/ 2740816 w 6857455"/>
                <a:gd name="connsiteY138" fmla="*/ 499037 h 874716"/>
                <a:gd name="connsiteX139" fmla="*/ 2853596 w 6857455"/>
                <a:gd name="connsiteY139" fmla="*/ 540187 h 874716"/>
                <a:gd name="connsiteX140" fmla="*/ 2966565 w 6857455"/>
                <a:gd name="connsiteY140" fmla="*/ 554286 h 874716"/>
                <a:gd name="connsiteX141" fmla="*/ 3028671 w 6857455"/>
                <a:gd name="connsiteY141" fmla="*/ 554094 h 874716"/>
                <a:gd name="connsiteX142" fmla="*/ 3073059 w 6857455"/>
                <a:gd name="connsiteY142" fmla="*/ 564192 h 874716"/>
                <a:gd name="connsiteX143" fmla="*/ 3182219 w 6857455"/>
                <a:gd name="connsiteY143" fmla="*/ 594862 h 874716"/>
                <a:gd name="connsiteX144" fmla="*/ 3233656 w 6857455"/>
                <a:gd name="connsiteY144" fmla="*/ 599625 h 874716"/>
                <a:gd name="connsiteX145" fmla="*/ 3288332 w 6857455"/>
                <a:gd name="connsiteY145" fmla="*/ 609914 h 874716"/>
                <a:gd name="connsiteX146" fmla="*/ 3423591 w 6857455"/>
                <a:gd name="connsiteY146" fmla="*/ 656015 h 874716"/>
                <a:gd name="connsiteX147" fmla="*/ 3534084 w 6857455"/>
                <a:gd name="connsiteY147" fmla="*/ 653349 h 874716"/>
                <a:gd name="connsiteX148" fmla="*/ 3604571 w 6857455"/>
                <a:gd name="connsiteY148" fmla="*/ 653918 h 874716"/>
                <a:gd name="connsiteX149" fmla="*/ 3688586 w 6857455"/>
                <a:gd name="connsiteY149" fmla="*/ 669160 h 874716"/>
                <a:gd name="connsiteX150" fmla="*/ 3757358 w 6857455"/>
                <a:gd name="connsiteY150" fmla="*/ 691450 h 874716"/>
                <a:gd name="connsiteX151" fmla="*/ 3852421 w 6857455"/>
                <a:gd name="connsiteY151" fmla="*/ 709167 h 874716"/>
                <a:gd name="connsiteX152" fmla="*/ 3947104 w 6857455"/>
                <a:gd name="connsiteY152" fmla="*/ 743267 h 874716"/>
                <a:gd name="connsiteX153" fmla="*/ 4013208 w 6857455"/>
                <a:gd name="connsiteY153" fmla="*/ 769367 h 874716"/>
                <a:gd name="connsiteX154" fmla="*/ 4105222 w 6857455"/>
                <a:gd name="connsiteY154" fmla="*/ 792418 h 874716"/>
                <a:gd name="connsiteX155" fmla="*/ 4246006 w 6857455"/>
                <a:gd name="connsiteY155" fmla="*/ 808610 h 874716"/>
                <a:gd name="connsiteX156" fmla="*/ 4310779 w 6857455"/>
                <a:gd name="connsiteY156" fmla="*/ 810326 h 874716"/>
                <a:gd name="connsiteX157" fmla="*/ 4413272 w 6857455"/>
                <a:gd name="connsiteY157" fmla="*/ 848235 h 874716"/>
                <a:gd name="connsiteX158" fmla="*/ 4457087 w 6857455"/>
                <a:gd name="connsiteY158" fmla="*/ 866524 h 874716"/>
                <a:gd name="connsiteX159" fmla="*/ 4496523 w 6857455"/>
                <a:gd name="connsiteY159" fmla="*/ 851284 h 874716"/>
                <a:gd name="connsiteX160" fmla="*/ 4522050 w 6857455"/>
                <a:gd name="connsiteY160" fmla="*/ 833757 h 874716"/>
                <a:gd name="connsiteX161" fmla="*/ 4602824 w 6857455"/>
                <a:gd name="connsiteY161" fmla="*/ 848618 h 874716"/>
                <a:gd name="connsiteX162" fmla="*/ 4688553 w 6857455"/>
                <a:gd name="connsiteY162" fmla="*/ 864238 h 874716"/>
                <a:gd name="connsiteX163" fmla="*/ 4749895 w 6857455"/>
                <a:gd name="connsiteY163" fmla="*/ 874716 h 874716"/>
                <a:gd name="connsiteX164" fmla="*/ 4826480 w 6857455"/>
                <a:gd name="connsiteY164" fmla="*/ 866334 h 874716"/>
                <a:gd name="connsiteX165" fmla="*/ 4886870 w 6857455"/>
                <a:gd name="connsiteY165" fmla="*/ 862906 h 874716"/>
                <a:gd name="connsiteX166" fmla="*/ 4935639 w 6857455"/>
                <a:gd name="connsiteY166" fmla="*/ 853190 h 874716"/>
                <a:gd name="connsiteX167" fmla="*/ 4952784 w 6857455"/>
                <a:gd name="connsiteY167" fmla="*/ 847473 h 874716"/>
                <a:gd name="connsiteX168" fmla="*/ 5088617 w 6857455"/>
                <a:gd name="connsiteY168" fmla="*/ 802896 h 874716"/>
                <a:gd name="connsiteX169" fmla="*/ 5233781 w 6857455"/>
                <a:gd name="connsiteY169" fmla="*/ 767271 h 874716"/>
                <a:gd name="connsiteX170" fmla="*/ 5327893 w 6857455"/>
                <a:gd name="connsiteY170" fmla="*/ 789752 h 874716"/>
                <a:gd name="connsiteX171" fmla="*/ 5362946 w 6857455"/>
                <a:gd name="connsiteY171" fmla="*/ 789370 h 874716"/>
                <a:gd name="connsiteX172" fmla="*/ 5524115 w 6857455"/>
                <a:gd name="connsiteY172" fmla="*/ 794514 h 874716"/>
                <a:gd name="connsiteX173" fmla="*/ 5552500 w 6857455"/>
                <a:gd name="connsiteY173" fmla="*/ 800038 h 874716"/>
                <a:gd name="connsiteX174" fmla="*/ 5705857 w 6857455"/>
                <a:gd name="connsiteY174" fmla="*/ 777367 h 874716"/>
                <a:gd name="connsiteX175" fmla="*/ 5761485 w 6857455"/>
                <a:gd name="connsiteY175" fmla="*/ 773557 h 874716"/>
                <a:gd name="connsiteX176" fmla="*/ 5812731 w 6857455"/>
                <a:gd name="connsiteY176" fmla="*/ 767271 h 874716"/>
                <a:gd name="connsiteX177" fmla="*/ 5884361 w 6857455"/>
                <a:gd name="connsiteY177" fmla="*/ 765747 h 874716"/>
                <a:gd name="connsiteX178" fmla="*/ 5958660 w 6857455"/>
                <a:gd name="connsiteY178" fmla="*/ 768605 h 874716"/>
                <a:gd name="connsiteX179" fmla="*/ 6041528 w 6857455"/>
                <a:gd name="connsiteY179" fmla="*/ 768033 h 874716"/>
                <a:gd name="connsiteX180" fmla="*/ 6074297 w 6857455"/>
                <a:gd name="connsiteY180" fmla="*/ 763081 h 874716"/>
                <a:gd name="connsiteX181" fmla="*/ 6162880 w 6857455"/>
                <a:gd name="connsiteY181" fmla="*/ 766509 h 874716"/>
                <a:gd name="connsiteX182" fmla="*/ 6209364 w 6857455"/>
                <a:gd name="connsiteY182" fmla="*/ 760795 h 874716"/>
                <a:gd name="connsiteX183" fmla="*/ 6285948 w 6857455"/>
                <a:gd name="connsiteY183" fmla="*/ 759651 h 874716"/>
                <a:gd name="connsiteX184" fmla="*/ 6310905 w 6857455"/>
                <a:gd name="connsiteY184" fmla="*/ 758316 h 874716"/>
                <a:gd name="connsiteX185" fmla="*/ 6333194 w 6857455"/>
                <a:gd name="connsiteY185" fmla="*/ 757554 h 874716"/>
                <a:gd name="connsiteX186" fmla="*/ 6409586 w 6857455"/>
                <a:gd name="connsiteY186" fmla="*/ 773177 h 874716"/>
                <a:gd name="connsiteX187" fmla="*/ 6477407 w 6857455"/>
                <a:gd name="connsiteY187" fmla="*/ 774129 h 874716"/>
                <a:gd name="connsiteX188" fmla="*/ 6596283 w 6857455"/>
                <a:gd name="connsiteY188" fmla="*/ 786703 h 874716"/>
                <a:gd name="connsiteX189" fmla="*/ 6622573 w 6857455"/>
                <a:gd name="connsiteY189" fmla="*/ 782321 h 874716"/>
                <a:gd name="connsiteX190" fmla="*/ 6704872 w 6857455"/>
                <a:gd name="connsiteY190" fmla="*/ 780607 h 874716"/>
                <a:gd name="connsiteX191" fmla="*/ 6751738 w 6857455"/>
                <a:gd name="connsiteY191" fmla="*/ 779273 h 874716"/>
                <a:gd name="connsiteX192" fmla="*/ 6809650 w 6857455"/>
                <a:gd name="connsiteY192" fmla="*/ 788417 h 874716"/>
                <a:gd name="connsiteX193" fmla="*/ 6832976 w 6857455"/>
                <a:gd name="connsiteY193" fmla="*/ 800428 h 87471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Lst>
              <a:rect l="l" t="t" r="r" b="b"/>
              <a:pathLst>
                <a:path w="6857455" h="874716">
                  <a:moveTo>
                    <a:pt x="6857455" y="804643"/>
                  </a:moveTo>
                  <a:lnTo>
                    <a:pt x="6857455" y="562246"/>
                  </a:lnTo>
                  <a:lnTo>
                    <a:pt x="6829178" y="551284"/>
                  </a:lnTo>
                  <a:cubicBezTo>
                    <a:pt x="6805745" y="539044"/>
                    <a:pt x="6784885" y="521708"/>
                    <a:pt x="6766024" y="500372"/>
                  </a:cubicBezTo>
                  <a:cubicBezTo>
                    <a:pt x="6755166" y="488179"/>
                    <a:pt x="6746784" y="486845"/>
                    <a:pt x="6734971" y="500944"/>
                  </a:cubicBezTo>
                  <a:cubicBezTo>
                    <a:pt x="6721257" y="517326"/>
                    <a:pt x="6701634" y="510850"/>
                    <a:pt x="6683915" y="507040"/>
                  </a:cubicBezTo>
                  <a:cubicBezTo>
                    <a:pt x="6665629" y="503230"/>
                    <a:pt x="6647148" y="499228"/>
                    <a:pt x="6628860" y="495418"/>
                  </a:cubicBezTo>
                  <a:cubicBezTo>
                    <a:pt x="6615335" y="492752"/>
                    <a:pt x="6601999" y="490466"/>
                    <a:pt x="6588662" y="487227"/>
                  </a:cubicBezTo>
                  <a:cubicBezTo>
                    <a:pt x="6547133" y="477129"/>
                    <a:pt x="6509794" y="480177"/>
                    <a:pt x="6476074" y="511230"/>
                  </a:cubicBezTo>
                  <a:cubicBezTo>
                    <a:pt x="6450356" y="535043"/>
                    <a:pt x="6417399" y="542093"/>
                    <a:pt x="6382345" y="534853"/>
                  </a:cubicBezTo>
                  <a:cubicBezTo>
                    <a:pt x="6377963" y="533901"/>
                    <a:pt x="6372439" y="530091"/>
                    <a:pt x="6369391" y="531615"/>
                  </a:cubicBezTo>
                  <a:cubicBezTo>
                    <a:pt x="6323479" y="553904"/>
                    <a:pt x="6287092" y="514658"/>
                    <a:pt x="6244799" y="512182"/>
                  </a:cubicBezTo>
                  <a:cubicBezTo>
                    <a:pt x="6226130" y="511040"/>
                    <a:pt x="6207079" y="496942"/>
                    <a:pt x="6190315" y="485703"/>
                  </a:cubicBezTo>
                  <a:cubicBezTo>
                    <a:pt x="6167262" y="470271"/>
                    <a:pt x="6146687" y="455412"/>
                    <a:pt x="6115446" y="462270"/>
                  </a:cubicBezTo>
                  <a:cubicBezTo>
                    <a:pt x="6084203" y="469319"/>
                    <a:pt x="6055627" y="456364"/>
                    <a:pt x="6032194" y="434266"/>
                  </a:cubicBezTo>
                  <a:cubicBezTo>
                    <a:pt x="6014287" y="417501"/>
                    <a:pt x="5994665" y="415977"/>
                    <a:pt x="5971042" y="420738"/>
                  </a:cubicBezTo>
                  <a:cubicBezTo>
                    <a:pt x="5941513" y="426645"/>
                    <a:pt x="5910842" y="427027"/>
                    <a:pt x="5880933" y="430646"/>
                  </a:cubicBezTo>
                  <a:cubicBezTo>
                    <a:pt x="5874454" y="431408"/>
                    <a:pt x="5866265" y="434076"/>
                    <a:pt x="5862452" y="438648"/>
                  </a:cubicBezTo>
                  <a:cubicBezTo>
                    <a:pt x="5815779" y="495418"/>
                    <a:pt x="5750055" y="495990"/>
                    <a:pt x="5685283" y="498658"/>
                  </a:cubicBezTo>
                  <a:cubicBezTo>
                    <a:pt x="5646039" y="500372"/>
                    <a:pt x="5606604" y="500372"/>
                    <a:pt x="5567169" y="499420"/>
                  </a:cubicBezTo>
                  <a:cubicBezTo>
                    <a:pt x="5553832" y="499228"/>
                    <a:pt x="5539736" y="496180"/>
                    <a:pt x="5527923" y="490466"/>
                  </a:cubicBezTo>
                  <a:cubicBezTo>
                    <a:pt x="5503348" y="478463"/>
                    <a:pt x="5480680" y="462843"/>
                    <a:pt x="5456292" y="450650"/>
                  </a:cubicBezTo>
                  <a:cubicBezTo>
                    <a:pt x="5447151" y="445886"/>
                    <a:pt x="5435338" y="445696"/>
                    <a:pt x="5424670" y="444934"/>
                  </a:cubicBezTo>
                  <a:cubicBezTo>
                    <a:pt x="5405809" y="443410"/>
                    <a:pt x="5384854" y="447982"/>
                    <a:pt x="5368662" y="441124"/>
                  </a:cubicBezTo>
                  <a:cubicBezTo>
                    <a:pt x="5326559" y="423407"/>
                    <a:pt x="5287123" y="427407"/>
                    <a:pt x="5247118" y="444934"/>
                  </a:cubicBezTo>
                  <a:cubicBezTo>
                    <a:pt x="5191108" y="469509"/>
                    <a:pt x="5138148" y="467605"/>
                    <a:pt x="5088617" y="428742"/>
                  </a:cubicBezTo>
                  <a:cubicBezTo>
                    <a:pt x="5066328" y="411215"/>
                    <a:pt x="5044609" y="419596"/>
                    <a:pt x="5025750" y="433694"/>
                  </a:cubicBezTo>
                  <a:cubicBezTo>
                    <a:pt x="5004032" y="450078"/>
                    <a:pt x="4982885" y="454268"/>
                    <a:pt x="4957930" y="442268"/>
                  </a:cubicBezTo>
                  <a:cubicBezTo>
                    <a:pt x="4952404" y="439600"/>
                    <a:pt x="4944594" y="440933"/>
                    <a:pt x="4938116" y="441886"/>
                  </a:cubicBezTo>
                  <a:cubicBezTo>
                    <a:pt x="4901158" y="446648"/>
                    <a:pt x="4864009" y="454650"/>
                    <a:pt x="4833910" y="421693"/>
                  </a:cubicBezTo>
                  <a:cubicBezTo>
                    <a:pt x="4828004" y="415214"/>
                    <a:pt x="4818097" y="412549"/>
                    <a:pt x="4810095" y="408167"/>
                  </a:cubicBezTo>
                  <a:cubicBezTo>
                    <a:pt x="4776566" y="390258"/>
                    <a:pt x="4777900" y="391974"/>
                    <a:pt x="4747991" y="413691"/>
                  </a:cubicBezTo>
                  <a:cubicBezTo>
                    <a:pt x="4732369" y="425121"/>
                    <a:pt x="4710842" y="436742"/>
                    <a:pt x="4692745" y="435790"/>
                  </a:cubicBezTo>
                  <a:cubicBezTo>
                    <a:pt x="4583584" y="430075"/>
                    <a:pt x="4479758" y="457508"/>
                    <a:pt x="4375933" y="483417"/>
                  </a:cubicBezTo>
                  <a:cubicBezTo>
                    <a:pt x="4311923" y="499420"/>
                    <a:pt x="4249436" y="500372"/>
                    <a:pt x="4185426" y="484179"/>
                  </a:cubicBezTo>
                  <a:cubicBezTo>
                    <a:pt x="4139133" y="472367"/>
                    <a:pt x="4095315" y="491800"/>
                    <a:pt x="4052072" y="505134"/>
                  </a:cubicBezTo>
                  <a:cubicBezTo>
                    <a:pt x="4043117" y="507799"/>
                    <a:pt x="4034735" y="518278"/>
                    <a:pt x="4029973" y="527233"/>
                  </a:cubicBezTo>
                  <a:cubicBezTo>
                    <a:pt x="4012826" y="558858"/>
                    <a:pt x="3984441" y="563810"/>
                    <a:pt x="3948626" y="550666"/>
                  </a:cubicBezTo>
                  <a:cubicBezTo>
                    <a:pt x="3920241" y="540377"/>
                    <a:pt x="3894332" y="526661"/>
                    <a:pt x="3871280" y="502275"/>
                  </a:cubicBezTo>
                  <a:cubicBezTo>
                    <a:pt x="3844229" y="473701"/>
                    <a:pt x="3816224" y="441124"/>
                    <a:pt x="3774312" y="429122"/>
                  </a:cubicBezTo>
                  <a:cubicBezTo>
                    <a:pt x="3756214" y="423979"/>
                    <a:pt x="3740593" y="423217"/>
                    <a:pt x="3721543" y="428552"/>
                  </a:cubicBezTo>
                  <a:cubicBezTo>
                    <a:pt x="3684583" y="438837"/>
                    <a:pt x="3647436" y="446078"/>
                    <a:pt x="3612763" y="414263"/>
                  </a:cubicBezTo>
                  <a:cubicBezTo>
                    <a:pt x="3593712" y="396736"/>
                    <a:pt x="3567994" y="385496"/>
                    <a:pt x="3537323" y="389878"/>
                  </a:cubicBezTo>
                  <a:cubicBezTo>
                    <a:pt x="3499031" y="395402"/>
                    <a:pt x="3464168" y="381496"/>
                    <a:pt x="3431593" y="360921"/>
                  </a:cubicBezTo>
                  <a:cubicBezTo>
                    <a:pt x="3419971" y="353491"/>
                    <a:pt x="3405682" y="349301"/>
                    <a:pt x="3392158" y="345681"/>
                  </a:cubicBezTo>
                  <a:cubicBezTo>
                    <a:pt x="3360915" y="337298"/>
                    <a:pt x="3329480" y="329868"/>
                    <a:pt x="3297856" y="323010"/>
                  </a:cubicBezTo>
                  <a:cubicBezTo>
                    <a:pt x="3271948" y="317296"/>
                    <a:pt x="3245849" y="313104"/>
                    <a:pt x="3219748" y="308151"/>
                  </a:cubicBezTo>
                  <a:cubicBezTo>
                    <a:pt x="3191173" y="302817"/>
                    <a:pt x="3168502" y="290433"/>
                    <a:pt x="3156692" y="261668"/>
                  </a:cubicBezTo>
                  <a:cubicBezTo>
                    <a:pt x="3152882" y="252524"/>
                    <a:pt x="3143737" y="245283"/>
                    <a:pt x="3136497" y="237663"/>
                  </a:cubicBezTo>
                  <a:cubicBezTo>
                    <a:pt x="3131355" y="232139"/>
                    <a:pt x="3124495" y="227947"/>
                    <a:pt x="3119733" y="222233"/>
                  </a:cubicBezTo>
                  <a:cubicBezTo>
                    <a:pt x="3094776" y="192132"/>
                    <a:pt x="3070201" y="161843"/>
                    <a:pt x="3045436" y="131742"/>
                  </a:cubicBezTo>
                  <a:cubicBezTo>
                    <a:pt x="3042958" y="128884"/>
                    <a:pt x="3040292" y="125455"/>
                    <a:pt x="3037054" y="124121"/>
                  </a:cubicBezTo>
                  <a:cubicBezTo>
                    <a:pt x="3003525" y="110215"/>
                    <a:pt x="2969614" y="97070"/>
                    <a:pt x="2936466" y="82400"/>
                  </a:cubicBezTo>
                  <a:cubicBezTo>
                    <a:pt x="2923702" y="76686"/>
                    <a:pt x="2910558" y="69637"/>
                    <a:pt x="2901031" y="59731"/>
                  </a:cubicBezTo>
                  <a:cubicBezTo>
                    <a:pt x="2879314" y="37250"/>
                    <a:pt x="2859502" y="12866"/>
                    <a:pt x="2828259" y="3149"/>
                  </a:cubicBezTo>
                  <a:cubicBezTo>
                    <a:pt x="2819114" y="293"/>
                    <a:pt x="2808256" y="-1231"/>
                    <a:pt x="2799492" y="1245"/>
                  </a:cubicBezTo>
                  <a:cubicBezTo>
                    <a:pt x="2763867" y="11532"/>
                    <a:pt x="2729005" y="24296"/>
                    <a:pt x="2693570" y="35154"/>
                  </a:cubicBezTo>
                  <a:cubicBezTo>
                    <a:pt x="2671092" y="41823"/>
                    <a:pt x="2650707" y="49825"/>
                    <a:pt x="2639847" y="73448"/>
                  </a:cubicBezTo>
                  <a:cubicBezTo>
                    <a:pt x="2636801" y="80114"/>
                    <a:pt x="2628226" y="87354"/>
                    <a:pt x="2621178" y="88688"/>
                  </a:cubicBezTo>
                  <a:cubicBezTo>
                    <a:pt x="2575839" y="97260"/>
                    <a:pt x="2531069" y="101451"/>
                    <a:pt x="2489348" y="72304"/>
                  </a:cubicBezTo>
                  <a:cubicBezTo>
                    <a:pt x="2480585" y="66017"/>
                    <a:pt x="2464201" y="66017"/>
                    <a:pt x="2452580" y="68683"/>
                  </a:cubicBezTo>
                  <a:cubicBezTo>
                    <a:pt x="2407811" y="78590"/>
                    <a:pt x="2365328" y="82020"/>
                    <a:pt x="2326464" y="50395"/>
                  </a:cubicBezTo>
                  <a:cubicBezTo>
                    <a:pt x="2321892" y="46585"/>
                    <a:pt x="2307224" y="50015"/>
                    <a:pt x="2300365" y="54777"/>
                  </a:cubicBezTo>
                  <a:cubicBezTo>
                    <a:pt x="2234259" y="101261"/>
                    <a:pt x="2198064" y="102405"/>
                    <a:pt x="2130434" y="58397"/>
                  </a:cubicBezTo>
                  <a:cubicBezTo>
                    <a:pt x="2126052" y="55539"/>
                    <a:pt x="2120337" y="52301"/>
                    <a:pt x="2118621" y="47919"/>
                  </a:cubicBezTo>
                  <a:cubicBezTo>
                    <a:pt x="2107001" y="19914"/>
                    <a:pt x="2082236" y="19152"/>
                    <a:pt x="2057659" y="16866"/>
                  </a:cubicBezTo>
                  <a:cubicBezTo>
                    <a:pt x="2030608" y="14390"/>
                    <a:pt x="2003555" y="11152"/>
                    <a:pt x="1976314" y="8865"/>
                  </a:cubicBezTo>
                  <a:cubicBezTo>
                    <a:pt x="1971550" y="8483"/>
                    <a:pt x="1966216" y="10007"/>
                    <a:pt x="1961454" y="11724"/>
                  </a:cubicBezTo>
                  <a:cubicBezTo>
                    <a:pt x="1943165" y="18010"/>
                    <a:pt x="1925449" y="27154"/>
                    <a:pt x="1906588" y="30964"/>
                  </a:cubicBezTo>
                  <a:cubicBezTo>
                    <a:pt x="1865821" y="39156"/>
                    <a:pt x="1826385" y="55539"/>
                    <a:pt x="1783330" y="48871"/>
                  </a:cubicBezTo>
                  <a:cubicBezTo>
                    <a:pt x="1775902" y="47729"/>
                    <a:pt x="1767327" y="53253"/>
                    <a:pt x="1759327" y="55349"/>
                  </a:cubicBezTo>
                  <a:cubicBezTo>
                    <a:pt x="1744849" y="58969"/>
                    <a:pt x="1730750" y="64111"/>
                    <a:pt x="1716082" y="65445"/>
                  </a:cubicBezTo>
                  <a:cubicBezTo>
                    <a:pt x="1677218" y="68875"/>
                    <a:pt x="1637975" y="71924"/>
                    <a:pt x="1598920" y="72114"/>
                  </a:cubicBezTo>
                  <a:cubicBezTo>
                    <a:pt x="1580061" y="72304"/>
                    <a:pt x="1561201" y="65065"/>
                    <a:pt x="1542150" y="62207"/>
                  </a:cubicBezTo>
                  <a:cubicBezTo>
                    <a:pt x="1533578" y="60873"/>
                    <a:pt x="1519669" y="58587"/>
                    <a:pt x="1516813" y="62779"/>
                  </a:cubicBezTo>
                  <a:cubicBezTo>
                    <a:pt x="1494714" y="94592"/>
                    <a:pt x="1463661" y="88496"/>
                    <a:pt x="1432228" y="88116"/>
                  </a:cubicBezTo>
                  <a:cubicBezTo>
                    <a:pt x="1362884" y="87354"/>
                    <a:pt x="1295826" y="60493"/>
                    <a:pt x="1224765" y="71924"/>
                  </a:cubicBezTo>
                  <a:cubicBezTo>
                    <a:pt x="1204191" y="75162"/>
                    <a:pt x="1181330" y="62397"/>
                    <a:pt x="1159231" y="58207"/>
                  </a:cubicBezTo>
                  <a:cubicBezTo>
                    <a:pt x="1147801" y="56111"/>
                    <a:pt x="1135228" y="53633"/>
                    <a:pt x="1124370" y="56301"/>
                  </a:cubicBezTo>
                  <a:cubicBezTo>
                    <a:pt x="1107605" y="60493"/>
                    <a:pt x="1091411" y="68113"/>
                    <a:pt x="1075600" y="75542"/>
                  </a:cubicBezTo>
                  <a:cubicBezTo>
                    <a:pt x="1046261" y="89258"/>
                    <a:pt x="1016162" y="89258"/>
                    <a:pt x="986633" y="79162"/>
                  </a:cubicBezTo>
                  <a:cubicBezTo>
                    <a:pt x="944722" y="64873"/>
                    <a:pt x="903193" y="64873"/>
                    <a:pt x="861089" y="76304"/>
                  </a:cubicBezTo>
                  <a:cubicBezTo>
                    <a:pt x="826990" y="85638"/>
                    <a:pt x="791935" y="92116"/>
                    <a:pt x="759168" y="104689"/>
                  </a:cubicBezTo>
                  <a:cubicBezTo>
                    <a:pt x="744689" y="110215"/>
                    <a:pt x="732497" y="126597"/>
                    <a:pt x="723735" y="140696"/>
                  </a:cubicBezTo>
                  <a:cubicBezTo>
                    <a:pt x="706018" y="169271"/>
                    <a:pt x="674013" y="169081"/>
                    <a:pt x="647532" y="147934"/>
                  </a:cubicBezTo>
                  <a:cubicBezTo>
                    <a:pt x="619717" y="125645"/>
                    <a:pt x="584664" y="112501"/>
                    <a:pt x="552659" y="95926"/>
                  </a:cubicBezTo>
                  <a:cubicBezTo>
                    <a:pt x="549993" y="94592"/>
                    <a:pt x="545039" y="96116"/>
                    <a:pt x="541800" y="97640"/>
                  </a:cubicBezTo>
                  <a:cubicBezTo>
                    <a:pt x="488649" y="122407"/>
                    <a:pt x="433593" y="126979"/>
                    <a:pt x="375107" y="123169"/>
                  </a:cubicBezTo>
                  <a:cubicBezTo>
                    <a:pt x="341960" y="121073"/>
                    <a:pt x="307289" y="137076"/>
                    <a:pt x="273567" y="145458"/>
                  </a:cubicBezTo>
                  <a:cubicBezTo>
                    <a:pt x="269757" y="146410"/>
                    <a:pt x="266519" y="151174"/>
                    <a:pt x="264043" y="154792"/>
                  </a:cubicBezTo>
                  <a:cubicBezTo>
                    <a:pt x="240228" y="190800"/>
                    <a:pt x="208223" y="200706"/>
                    <a:pt x="169360" y="177273"/>
                  </a:cubicBezTo>
                  <a:cubicBezTo>
                    <a:pt x="143643" y="161651"/>
                    <a:pt x="118114" y="158032"/>
                    <a:pt x="89347" y="157460"/>
                  </a:cubicBezTo>
                  <a:cubicBezTo>
                    <a:pt x="71059" y="157078"/>
                    <a:pt x="52962" y="147934"/>
                    <a:pt x="34291" y="145268"/>
                  </a:cubicBezTo>
                  <a:lnTo>
                    <a:pt x="0" y="142056"/>
                  </a:lnTo>
                  <a:lnTo>
                    <a:pt x="0" y="849556"/>
                  </a:lnTo>
                  <a:lnTo>
                    <a:pt x="60652" y="844783"/>
                  </a:lnTo>
                  <a:cubicBezTo>
                    <a:pt x="80251" y="839473"/>
                    <a:pt x="99446" y="832043"/>
                    <a:pt x="119068" y="827281"/>
                  </a:cubicBezTo>
                  <a:cubicBezTo>
                    <a:pt x="137355" y="822899"/>
                    <a:pt x="154501" y="812802"/>
                    <a:pt x="171840" y="804420"/>
                  </a:cubicBezTo>
                  <a:cubicBezTo>
                    <a:pt x="204985" y="788417"/>
                    <a:pt x="240420" y="798514"/>
                    <a:pt x="274329" y="794324"/>
                  </a:cubicBezTo>
                  <a:cubicBezTo>
                    <a:pt x="285188" y="792990"/>
                    <a:pt x="296046" y="791466"/>
                    <a:pt x="306715" y="788798"/>
                  </a:cubicBezTo>
                  <a:cubicBezTo>
                    <a:pt x="335864" y="781749"/>
                    <a:pt x="365583" y="775653"/>
                    <a:pt x="393967" y="765937"/>
                  </a:cubicBezTo>
                  <a:cubicBezTo>
                    <a:pt x="426165" y="755078"/>
                    <a:pt x="457028" y="740600"/>
                    <a:pt x="493793" y="725549"/>
                  </a:cubicBezTo>
                  <a:cubicBezTo>
                    <a:pt x="506557" y="729360"/>
                    <a:pt x="526180" y="739648"/>
                    <a:pt x="546373" y="740600"/>
                  </a:cubicBezTo>
                  <a:cubicBezTo>
                    <a:pt x="611337" y="743838"/>
                    <a:pt x="672107" y="726121"/>
                    <a:pt x="730211" y="698116"/>
                  </a:cubicBezTo>
                  <a:cubicBezTo>
                    <a:pt x="747927" y="689734"/>
                    <a:pt x="766980" y="684210"/>
                    <a:pt x="784889" y="676018"/>
                  </a:cubicBezTo>
                  <a:cubicBezTo>
                    <a:pt x="791173" y="673161"/>
                    <a:pt x="799365" y="667065"/>
                    <a:pt x="800509" y="661349"/>
                  </a:cubicBezTo>
                  <a:cubicBezTo>
                    <a:pt x="807175" y="628201"/>
                    <a:pt x="831942" y="628772"/>
                    <a:pt x="857661" y="626868"/>
                  </a:cubicBezTo>
                  <a:cubicBezTo>
                    <a:pt x="888332" y="624582"/>
                    <a:pt x="918621" y="619248"/>
                    <a:pt x="949102" y="614676"/>
                  </a:cubicBezTo>
                  <a:cubicBezTo>
                    <a:pt x="953104" y="614104"/>
                    <a:pt x="956722" y="610104"/>
                    <a:pt x="960342" y="607435"/>
                  </a:cubicBezTo>
                  <a:cubicBezTo>
                    <a:pt x="965867" y="603435"/>
                    <a:pt x="971011" y="597339"/>
                    <a:pt x="977109" y="595815"/>
                  </a:cubicBezTo>
                  <a:cubicBezTo>
                    <a:pt x="1008350" y="588385"/>
                    <a:pt x="1039783" y="582099"/>
                    <a:pt x="1071218" y="575240"/>
                  </a:cubicBezTo>
                  <a:cubicBezTo>
                    <a:pt x="1078266" y="573716"/>
                    <a:pt x="1085505" y="571812"/>
                    <a:pt x="1091983" y="568764"/>
                  </a:cubicBezTo>
                  <a:cubicBezTo>
                    <a:pt x="1098079" y="565906"/>
                    <a:pt x="1103223" y="560952"/>
                    <a:pt x="1109321" y="557904"/>
                  </a:cubicBezTo>
                  <a:cubicBezTo>
                    <a:pt x="1125892" y="549714"/>
                    <a:pt x="1142851" y="542093"/>
                    <a:pt x="1162279" y="532949"/>
                  </a:cubicBezTo>
                  <a:cubicBezTo>
                    <a:pt x="1173138" y="550094"/>
                    <a:pt x="1187810" y="540377"/>
                    <a:pt x="1206097" y="532187"/>
                  </a:cubicBezTo>
                  <a:cubicBezTo>
                    <a:pt x="1224765" y="523805"/>
                    <a:pt x="1246292" y="521137"/>
                    <a:pt x="1266867" y="518088"/>
                  </a:cubicBezTo>
                  <a:cubicBezTo>
                    <a:pt x="1304588" y="512564"/>
                    <a:pt x="1342499" y="509134"/>
                    <a:pt x="1380219" y="504182"/>
                  </a:cubicBezTo>
                  <a:cubicBezTo>
                    <a:pt x="1388221" y="503038"/>
                    <a:pt x="1397365" y="500944"/>
                    <a:pt x="1403461" y="496180"/>
                  </a:cubicBezTo>
                  <a:cubicBezTo>
                    <a:pt x="1445181" y="464175"/>
                    <a:pt x="1495858" y="455222"/>
                    <a:pt x="1544054" y="458268"/>
                  </a:cubicBezTo>
                  <a:cubicBezTo>
                    <a:pt x="1581965" y="460557"/>
                    <a:pt x="1619114" y="462270"/>
                    <a:pt x="1656644" y="459032"/>
                  </a:cubicBezTo>
                  <a:cubicBezTo>
                    <a:pt x="1659502" y="458841"/>
                    <a:pt x="1663312" y="459223"/>
                    <a:pt x="1665406" y="460747"/>
                  </a:cubicBezTo>
                  <a:cubicBezTo>
                    <a:pt x="1678360" y="470843"/>
                    <a:pt x="1691887" y="471605"/>
                    <a:pt x="1708461" y="473318"/>
                  </a:cubicBezTo>
                  <a:cubicBezTo>
                    <a:pt x="1731894" y="475797"/>
                    <a:pt x="1753421" y="474081"/>
                    <a:pt x="1775140" y="469891"/>
                  </a:cubicBezTo>
                  <a:cubicBezTo>
                    <a:pt x="1790952" y="466843"/>
                    <a:pt x="1806953" y="460557"/>
                    <a:pt x="1821051" y="452554"/>
                  </a:cubicBezTo>
                  <a:cubicBezTo>
                    <a:pt x="1840672" y="441314"/>
                    <a:pt x="1859535" y="436934"/>
                    <a:pt x="1878203" y="451792"/>
                  </a:cubicBezTo>
                  <a:cubicBezTo>
                    <a:pt x="1898396" y="467605"/>
                    <a:pt x="1921257" y="462081"/>
                    <a:pt x="1943547" y="462651"/>
                  </a:cubicBezTo>
                  <a:cubicBezTo>
                    <a:pt x="1953262" y="462843"/>
                    <a:pt x="1963550" y="462461"/>
                    <a:pt x="1972884" y="464937"/>
                  </a:cubicBezTo>
                  <a:cubicBezTo>
                    <a:pt x="1999935" y="471987"/>
                    <a:pt x="2026036" y="482655"/>
                    <a:pt x="2053469" y="487417"/>
                  </a:cubicBezTo>
                  <a:cubicBezTo>
                    <a:pt x="2068710" y="490084"/>
                    <a:pt x="2085664" y="485321"/>
                    <a:pt x="2101477" y="481893"/>
                  </a:cubicBezTo>
                  <a:cubicBezTo>
                    <a:pt x="2117479" y="478273"/>
                    <a:pt x="2133290" y="472749"/>
                    <a:pt x="2148722" y="467033"/>
                  </a:cubicBezTo>
                  <a:cubicBezTo>
                    <a:pt x="2159199" y="463223"/>
                    <a:pt x="2170629" y="459603"/>
                    <a:pt x="2179011" y="452744"/>
                  </a:cubicBezTo>
                  <a:cubicBezTo>
                    <a:pt x="2198064" y="437124"/>
                    <a:pt x="2217685" y="434455"/>
                    <a:pt x="2240165" y="442648"/>
                  </a:cubicBezTo>
                  <a:cubicBezTo>
                    <a:pt x="2243593" y="443982"/>
                    <a:pt x="2247594" y="443982"/>
                    <a:pt x="2251404" y="444172"/>
                  </a:cubicBezTo>
                  <a:cubicBezTo>
                    <a:pt x="2312370" y="448172"/>
                    <a:pt x="2373330" y="450650"/>
                    <a:pt x="2433912" y="456746"/>
                  </a:cubicBezTo>
                  <a:cubicBezTo>
                    <a:pt x="2458485" y="459223"/>
                    <a:pt x="2482107" y="470081"/>
                    <a:pt x="2506302" y="476939"/>
                  </a:cubicBezTo>
                  <a:cubicBezTo>
                    <a:pt x="2511256" y="478273"/>
                    <a:pt x="2516783" y="480369"/>
                    <a:pt x="2521735" y="479415"/>
                  </a:cubicBezTo>
                  <a:cubicBezTo>
                    <a:pt x="2575647" y="469891"/>
                    <a:pt x="2626132" y="483797"/>
                    <a:pt x="2675854" y="502086"/>
                  </a:cubicBezTo>
                  <a:cubicBezTo>
                    <a:pt x="2680996" y="503992"/>
                    <a:pt x="2687282" y="503419"/>
                    <a:pt x="2692998" y="503038"/>
                  </a:cubicBezTo>
                  <a:cubicBezTo>
                    <a:pt x="2709003" y="501706"/>
                    <a:pt x="2726337" y="495038"/>
                    <a:pt x="2740816" y="499037"/>
                  </a:cubicBezTo>
                  <a:cubicBezTo>
                    <a:pt x="2779297" y="510088"/>
                    <a:pt x="2817398" y="523423"/>
                    <a:pt x="2853596" y="540187"/>
                  </a:cubicBezTo>
                  <a:cubicBezTo>
                    <a:pt x="2890365" y="557142"/>
                    <a:pt x="2924464" y="571430"/>
                    <a:pt x="2966565" y="554286"/>
                  </a:cubicBezTo>
                  <a:cubicBezTo>
                    <a:pt x="2984472" y="547045"/>
                    <a:pt x="3008095" y="552190"/>
                    <a:pt x="3028671" y="554094"/>
                  </a:cubicBezTo>
                  <a:cubicBezTo>
                    <a:pt x="3043720" y="555618"/>
                    <a:pt x="3058198" y="564192"/>
                    <a:pt x="3073059" y="564192"/>
                  </a:cubicBezTo>
                  <a:cubicBezTo>
                    <a:pt x="3112686" y="564192"/>
                    <a:pt x="3147927" y="574288"/>
                    <a:pt x="3182219" y="594862"/>
                  </a:cubicBezTo>
                  <a:cubicBezTo>
                    <a:pt x="3195557" y="602863"/>
                    <a:pt x="3216322" y="597529"/>
                    <a:pt x="3233656" y="599625"/>
                  </a:cubicBezTo>
                  <a:cubicBezTo>
                    <a:pt x="3251947" y="602101"/>
                    <a:pt x="3270804" y="604387"/>
                    <a:pt x="3288332" y="609914"/>
                  </a:cubicBezTo>
                  <a:cubicBezTo>
                    <a:pt x="3333672" y="624392"/>
                    <a:pt x="3378441" y="640774"/>
                    <a:pt x="3423591" y="656015"/>
                  </a:cubicBezTo>
                  <a:cubicBezTo>
                    <a:pt x="3460738" y="668590"/>
                    <a:pt x="3497317" y="658683"/>
                    <a:pt x="3534084" y="653349"/>
                  </a:cubicBezTo>
                  <a:cubicBezTo>
                    <a:pt x="3557137" y="649919"/>
                    <a:pt x="3578662" y="641727"/>
                    <a:pt x="3604571" y="653918"/>
                  </a:cubicBezTo>
                  <a:cubicBezTo>
                    <a:pt x="3629338" y="665541"/>
                    <a:pt x="3660771" y="662873"/>
                    <a:pt x="3688586" y="669160"/>
                  </a:cubicBezTo>
                  <a:cubicBezTo>
                    <a:pt x="3712020" y="674494"/>
                    <a:pt x="3734687" y="683068"/>
                    <a:pt x="3757358" y="691450"/>
                  </a:cubicBezTo>
                  <a:cubicBezTo>
                    <a:pt x="3788221" y="702881"/>
                    <a:pt x="3818700" y="714881"/>
                    <a:pt x="3852421" y="709167"/>
                  </a:cubicBezTo>
                  <a:cubicBezTo>
                    <a:pt x="3890714" y="702689"/>
                    <a:pt x="3917001" y="727073"/>
                    <a:pt x="3947104" y="743267"/>
                  </a:cubicBezTo>
                  <a:cubicBezTo>
                    <a:pt x="3967869" y="754316"/>
                    <a:pt x="3990538" y="762509"/>
                    <a:pt x="4013208" y="769367"/>
                  </a:cubicBezTo>
                  <a:cubicBezTo>
                    <a:pt x="4043497" y="778321"/>
                    <a:pt x="4074740" y="783655"/>
                    <a:pt x="4105222" y="792418"/>
                  </a:cubicBezTo>
                  <a:cubicBezTo>
                    <a:pt x="4151325" y="805561"/>
                    <a:pt x="4198001" y="815850"/>
                    <a:pt x="4246006" y="808610"/>
                  </a:cubicBezTo>
                  <a:cubicBezTo>
                    <a:pt x="4268105" y="805372"/>
                    <a:pt x="4288682" y="805561"/>
                    <a:pt x="4310779" y="810326"/>
                  </a:cubicBezTo>
                  <a:cubicBezTo>
                    <a:pt x="4346974" y="818136"/>
                    <a:pt x="4384123" y="819089"/>
                    <a:pt x="4413272" y="848235"/>
                  </a:cubicBezTo>
                  <a:cubicBezTo>
                    <a:pt x="4423558" y="858524"/>
                    <a:pt x="4442037" y="861190"/>
                    <a:pt x="4457087" y="866524"/>
                  </a:cubicBezTo>
                  <a:cubicBezTo>
                    <a:pt x="4474424" y="872812"/>
                    <a:pt x="4487186" y="869572"/>
                    <a:pt x="4496523" y="851284"/>
                  </a:cubicBezTo>
                  <a:cubicBezTo>
                    <a:pt x="4500713" y="843093"/>
                    <a:pt x="4512715" y="835091"/>
                    <a:pt x="4522050" y="833757"/>
                  </a:cubicBezTo>
                  <a:cubicBezTo>
                    <a:pt x="4550055" y="829757"/>
                    <a:pt x="4575773" y="835663"/>
                    <a:pt x="4602824" y="848618"/>
                  </a:cubicBezTo>
                  <a:cubicBezTo>
                    <a:pt x="4628161" y="860810"/>
                    <a:pt x="4659786" y="859476"/>
                    <a:pt x="4688553" y="864238"/>
                  </a:cubicBezTo>
                  <a:cubicBezTo>
                    <a:pt x="4708936" y="867668"/>
                    <a:pt x="4729321" y="874716"/>
                    <a:pt x="4749895" y="874716"/>
                  </a:cubicBezTo>
                  <a:cubicBezTo>
                    <a:pt x="4775424" y="874716"/>
                    <a:pt x="4800761" y="868620"/>
                    <a:pt x="4826480" y="866334"/>
                  </a:cubicBezTo>
                  <a:cubicBezTo>
                    <a:pt x="4846482" y="864430"/>
                    <a:pt x="4866867" y="865192"/>
                    <a:pt x="4886870" y="862906"/>
                  </a:cubicBezTo>
                  <a:cubicBezTo>
                    <a:pt x="4903254" y="861190"/>
                    <a:pt x="4919447" y="856810"/>
                    <a:pt x="4935639" y="853190"/>
                  </a:cubicBezTo>
                  <a:cubicBezTo>
                    <a:pt x="4941546" y="851856"/>
                    <a:pt x="4947452" y="846711"/>
                    <a:pt x="4952784" y="847473"/>
                  </a:cubicBezTo>
                  <a:cubicBezTo>
                    <a:pt x="5005745" y="855666"/>
                    <a:pt x="5043847" y="819089"/>
                    <a:pt x="5088617" y="802896"/>
                  </a:cubicBezTo>
                  <a:cubicBezTo>
                    <a:pt x="5135672" y="785749"/>
                    <a:pt x="5181204" y="759461"/>
                    <a:pt x="5233781" y="767271"/>
                  </a:cubicBezTo>
                  <a:cubicBezTo>
                    <a:pt x="5265596" y="772033"/>
                    <a:pt x="5296267" y="783083"/>
                    <a:pt x="5327893" y="789752"/>
                  </a:cubicBezTo>
                  <a:cubicBezTo>
                    <a:pt x="5339132" y="792038"/>
                    <a:pt x="5351705" y="791656"/>
                    <a:pt x="5362946" y="789370"/>
                  </a:cubicBezTo>
                  <a:cubicBezTo>
                    <a:pt x="5417240" y="778891"/>
                    <a:pt x="5470771" y="777367"/>
                    <a:pt x="5524115" y="794514"/>
                  </a:cubicBezTo>
                  <a:cubicBezTo>
                    <a:pt x="5533257" y="797372"/>
                    <a:pt x="5542974" y="800038"/>
                    <a:pt x="5552500" y="800038"/>
                  </a:cubicBezTo>
                  <a:cubicBezTo>
                    <a:pt x="5604697" y="800038"/>
                    <a:pt x="5655944" y="796038"/>
                    <a:pt x="5705857" y="777367"/>
                  </a:cubicBezTo>
                  <a:cubicBezTo>
                    <a:pt x="5722622" y="771080"/>
                    <a:pt x="5743006" y="775081"/>
                    <a:pt x="5761485" y="773557"/>
                  </a:cubicBezTo>
                  <a:cubicBezTo>
                    <a:pt x="5778629" y="772224"/>
                    <a:pt x="5796156" y="771653"/>
                    <a:pt x="5812731" y="767271"/>
                  </a:cubicBezTo>
                  <a:cubicBezTo>
                    <a:pt x="5836925" y="760795"/>
                    <a:pt x="5859404" y="760033"/>
                    <a:pt x="5884361" y="765747"/>
                  </a:cubicBezTo>
                  <a:cubicBezTo>
                    <a:pt x="5908174" y="771080"/>
                    <a:pt x="5933892" y="768415"/>
                    <a:pt x="5958660" y="768605"/>
                  </a:cubicBezTo>
                  <a:cubicBezTo>
                    <a:pt x="5986282" y="768795"/>
                    <a:pt x="6013906" y="768984"/>
                    <a:pt x="6041528" y="768033"/>
                  </a:cubicBezTo>
                  <a:cubicBezTo>
                    <a:pt x="6052579" y="767653"/>
                    <a:pt x="6065151" y="760033"/>
                    <a:pt x="6074297" y="763081"/>
                  </a:cubicBezTo>
                  <a:cubicBezTo>
                    <a:pt x="6103824" y="773366"/>
                    <a:pt x="6133353" y="760985"/>
                    <a:pt x="6162880" y="766509"/>
                  </a:cubicBezTo>
                  <a:cubicBezTo>
                    <a:pt x="6177360" y="769367"/>
                    <a:pt x="6193743" y="761557"/>
                    <a:pt x="6209364" y="760795"/>
                  </a:cubicBezTo>
                  <a:cubicBezTo>
                    <a:pt x="6234892" y="759461"/>
                    <a:pt x="6260419" y="760033"/>
                    <a:pt x="6285948" y="759651"/>
                  </a:cubicBezTo>
                  <a:cubicBezTo>
                    <a:pt x="6294330" y="759461"/>
                    <a:pt x="6302523" y="758699"/>
                    <a:pt x="6310905" y="758316"/>
                  </a:cubicBezTo>
                  <a:cubicBezTo>
                    <a:pt x="6318335" y="757936"/>
                    <a:pt x="6326145" y="756222"/>
                    <a:pt x="6333194" y="757554"/>
                  </a:cubicBezTo>
                  <a:cubicBezTo>
                    <a:pt x="6358723" y="762318"/>
                    <a:pt x="6383869" y="770129"/>
                    <a:pt x="6409586" y="773177"/>
                  </a:cubicBezTo>
                  <a:cubicBezTo>
                    <a:pt x="6431875" y="775843"/>
                    <a:pt x="6454928" y="772224"/>
                    <a:pt x="6477407" y="774129"/>
                  </a:cubicBezTo>
                  <a:cubicBezTo>
                    <a:pt x="6517032" y="777367"/>
                    <a:pt x="6556657" y="783083"/>
                    <a:pt x="6596283" y="786703"/>
                  </a:cubicBezTo>
                  <a:cubicBezTo>
                    <a:pt x="6604857" y="787465"/>
                    <a:pt x="6613809" y="782701"/>
                    <a:pt x="6622573" y="782321"/>
                  </a:cubicBezTo>
                  <a:cubicBezTo>
                    <a:pt x="6650006" y="781369"/>
                    <a:pt x="6677439" y="781177"/>
                    <a:pt x="6704872" y="780607"/>
                  </a:cubicBezTo>
                  <a:cubicBezTo>
                    <a:pt x="6720493" y="780415"/>
                    <a:pt x="6736305" y="780987"/>
                    <a:pt x="6751738" y="779273"/>
                  </a:cubicBezTo>
                  <a:cubicBezTo>
                    <a:pt x="6772120" y="776987"/>
                    <a:pt x="6790599" y="773557"/>
                    <a:pt x="6809650" y="788417"/>
                  </a:cubicBezTo>
                  <a:cubicBezTo>
                    <a:pt x="6816984" y="794180"/>
                    <a:pt x="6824819" y="797942"/>
                    <a:pt x="6832976" y="800428"/>
                  </a:cubicBezTo>
                  <a:close/>
                </a:path>
              </a:pathLst>
            </a:custGeom>
            <a:solidFill>
              <a:srgbClr val="FFFFFF"/>
            </a:solidFill>
            <a:ln>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
          <p:nvSpPr>
            <p:cNvPr id="4107" name="Freeform: Shape 4106">
              <a:extLst>
                <a:ext uri="{FF2B5EF4-FFF2-40B4-BE49-F238E27FC236}">
                  <a16:creationId xmlns:a16="http://schemas.microsoft.com/office/drawing/2014/main" id="{4E59A2A1-1352-47AA-80C2-0FF5375940EC}"/>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rot="16200000">
              <a:off x="2403998" y="2991370"/>
              <a:ext cx="6857455" cy="874716"/>
            </a:xfrm>
            <a:custGeom>
              <a:avLst/>
              <a:gdLst>
                <a:gd name="connsiteX0" fmla="*/ 6857455 w 6857455"/>
                <a:gd name="connsiteY0" fmla="*/ 804643 h 874716"/>
                <a:gd name="connsiteX1" fmla="*/ 6857455 w 6857455"/>
                <a:gd name="connsiteY1" fmla="*/ 562246 h 874716"/>
                <a:gd name="connsiteX2" fmla="*/ 6829178 w 6857455"/>
                <a:gd name="connsiteY2" fmla="*/ 551284 h 874716"/>
                <a:gd name="connsiteX3" fmla="*/ 6766024 w 6857455"/>
                <a:gd name="connsiteY3" fmla="*/ 500372 h 874716"/>
                <a:gd name="connsiteX4" fmla="*/ 6734971 w 6857455"/>
                <a:gd name="connsiteY4" fmla="*/ 500944 h 874716"/>
                <a:gd name="connsiteX5" fmla="*/ 6683915 w 6857455"/>
                <a:gd name="connsiteY5" fmla="*/ 507040 h 874716"/>
                <a:gd name="connsiteX6" fmla="*/ 6628860 w 6857455"/>
                <a:gd name="connsiteY6" fmla="*/ 495418 h 874716"/>
                <a:gd name="connsiteX7" fmla="*/ 6588662 w 6857455"/>
                <a:gd name="connsiteY7" fmla="*/ 487227 h 874716"/>
                <a:gd name="connsiteX8" fmla="*/ 6476074 w 6857455"/>
                <a:gd name="connsiteY8" fmla="*/ 511230 h 874716"/>
                <a:gd name="connsiteX9" fmla="*/ 6382345 w 6857455"/>
                <a:gd name="connsiteY9" fmla="*/ 534853 h 874716"/>
                <a:gd name="connsiteX10" fmla="*/ 6369391 w 6857455"/>
                <a:gd name="connsiteY10" fmla="*/ 531615 h 874716"/>
                <a:gd name="connsiteX11" fmla="*/ 6244799 w 6857455"/>
                <a:gd name="connsiteY11" fmla="*/ 512182 h 874716"/>
                <a:gd name="connsiteX12" fmla="*/ 6190315 w 6857455"/>
                <a:gd name="connsiteY12" fmla="*/ 485703 h 874716"/>
                <a:gd name="connsiteX13" fmla="*/ 6115446 w 6857455"/>
                <a:gd name="connsiteY13" fmla="*/ 462270 h 874716"/>
                <a:gd name="connsiteX14" fmla="*/ 6032194 w 6857455"/>
                <a:gd name="connsiteY14" fmla="*/ 434266 h 874716"/>
                <a:gd name="connsiteX15" fmla="*/ 5971042 w 6857455"/>
                <a:gd name="connsiteY15" fmla="*/ 420738 h 874716"/>
                <a:gd name="connsiteX16" fmla="*/ 5880933 w 6857455"/>
                <a:gd name="connsiteY16" fmla="*/ 430646 h 874716"/>
                <a:gd name="connsiteX17" fmla="*/ 5862452 w 6857455"/>
                <a:gd name="connsiteY17" fmla="*/ 438648 h 874716"/>
                <a:gd name="connsiteX18" fmla="*/ 5685283 w 6857455"/>
                <a:gd name="connsiteY18" fmla="*/ 498658 h 874716"/>
                <a:gd name="connsiteX19" fmla="*/ 5567169 w 6857455"/>
                <a:gd name="connsiteY19" fmla="*/ 499420 h 874716"/>
                <a:gd name="connsiteX20" fmla="*/ 5527923 w 6857455"/>
                <a:gd name="connsiteY20" fmla="*/ 490466 h 874716"/>
                <a:gd name="connsiteX21" fmla="*/ 5456292 w 6857455"/>
                <a:gd name="connsiteY21" fmla="*/ 450650 h 874716"/>
                <a:gd name="connsiteX22" fmla="*/ 5424670 w 6857455"/>
                <a:gd name="connsiteY22" fmla="*/ 444934 h 874716"/>
                <a:gd name="connsiteX23" fmla="*/ 5368662 w 6857455"/>
                <a:gd name="connsiteY23" fmla="*/ 441124 h 874716"/>
                <a:gd name="connsiteX24" fmla="*/ 5247118 w 6857455"/>
                <a:gd name="connsiteY24" fmla="*/ 444934 h 874716"/>
                <a:gd name="connsiteX25" fmla="*/ 5088617 w 6857455"/>
                <a:gd name="connsiteY25" fmla="*/ 428742 h 874716"/>
                <a:gd name="connsiteX26" fmla="*/ 5025750 w 6857455"/>
                <a:gd name="connsiteY26" fmla="*/ 433694 h 874716"/>
                <a:gd name="connsiteX27" fmla="*/ 4957930 w 6857455"/>
                <a:gd name="connsiteY27" fmla="*/ 442268 h 874716"/>
                <a:gd name="connsiteX28" fmla="*/ 4938116 w 6857455"/>
                <a:gd name="connsiteY28" fmla="*/ 441886 h 874716"/>
                <a:gd name="connsiteX29" fmla="*/ 4833910 w 6857455"/>
                <a:gd name="connsiteY29" fmla="*/ 421693 h 874716"/>
                <a:gd name="connsiteX30" fmla="*/ 4810095 w 6857455"/>
                <a:gd name="connsiteY30" fmla="*/ 408167 h 874716"/>
                <a:gd name="connsiteX31" fmla="*/ 4747991 w 6857455"/>
                <a:gd name="connsiteY31" fmla="*/ 413691 h 874716"/>
                <a:gd name="connsiteX32" fmla="*/ 4692745 w 6857455"/>
                <a:gd name="connsiteY32" fmla="*/ 435790 h 874716"/>
                <a:gd name="connsiteX33" fmla="*/ 4375933 w 6857455"/>
                <a:gd name="connsiteY33" fmla="*/ 483417 h 874716"/>
                <a:gd name="connsiteX34" fmla="*/ 4185426 w 6857455"/>
                <a:gd name="connsiteY34" fmla="*/ 484179 h 874716"/>
                <a:gd name="connsiteX35" fmla="*/ 4052072 w 6857455"/>
                <a:gd name="connsiteY35" fmla="*/ 505134 h 874716"/>
                <a:gd name="connsiteX36" fmla="*/ 4029973 w 6857455"/>
                <a:gd name="connsiteY36" fmla="*/ 527233 h 874716"/>
                <a:gd name="connsiteX37" fmla="*/ 3948626 w 6857455"/>
                <a:gd name="connsiteY37" fmla="*/ 550666 h 874716"/>
                <a:gd name="connsiteX38" fmla="*/ 3871280 w 6857455"/>
                <a:gd name="connsiteY38" fmla="*/ 502275 h 874716"/>
                <a:gd name="connsiteX39" fmla="*/ 3774312 w 6857455"/>
                <a:gd name="connsiteY39" fmla="*/ 429122 h 874716"/>
                <a:gd name="connsiteX40" fmla="*/ 3721543 w 6857455"/>
                <a:gd name="connsiteY40" fmla="*/ 428552 h 874716"/>
                <a:gd name="connsiteX41" fmla="*/ 3612763 w 6857455"/>
                <a:gd name="connsiteY41" fmla="*/ 414263 h 874716"/>
                <a:gd name="connsiteX42" fmla="*/ 3537323 w 6857455"/>
                <a:gd name="connsiteY42" fmla="*/ 389878 h 874716"/>
                <a:gd name="connsiteX43" fmla="*/ 3431593 w 6857455"/>
                <a:gd name="connsiteY43" fmla="*/ 360921 h 874716"/>
                <a:gd name="connsiteX44" fmla="*/ 3392158 w 6857455"/>
                <a:gd name="connsiteY44" fmla="*/ 345681 h 874716"/>
                <a:gd name="connsiteX45" fmla="*/ 3297856 w 6857455"/>
                <a:gd name="connsiteY45" fmla="*/ 323010 h 874716"/>
                <a:gd name="connsiteX46" fmla="*/ 3219748 w 6857455"/>
                <a:gd name="connsiteY46" fmla="*/ 308151 h 874716"/>
                <a:gd name="connsiteX47" fmla="*/ 3156692 w 6857455"/>
                <a:gd name="connsiteY47" fmla="*/ 261668 h 874716"/>
                <a:gd name="connsiteX48" fmla="*/ 3136497 w 6857455"/>
                <a:gd name="connsiteY48" fmla="*/ 237663 h 874716"/>
                <a:gd name="connsiteX49" fmla="*/ 3119733 w 6857455"/>
                <a:gd name="connsiteY49" fmla="*/ 222233 h 874716"/>
                <a:gd name="connsiteX50" fmla="*/ 3045436 w 6857455"/>
                <a:gd name="connsiteY50" fmla="*/ 131742 h 874716"/>
                <a:gd name="connsiteX51" fmla="*/ 3037054 w 6857455"/>
                <a:gd name="connsiteY51" fmla="*/ 124121 h 874716"/>
                <a:gd name="connsiteX52" fmla="*/ 2936466 w 6857455"/>
                <a:gd name="connsiteY52" fmla="*/ 82400 h 874716"/>
                <a:gd name="connsiteX53" fmla="*/ 2901031 w 6857455"/>
                <a:gd name="connsiteY53" fmla="*/ 59731 h 874716"/>
                <a:gd name="connsiteX54" fmla="*/ 2828259 w 6857455"/>
                <a:gd name="connsiteY54" fmla="*/ 3149 h 874716"/>
                <a:gd name="connsiteX55" fmla="*/ 2799492 w 6857455"/>
                <a:gd name="connsiteY55" fmla="*/ 1245 h 874716"/>
                <a:gd name="connsiteX56" fmla="*/ 2693570 w 6857455"/>
                <a:gd name="connsiteY56" fmla="*/ 35154 h 874716"/>
                <a:gd name="connsiteX57" fmla="*/ 2639847 w 6857455"/>
                <a:gd name="connsiteY57" fmla="*/ 73448 h 874716"/>
                <a:gd name="connsiteX58" fmla="*/ 2621178 w 6857455"/>
                <a:gd name="connsiteY58" fmla="*/ 88688 h 874716"/>
                <a:gd name="connsiteX59" fmla="*/ 2489348 w 6857455"/>
                <a:gd name="connsiteY59" fmla="*/ 72304 h 874716"/>
                <a:gd name="connsiteX60" fmla="*/ 2452580 w 6857455"/>
                <a:gd name="connsiteY60" fmla="*/ 68683 h 874716"/>
                <a:gd name="connsiteX61" fmla="*/ 2326464 w 6857455"/>
                <a:gd name="connsiteY61" fmla="*/ 50395 h 874716"/>
                <a:gd name="connsiteX62" fmla="*/ 2300365 w 6857455"/>
                <a:gd name="connsiteY62" fmla="*/ 54777 h 874716"/>
                <a:gd name="connsiteX63" fmla="*/ 2130434 w 6857455"/>
                <a:gd name="connsiteY63" fmla="*/ 58397 h 874716"/>
                <a:gd name="connsiteX64" fmla="*/ 2118621 w 6857455"/>
                <a:gd name="connsiteY64" fmla="*/ 47919 h 874716"/>
                <a:gd name="connsiteX65" fmla="*/ 2057659 w 6857455"/>
                <a:gd name="connsiteY65" fmla="*/ 16866 h 874716"/>
                <a:gd name="connsiteX66" fmla="*/ 1976314 w 6857455"/>
                <a:gd name="connsiteY66" fmla="*/ 8865 h 874716"/>
                <a:gd name="connsiteX67" fmla="*/ 1961454 w 6857455"/>
                <a:gd name="connsiteY67" fmla="*/ 11724 h 874716"/>
                <a:gd name="connsiteX68" fmla="*/ 1906588 w 6857455"/>
                <a:gd name="connsiteY68" fmla="*/ 30964 h 874716"/>
                <a:gd name="connsiteX69" fmla="*/ 1783330 w 6857455"/>
                <a:gd name="connsiteY69" fmla="*/ 48871 h 874716"/>
                <a:gd name="connsiteX70" fmla="*/ 1759327 w 6857455"/>
                <a:gd name="connsiteY70" fmla="*/ 55349 h 874716"/>
                <a:gd name="connsiteX71" fmla="*/ 1716082 w 6857455"/>
                <a:gd name="connsiteY71" fmla="*/ 65445 h 874716"/>
                <a:gd name="connsiteX72" fmla="*/ 1598920 w 6857455"/>
                <a:gd name="connsiteY72" fmla="*/ 72114 h 874716"/>
                <a:gd name="connsiteX73" fmla="*/ 1542150 w 6857455"/>
                <a:gd name="connsiteY73" fmla="*/ 62207 h 874716"/>
                <a:gd name="connsiteX74" fmla="*/ 1516813 w 6857455"/>
                <a:gd name="connsiteY74" fmla="*/ 62779 h 874716"/>
                <a:gd name="connsiteX75" fmla="*/ 1432228 w 6857455"/>
                <a:gd name="connsiteY75" fmla="*/ 88116 h 874716"/>
                <a:gd name="connsiteX76" fmla="*/ 1224765 w 6857455"/>
                <a:gd name="connsiteY76" fmla="*/ 71924 h 874716"/>
                <a:gd name="connsiteX77" fmla="*/ 1159231 w 6857455"/>
                <a:gd name="connsiteY77" fmla="*/ 58207 h 874716"/>
                <a:gd name="connsiteX78" fmla="*/ 1124370 w 6857455"/>
                <a:gd name="connsiteY78" fmla="*/ 56301 h 874716"/>
                <a:gd name="connsiteX79" fmla="*/ 1075600 w 6857455"/>
                <a:gd name="connsiteY79" fmla="*/ 75542 h 874716"/>
                <a:gd name="connsiteX80" fmla="*/ 986633 w 6857455"/>
                <a:gd name="connsiteY80" fmla="*/ 79162 h 874716"/>
                <a:gd name="connsiteX81" fmla="*/ 861089 w 6857455"/>
                <a:gd name="connsiteY81" fmla="*/ 76304 h 874716"/>
                <a:gd name="connsiteX82" fmla="*/ 759168 w 6857455"/>
                <a:gd name="connsiteY82" fmla="*/ 104689 h 874716"/>
                <a:gd name="connsiteX83" fmla="*/ 723735 w 6857455"/>
                <a:gd name="connsiteY83" fmla="*/ 140696 h 874716"/>
                <a:gd name="connsiteX84" fmla="*/ 647532 w 6857455"/>
                <a:gd name="connsiteY84" fmla="*/ 147934 h 874716"/>
                <a:gd name="connsiteX85" fmla="*/ 552659 w 6857455"/>
                <a:gd name="connsiteY85" fmla="*/ 95926 h 874716"/>
                <a:gd name="connsiteX86" fmla="*/ 541800 w 6857455"/>
                <a:gd name="connsiteY86" fmla="*/ 97640 h 874716"/>
                <a:gd name="connsiteX87" fmla="*/ 375107 w 6857455"/>
                <a:gd name="connsiteY87" fmla="*/ 123169 h 874716"/>
                <a:gd name="connsiteX88" fmla="*/ 273567 w 6857455"/>
                <a:gd name="connsiteY88" fmla="*/ 145458 h 874716"/>
                <a:gd name="connsiteX89" fmla="*/ 264043 w 6857455"/>
                <a:gd name="connsiteY89" fmla="*/ 154792 h 874716"/>
                <a:gd name="connsiteX90" fmla="*/ 169360 w 6857455"/>
                <a:gd name="connsiteY90" fmla="*/ 177273 h 874716"/>
                <a:gd name="connsiteX91" fmla="*/ 89347 w 6857455"/>
                <a:gd name="connsiteY91" fmla="*/ 157460 h 874716"/>
                <a:gd name="connsiteX92" fmla="*/ 34291 w 6857455"/>
                <a:gd name="connsiteY92" fmla="*/ 145268 h 874716"/>
                <a:gd name="connsiteX93" fmla="*/ 0 w 6857455"/>
                <a:gd name="connsiteY93" fmla="*/ 142056 h 874716"/>
                <a:gd name="connsiteX94" fmla="*/ 0 w 6857455"/>
                <a:gd name="connsiteY94" fmla="*/ 849556 h 874716"/>
                <a:gd name="connsiteX95" fmla="*/ 60652 w 6857455"/>
                <a:gd name="connsiteY95" fmla="*/ 844783 h 874716"/>
                <a:gd name="connsiteX96" fmla="*/ 119068 w 6857455"/>
                <a:gd name="connsiteY96" fmla="*/ 827281 h 874716"/>
                <a:gd name="connsiteX97" fmla="*/ 171840 w 6857455"/>
                <a:gd name="connsiteY97" fmla="*/ 804420 h 874716"/>
                <a:gd name="connsiteX98" fmla="*/ 274329 w 6857455"/>
                <a:gd name="connsiteY98" fmla="*/ 794324 h 874716"/>
                <a:gd name="connsiteX99" fmla="*/ 306715 w 6857455"/>
                <a:gd name="connsiteY99" fmla="*/ 788798 h 874716"/>
                <a:gd name="connsiteX100" fmla="*/ 393967 w 6857455"/>
                <a:gd name="connsiteY100" fmla="*/ 765937 h 874716"/>
                <a:gd name="connsiteX101" fmla="*/ 493793 w 6857455"/>
                <a:gd name="connsiteY101" fmla="*/ 725549 h 874716"/>
                <a:gd name="connsiteX102" fmla="*/ 546373 w 6857455"/>
                <a:gd name="connsiteY102" fmla="*/ 740600 h 874716"/>
                <a:gd name="connsiteX103" fmla="*/ 730211 w 6857455"/>
                <a:gd name="connsiteY103" fmla="*/ 698116 h 874716"/>
                <a:gd name="connsiteX104" fmla="*/ 784889 w 6857455"/>
                <a:gd name="connsiteY104" fmla="*/ 676018 h 874716"/>
                <a:gd name="connsiteX105" fmla="*/ 800509 w 6857455"/>
                <a:gd name="connsiteY105" fmla="*/ 661349 h 874716"/>
                <a:gd name="connsiteX106" fmla="*/ 857661 w 6857455"/>
                <a:gd name="connsiteY106" fmla="*/ 626868 h 874716"/>
                <a:gd name="connsiteX107" fmla="*/ 949102 w 6857455"/>
                <a:gd name="connsiteY107" fmla="*/ 614676 h 874716"/>
                <a:gd name="connsiteX108" fmla="*/ 960342 w 6857455"/>
                <a:gd name="connsiteY108" fmla="*/ 607435 h 874716"/>
                <a:gd name="connsiteX109" fmla="*/ 977109 w 6857455"/>
                <a:gd name="connsiteY109" fmla="*/ 595815 h 874716"/>
                <a:gd name="connsiteX110" fmla="*/ 1071218 w 6857455"/>
                <a:gd name="connsiteY110" fmla="*/ 575240 h 874716"/>
                <a:gd name="connsiteX111" fmla="*/ 1091983 w 6857455"/>
                <a:gd name="connsiteY111" fmla="*/ 568764 h 874716"/>
                <a:gd name="connsiteX112" fmla="*/ 1109321 w 6857455"/>
                <a:gd name="connsiteY112" fmla="*/ 557904 h 874716"/>
                <a:gd name="connsiteX113" fmla="*/ 1162279 w 6857455"/>
                <a:gd name="connsiteY113" fmla="*/ 532949 h 874716"/>
                <a:gd name="connsiteX114" fmla="*/ 1206097 w 6857455"/>
                <a:gd name="connsiteY114" fmla="*/ 532187 h 874716"/>
                <a:gd name="connsiteX115" fmla="*/ 1266867 w 6857455"/>
                <a:gd name="connsiteY115" fmla="*/ 518088 h 874716"/>
                <a:gd name="connsiteX116" fmla="*/ 1380219 w 6857455"/>
                <a:gd name="connsiteY116" fmla="*/ 504182 h 874716"/>
                <a:gd name="connsiteX117" fmla="*/ 1403461 w 6857455"/>
                <a:gd name="connsiteY117" fmla="*/ 496180 h 874716"/>
                <a:gd name="connsiteX118" fmla="*/ 1544054 w 6857455"/>
                <a:gd name="connsiteY118" fmla="*/ 458268 h 874716"/>
                <a:gd name="connsiteX119" fmla="*/ 1656644 w 6857455"/>
                <a:gd name="connsiteY119" fmla="*/ 459032 h 874716"/>
                <a:gd name="connsiteX120" fmla="*/ 1665406 w 6857455"/>
                <a:gd name="connsiteY120" fmla="*/ 460747 h 874716"/>
                <a:gd name="connsiteX121" fmla="*/ 1708461 w 6857455"/>
                <a:gd name="connsiteY121" fmla="*/ 473318 h 874716"/>
                <a:gd name="connsiteX122" fmla="*/ 1775140 w 6857455"/>
                <a:gd name="connsiteY122" fmla="*/ 469891 h 874716"/>
                <a:gd name="connsiteX123" fmla="*/ 1821051 w 6857455"/>
                <a:gd name="connsiteY123" fmla="*/ 452554 h 874716"/>
                <a:gd name="connsiteX124" fmla="*/ 1878203 w 6857455"/>
                <a:gd name="connsiteY124" fmla="*/ 451792 h 874716"/>
                <a:gd name="connsiteX125" fmla="*/ 1943547 w 6857455"/>
                <a:gd name="connsiteY125" fmla="*/ 462651 h 874716"/>
                <a:gd name="connsiteX126" fmla="*/ 1972884 w 6857455"/>
                <a:gd name="connsiteY126" fmla="*/ 464937 h 874716"/>
                <a:gd name="connsiteX127" fmla="*/ 2053469 w 6857455"/>
                <a:gd name="connsiteY127" fmla="*/ 487417 h 874716"/>
                <a:gd name="connsiteX128" fmla="*/ 2101477 w 6857455"/>
                <a:gd name="connsiteY128" fmla="*/ 481893 h 874716"/>
                <a:gd name="connsiteX129" fmla="*/ 2148722 w 6857455"/>
                <a:gd name="connsiteY129" fmla="*/ 467033 h 874716"/>
                <a:gd name="connsiteX130" fmla="*/ 2179011 w 6857455"/>
                <a:gd name="connsiteY130" fmla="*/ 452744 h 874716"/>
                <a:gd name="connsiteX131" fmla="*/ 2240165 w 6857455"/>
                <a:gd name="connsiteY131" fmla="*/ 442648 h 874716"/>
                <a:gd name="connsiteX132" fmla="*/ 2251404 w 6857455"/>
                <a:gd name="connsiteY132" fmla="*/ 444172 h 874716"/>
                <a:gd name="connsiteX133" fmla="*/ 2433912 w 6857455"/>
                <a:gd name="connsiteY133" fmla="*/ 456746 h 874716"/>
                <a:gd name="connsiteX134" fmla="*/ 2506302 w 6857455"/>
                <a:gd name="connsiteY134" fmla="*/ 476939 h 874716"/>
                <a:gd name="connsiteX135" fmla="*/ 2521735 w 6857455"/>
                <a:gd name="connsiteY135" fmla="*/ 479415 h 874716"/>
                <a:gd name="connsiteX136" fmla="*/ 2675854 w 6857455"/>
                <a:gd name="connsiteY136" fmla="*/ 502086 h 874716"/>
                <a:gd name="connsiteX137" fmla="*/ 2692998 w 6857455"/>
                <a:gd name="connsiteY137" fmla="*/ 503038 h 874716"/>
                <a:gd name="connsiteX138" fmla="*/ 2740816 w 6857455"/>
                <a:gd name="connsiteY138" fmla="*/ 499037 h 874716"/>
                <a:gd name="connsiteX139" fmla="*/ 2853596 w 6857455"/>
                <a:gd name="connsiteY139" fmla="*/ 540187 h 874716"/>
                <a:gd name="connsiteX140" fmla="*/ 2966565 w 6857455"/>
                <a:gd name="connsiteY140" fmla="*/ 554286 h 874716"/>
                <a:gd name="connsiteX141" fmla="*/ 3028671 w 6857455"/>
                <a:gd name="connsiteY141" fmla="*/ 554094 h 874716"/>
                <a:gd name="connsiteX142" fmla="*/ 3073059 w 6857455"/>
                <a:gd name="connsiteY142" fmla="*/ 564192 h 874716"/>
                <a:gd name="connsiteX143" fmla="*/ 3182219 w 6857455"/>
                <a:gd name="connsiteY143" fmla="*/ 594862 h 874716"/>
                <a:gd name="connsiteX144" fmla="*/ 3233656 w 6857455"/>
                <a:gd name="connsiteY144" fmla="*/ 599625 h 874716"/>
                <a:gd name="connsiteX145" fmla="*/ 3288332 w 6857455"/>
                <a:gd name="connsiteY145" fmla="*/ 609914 h 874716"/>
                <a:gd name="connsiteX146" fmla="*/ 3423591 w 6857455"/>
                <a:gd name="connsiteY146" fmla="*/ 656015 h 874716"/>
                <a:gd name="connsiteX147" fmla="*/ 3534084 w 6857455"/>
                <a:gd name="connsiteY147" fmla="*/ 653349 h 874716"/>
                <a:gd name="connsiteX148" fmla="*/ 3604571 w 6857455"/>
                <a:gd name="connsiteY148" fmla="*/ 653918 h 874716"/>
                <a:gd name="connsiteX149" fmla="*/ 3688586 w 6857455"/>
                <a:gd name="connsiteY149" fmla="*/ 669160 h 874716"/>
                <a:gd name="connsiteX150" fmla="*/ 3757358 w 6857455"/>
                <a:gd name="connsiteY150" fmla="*/ 691450 h 874716"/>
                <a:gd name="connsiteX151" fmla="*/ 3852421 w 6857455"/>
                <a:gd name="connsiteY151" fmla="*/ 709167 h 874716"/>
                <a:gd name="connsiteX152" fmla="*/ 3947104 w 6857455"/>
                <a:gd name="connsiteY152" fmla="*/ 743267 h 874716"/>
                <a:gd name="connsiteX153" fmla="*/ 4013208 w 6857455"/>
                <a:gd name="connsiteY153" fmla="*/ 769367 h 874716"/>
                <a:gd name="connsiteX154" fmla="*/ 4105222 w 6857455"/>
                <a:gd name="connsiteY154" fmla="*/ 792417 h 874716"/>
                <a:gd name="connsiteX155" fmla="*/ 4246006 w 6857455"/>
                <a:gd name="connsiteY155" fmla="*/ 808610 h 874716"/>
                <a:gd name="connsiteX156" fmla="*/ 4310779 w 6857455"/>
                <a:gd name="connsiteY156" fmla="*/ 810326 h 874716"/>
                <a:gd name="connsiteX157" fmla="*/ 4413272 w 6857455"/>
                <a:gd name="connsiteY157" fmla="*/ 848235 h 874716"/>
                <a:gd name="connsiteX158" fmla="*/ 4457087 w 6857455"/>
                <a:gd name="connsiteY158" fmla="*/ 866524 h 874716"/>
                <a:gd name="connsiteX159" fmla="*/ 4496523 w 6857455"/>
                <a:gd name="connsiteY159" fmla="*/ 851284 h 874716"/>
                <a:gd name="connsiteX160" fmla="*/ 4522050 w 6857455"/>
                <a:gd name="connsiteY160" fmla="*/ 833757 h 874716"/>
                <a:gd name="connsiteX161" fmla="*/ 4602824 w 6857455"/>
                <a:gd name="connsiteY161" fmla="*/ 848618 h 874716"/>
                <a:gd name="connsiteX162" fmla="*/ 4688553 w 6857455"/>
                <a:gd name="connsiteY162" fmla="*/ 864238 h 874716"/>
                <a:gd name="connsiteX163" fmla="*/ 4749895 w 6857455"/>
                <a:gd name="connsiteY163" fmla="*/ 874716 h 874716"/>
                <a:gd name="connsiteX164" fmla="*/ 4826480 w 6857455"/>
                <a:gd name="connsiteY164" fmla="*/ 866334 h 874716"/>
                <a:gd name="connsiteX165" fmla="*/ 4886870 w 6857455"/>
                <a:gd name="connsiteY165" fmla="*/ 862906 h 874716"/>
                <a:gd name="connsiteX166" fmla="*/ 4935639 w 6857455"/>
                <a:gd name="connsiteY166" fmla="*/ 853190 h 874716"/>
                <a:gd name="connsiteX167" fmla="*/ 4952784 w 6857455"/>
                <a:gd name="connsiteY167" fmla="*/ 847473 h 874716"/>
                <a:gd name="connsiteX168" fmla="*/ 5088617 w 6857455"/>
                <a:gd name="connsiteY168" fmla="*/ 802896 h 874716"/>
                <a:gd name="connsiteX169" fmla="*/ 5233781 w 6857455"/>
                <a:gd name="connsiteY169" fmla="*/ 767271 h 874716"/>
                <a:gd name="connsiteX170" fmla="*/ 5327893 w 6857455"/>
                <a:gd name="connsiteY170" fmla="*/ 789752 h 874716"/>
                <a:gd name="connsiteX171" fmla="*/ 5362946 w 6857455"/>
                <a:gd name="connsiteY171" fmla="*/ 789370 h 874716"/>
                <a:gd name="connsiteX172" fmla="*/ 5524115 w 6857455"/>
                <a:gd name="connsiteY172" fmla="*/ 794514 h 874716"/>
                <a:gd name="connsiteX173" fmla="*/ 5552500 w 6857455"/>
                <a:gd name="connsiteY173" fmla="*/ 800038 h 874716"/>
                <a:gd name="connsiteX174" fmla="*/ 5705857 w 6857455"/>
                <a:gd name="connsiteY174" fmla="*/ 777367 h 874716"/>
                <a:gd name="connsiteX175" fmla="*/ 5761485 w 6857455"/>
                <a:gd name="connsiteY175" fmla="*/ 773557 h 874716"/>
                <a:gd name="connsiteX176" fmla="*/ 5812731 w 6857455"/>
                <a:gd name="connsiteY176" fmla="*/ 767271 h 874716"/>
                <a:gd name="connsiteX177" fmla="*/ 5884361 w 6857455"/>
                <a:gd name="connsiteY177" fmla="*/ 765747 h 874716"/>
                <a:gd name="connsiteX178" fmla="*/ 5958660 w 6857455"/>
                <a:gd name="connsiteY178" fmla="*/ 768605 h 874716"/>
                <a:gd name="connsiteX179" fmla="*/ 6041528 w 6857455"/>
                <a:gd name="connsiteY179" fmla="*/ 768033 h 874716"/>
                <a:gd name="connsiteX180" fmla="*/ 6074297 w 6857455"/>
                <a:gd name="connsiteY180" fmla="*/ 763081 h 874716"/>
                <a:gd name="connsiteX181" fmla="*/ 6162880 w 6857455"/>
                <a:gd name="connsiteY181" fmla="*/ 766509 h 874716"/>
                <a:gd name="connsiteX182" fmla="*/ 6209364 w 6857455"/>
                <a:gd name="connsiteY182" fmla="*/ 760795 h 874716"/>
                <a:gd name="connsiteX183" fmla="*/ 6285948 w 6857455"/>
                <a:gd name="connsiteY183" fmla="*/ 759651 h 874716"/>
                <a:gd name="connsiteX184" fmla="*/ 6310905 w 6857455"/>
                <a:gd name="connsiteY184" fmla="*/ 758316 h 874716"/>
                <a:gd name="connsiteX185" fmla="*/ 6333194 w 6857455"/>
                <a:gd name="connsiteY185" fmla="*/ 757554 h 874716"/>
                <a:gd name="connsiteX186" fmla="*/ 6409586 w 6857455"/>
                <a:gd name="connsiteY186" fmla="*/ 773177 h 874716"/>
                <a:gd name="connsiteX187" fmla="*/ 6477407 w 6857455"/>
                <a:gd name="connsiteY187" fmla="*/ 774129 h 874716"/>
                <a:gd name="connsiteX188" fmla="*/ 6596283 w 6857455"/>
                <a:gd name="connsiteY188" fmla="*/ 786703 h 874716"/>
                <a:gd name="connsiteX189" fmla="*/ 6622573 w 6857455"/>
                <a:gd name="connsiteY189" fmla="*/ 782321 h 874716"/>
                <a:gd name="connsiteX190" fmla="*/ 6704872 w 6857455"/>
                <a:gd name="connsiteY190" fmla="*/ 780607 h 874716"/>
                <a:gd name="connsiteX191" fmla="*/ 6751738 w 6857455"/>
                <a:gd name="connsiteY191" fmla="*/ 779273 h 874716"/>
                <a:gd name="connsiteX192" fmla="*/ 6809650 w 6857455"/>
                <a:gd name="connsiteY192" fmla="*/ 788417 h 874716"/>
                <a:gd name="connsiteX193" fmla="*/ 6832976 w 6857455"/>
                <a:gd name="connsiteY193" fmla="*/ 800428 h 874716"/>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 ang="0">
                  <a:pos x="connsiteX47" y="connsiteY47"/>
                </a:cxn>
                <a:cxn ang="0">
                  <a:pos x="connsiteX48" y="connsiteY48"/>
                </a:cxn>
                <a:cxn ang="0">
                  <a:pos x="connsiteX49" y="connsiteY49"/>
                </a:cxn>
                <a:cxn ang="0">
                  <a:pos x="connsiteX50" y="connsiteY50"/>
                </a:cxn>
                <a:cxn ang="0">
                  <a:pos x="connsiteX51" y="connsiteY51"/>
                </a:cxn>
                <a:cxn ang="0">
                  <a:pos x="connsiteX52" y="connsiteY52"/>
                </a:cxn>
                <a:cxn ang="0">
                  <a:pos x="connsiteX53" y="connsiteY53"/>
                </a:cxn>
                <a:cxn ang="0">
                  <a:pos x="connsiteX54" y="connsiteY54"/>
                </a:cxn>
                <a:cxn ang="0">
                  <a:pos x="connsiteX55" y="connsiteY55"/>
                </a:cxn>
                <a:cxn ang="0">
                  <a:pos x="connsiteX56" y="connsiteY56"/>
                </a:cxn>
                <a:cxn ang="0">
                  <a:pos x="connsiteX57" y="connsiteY57"/>
                </a:cxn>
                <a:cxn ang="0">
                  <a:pos x="connsiteX58" y="connsiteY58"/>
                </a:cxn>
                <a:cxn ang="0">
                  <a:pos x="connsiteX59" y="connsiteY59"/>
                </a:cxn>
                <a:cxn ang="0">
                  <a:pos x="connsiteX60" y="connsiteY60"/>
                </a:cxn>
                <a:cxn ang="0">
                  <a:pos x="connsiteX61" y="connsiteY61"/>
                </a:cxn>
                <a:cxn ang="0">
                  <a:pos x="connsiteX62" y="connsiteY62"/>
                </a:cxn>
                <a:cxn ang="0">
                  <a:pos x="connsiteX63" y="connsiteY63"/>
                </a:cxn>
                <a:cxn ang="0">
                  <a:pos x="connsiteX64" y="connsiteY64"/>
                </a:cxn>
                <a:cxn ang="0">
                  <a:pos x="connsiteX65" y="connsiteY65"/>
                </a:cxn>
                <a:cxn ang="0">
                  <a:pos x="connsiteX66" y="connsiteY66"/>
                </a:cxn>
                <a:cxn ang="0">
                  <a:pos x="connsiteX67" y="connsiteY67"/>
                </a:cxn>
                <a:cxn ang="0">
                  <a:pos x="connsiteX68" y="connsiteY68"/>
                </a:cxn>
                <a:cxn ang="0">
                  <a:pos x="connsiteX69" y="connsiteY69"/>
                </a:cxn>
                <a:cxn ang="0">
                  <a:pos x="connsiteX70" y="connsiteY70"/>
                </a:cxn>
                <a:cxn ang="0">
                  <a:pos x="connsiteX71" y="connsiteY71"/>
                </a:cxn>
                <a:cxn ang="0">
                  <a:pos x="connsiteX72" y="connsiteY72"/>
                </a:cxn>
                <a:cxn ang="0">
                  <a:pos x="connsiteX73" y="connsiteY73"/>
                </a:cxn>
                <a:cxn ang="0">
                  <a:pos x="connsiteX74" y="connsiteY74"/>
                </a:cxn>
                <a:cxn ang="0">
                  <a:pos x="connsiteX75" y="connsiteY75"/>
                </a:cxn>
                <a:cxn ang="0">
                  <a:pos x="connsiteX76" y="connsiteY76"/>
                </a:cxn>
                <a:cxn ang="0">
                  <a:pos x="connsiteX77" y="connsiteY77"/>
                </a:cxn>
                <a:cxn ang="0">
                  <a:pos x="connsiteX78" y="connsiteY78"/>
                </a:cxn>
                <a:cxn ang="0">
                  <a:pos x="connsiteX79" y="connsiteY79"/>
                </a:cxn>
                <a:cxn ang="0">
                  <a:pos x="connsiteX80" y="connsiteY80"/>
                </a:cxn>
                <a:cxn ang="0">
                  <a:pos x="connsiteX81" y="connsiteY81"/>
                </a:cxn>
                <a:cxn ang="0">
                  <a:pos x="connsiteX82" y="connsiteY82"/>
                </a:cxn>
                <a:cxn ang="0">
                  <a:pos x="connsiteX83" y="connsiteY83"/>
                </a:cxn>
                <a:cxn ang="0">
                  <a:pos x="connsiteX84" y="connsiteY84"/>
                </a:cxn>
                <a:cxn ang="0">
                  <a:pos x="connsiteX85" y="connsiteY85"/>
                </a:cxn>
                <a:cxn ang="0">
                  <a:pos x="connsiteX86" y="connsiteY86"/>
                </a:cxn>
                <a:cxn ang="0">
                  <a:pos x="connsiteX87" y="connsiteY87"/>
                </a:cxn>
                <a:cxn ang="0">
                  <a:pos x="connsiteX88" y="connsiteY88"/>
                </a:cxn>
                <a:cxn ang="0">
                  <a:pos x="connsiteX89" y="connsiteY89"/>
                </a:cxn>
                <a:cxn ang="0">
                  <a:pos x="connsiteX90" y="connsiteY90"/>
                </a:cxn>
                <a:cxn ang="0">
                  <a:pos x="connsiteX91" y="connsiteY91"/>
                </a:cxn>
                <a:cxn ang="0">
                  <a:pos x="connsiteX92" y="connsiteY92"/>
                </a:cxn>
                <a:cxn ang="0">
                  <a:pos x="connsiteX93" y="connsiteY93"/>
                </a:cxn>
                <a:cxn ang="0">
                  <a:pos x="connsiteX94" y="connsiteY94"/>
                </a:cxn>
                <a:cxn ang="0">
                  <a:pos x="connsiteX95" y="connsiteY95"/>
                </a:cxn>
                <a:cxn ang="0">
                  <a:pos x="connsiteX96" y="connsiteY96"/>
                </a:cxn>
                <a:cxn ang="0">
                  <a:pos x="connsiteX97" y="connsiteY97"/>
                </a:cxn>
                <a:cxn ang="0">
                  <a:pos x="connsiteX98" y="connsiteY98"/>
                </a:cxn>
                <a:cxn ang="0">
                  <a:pos x="connsiteX99" y="connsiteY99"/>
                </a:cxn>
                <a:cxn ang="0">
                  <a:pos x="connsiteX100" y="connsiteY100"/>
                </a:cxn>
                <a:cxn ang="0">
                  <a:pos x="connsiteX101" y="connsiteY101"/>
                </a:cxn>
                <a:cxn ang="0">
                  <a:pos x="connsiteX102" y="connsiteY102"/>
                </a:cxn>
                <a:cxn ang="0">
                  <a:pos x="connsiteX103" y="connsiteY103"/>
                </a:cxn>
                <a:cxn ang="0">
                  <a:pos x="connsiteX104" y="connsiteY104"/>
                </a:cxn>
                <a:cxn ang="0">
                  <a:pos x="connsiteX105" y="connsiteY105"/>
                </a:cxn>
                <a:cxn ang="0">
                  <a:pos x="connsiteX106" y="connsiteY106"/>
                </a:cxn>
                <a:cxn ang="0">
                  <a:pos x="connsiteX107" y="connsiteY107"/>
                </a:cxn>
                <a:cxn ang="0">
                  <a:pos x="connsiteX108" y="connsiteY108"/>
                </a:cxn>
                <a:cxn ang="0">
                  <a:pos x="connsiteX109" y="connsiteY109"/>
                </a:cxn>
                <a:cxn ang="0">
                  <a:pos x="connsiteX110" y="connsiteY110"/>
                </a:cxn>
                <a:cxn ang="0">
                  <a:pos x="connsiteX111" y="connsiteY111"/>
                </a:cxn>
                <a:cxn ang="0">
                  <a:pos x="connsiteX112" y="connsiteY112"/>
                </a:cxn>
                <a:cxn ang="0">
                  <a:pos x="connsiteX113" y="connsiteY113"/>
                </a:cxn>
                <a:cxn ang="0">
                  <a:pos x="connsiteX114" y="connsiteY114"/>
                </a:cxn>
                <a:cxn ang="0">
                  <a:pos x="connsiteX115" y="connsiteY115"/>
                </a:cxn>
                <a:cxn ang="0">
                  <a:pos x="connsiteX116" y="connsiteY116"/>
                </a:cxn>
                <a:cxn ang="0">
                  <a:pos x="connsiteX117" y="connsiteY117"/>
                </a:cxn>
                <a:cxn ang="0">
                  <a:pos x="connsiteX118" y="connsiteY118"/>
                </a:cxn>
                <a:cxn ang="0">
                  <a:pos x="connsiteX119" y="connsiteY119"/>
                </a:cxn>
                <a:cxn ang="0">
                  <a:pos x="connsiteX120" y="connsiteY120"/>
                </a:cxn>
                <a:cxn ang="0">
                  <a:pos x="connsiteX121" y="connsiteY121"/>
                </a:cxn>
                <a:cxn ang="0">
                  <a:pos x="connsiteX122" y="connsiteY122"/>
                </a:cxn>
                <a:cxn ang="0">
                  <a:pos x="connsiteX123" y="connsiteY123"/>
                </a:cxn>
                <a:cxn ang="0">
                  <a:pos x="connsiteX124" y="connsiteY124"/>
                </a:cxn>
                <a:cxn ang="0">
                  <a:pos x="connsiteX125" y="connsiteY125"/>
                </a:cxn>
                <a:cxn ang="0">
                  <a:pos x="connsiteX126" y="connsiteY126"/>
                </a:cxn>
                <a:cxn ang="0">
                  <a:pos x="connsiteX127" y="connsiteY127"/>
                </a:cxn>
                <a:cxn ang="0">
                  <a:pos x="connsiteX128" y="connsiteY128"/>
                </a:cxn>
                <a:cxn ang="0">
                  <a:pos x="connsiteX129" y="connsiteY129"/>
                </a:cxn>
                <a:cxn ang="0">
                  <a:pos x="connsiteX130" y="connsiteY130"/>
                </a:cxn>
                <a:cxn ang="0">
                  <a:pos x="connsiteX131" y="connsiteY131"/>
                </a:cxn>
                <a:cxn ang="0">
                  <a:pos x="connsiteX132" y="connsiteY132"/>
                </a:cxn>
                <a:cxn ang="0">
                  <a:pos x="connsiteX133" y="connsiteY133"/>
                </a:cxn>
                <a:cxn ang="0">
                  <a:pos x="connsiteX134" y="connsiteY134"/>
                </a:cxn>
                <a:cxn ang="0">
                  <a:pos x="connsiteX135" y="connsiteY135"/>
                </a:cxn>
                <a:cxn ang="0">
                  <a:pos x="connsiteX136" y="connsiteY136"/>
                </a:cxn>
                <a:cxn ang="0">
                  <a:pos x="connsiteX137" y="connsiteY137"/>
                </a:cxn>
                <a:cxn ang="0">
                  <a:pos x="connsiteX138" y="connsiteY138"/>
                </a:cxn>
                <a:cxn ang="0">
                  <a:pos x="connsiteX139" y="connsiteY139"/>
                </a:cxn>
                <a:cxn ang="0">
                  <a:pos x="connsiteX140" y="connsiteY140"/>
                </a:cxn>
                <a:cxn ang="0">
                  <a:pos x="connsiteX141" y="connsiteY141"/>
                </a:cxn>
                <a:cxn ang="0">
                  <a:pos x="connsiteX142" y="connsiteY142"/>
                </a:cxn>
                <a:cxn ang="0">
                  <a:pos x="connsiteX143" y="connsiteY143"/>
                </a:cxn>
                <a:cxn ang="0">
                  <a:pos x="connsiteX144" y="connsiteY144"/>
                </a:cxn>
                <a:cxn ang="0">
                  <a:pos x="connsiteX145" y="connsiteY145"/>
                </a:cxn>
                <a:cxn ang="0">
                  <a:pos x="connsiteX146" y="connsiteY146"/>
                </a:cxn>
                <a:cxn ang="0">
                  <a:pos x="connsiteX147" y="connsiteY147"/>
                </a:cxn>
                <a:cxn ang="0">
                  <a:pos x="connsiteX148" y="connsiteY148"/>
                </a:cxn>
                <a:cxn ang="0">
                  <a:pos x="connsiteX149" y="connsiteY149"/>
                </a:cxn>
                <a:cxn ang="0">
                  <a:pos x="connsiteX150" y="connsiteY150"/>
                </a:cxn>
                <a:cxn ang="0">
                  <a:pos x="connsiteX151" y="connsiteY151"/>
                </a:cxn>
                <a:cxn ang="0">
                  <a:pos x="connsiteX152" y="connsiteY152"/>
                </a:cxn>
                <a:cxn ang="0">
                  <a:pos x="connsiteX153" y="connsiteY153"/>
                </a:cxn>
                <a:cxn ang="0">
                  <a:pos x="connsiteX154" y="connsiteY154"/>
                </a:cxn>
                <a:cxn ang="0">
                  <a:pos x="connsiteX155" y="connsiteY155"/>
                </a:cxn>
                <a:cxn ang="0">
                  <a:pos x="connsiteX156" y="connsiteY156"/>
                </a:cxn>
                <a:cxn ang="0">
                  <a:pos x="connsiteX157" y="connsiteY157"/>
                </a:cxn>
                <a:cxn ang="0">
                  <a:pos x="connsiteX158" y="connsiteY158"/>
                </a:cxn>
                <a:cxn ang="0">
                  <a:pos x="connsiteX159" y="connsiteY159"/>
                </a:cxn>
                <a:cxn ang="0">
                  <a:pos x="connsiteX160" y="connsiteY160"/>
                </a:cxn>
                <a:cxn ang="0">
                  <a:pos x="connsiteX161" y="connsiteY161"/>
                </a:cxn>
                <a:cxn ang="0">
                  <a:pos x="connsiteX162" y="connsiteY162"/>
                </a:cxn>
                <a:cxn ang="0">
                  <a:pos x="connsiteX163" y="connsiteY163"/>
                </a:cxn>
                <a:cxn ang="0">
                  <a:pos x="connsiteX164" y="connsiteY164"/>
                </a:cxn>
                <a:cxn ang="0">
                  <a:pos x="connsiteX165" y="connsiteY165"/>
                </a:cxn>
                <a:cxn ang="0">
                  <a:pos x="connsiteX166" y="connsiteY166"/>
                </a:cxn>
                <a:cxn ang="0">
                  <a:pos x="connsiteX167" y="connsiteY167"/>
                </a:cxn>
                <a:cxn ang="0">
                  <a:pos x="connsiteX168" y="connsiteY168"/>
                </a:cxn>
                <a:cxn ang="0">
                  <a:pos x="connsiteX169" y="connsiteY169"/>
                </a:cxn>
                <a:cxn ang="0">
                  <a:pos x="connsiteX170" y="connsiteY170"/>
                </a:cxn>
                <a:cxn ang="0">
                  <a:pos x="connsiteX171" y="connsiteY171"/>
                </a:cxn>
                <a:cxn ang="0">
                  <a:pos x="connsiteX172" y="connsiteY172"/>
                </a:cxn>
                <a:cxn ang="0">
                  <a:pos x="connsiteX173" y="connsiteY173"/>
                </a:cxn>
                <a:cxn ang="0">
                  <a:pos x="connsiteX174" y="connsiteY174"/>
                </a:cxn>
                <a:cxn ang="0">
                  <a:pos x="connsiteX175" y="connsiteY175"/>
                </a:cxn>
                <a:cxn ang="0">
                  <a:pos x="connsiteX176" y="connsiteY176"/>
                </a:cxn>
                <a:cxn ang="0">
                  <a:pos x="connsiteX177" y="connsiteY177"/>
                </a:cxn>
                <a:cxn ang="0">
                  <a:pos x="connsiteX178" y="connsiteY178"/>
                </a:cxn>
                <a:cxn ang="0">
                  <a:pos x="connsiteX179" y="connsiteY179"/>
                </a:cxn>
                <a:cxn ang="0">
                  <a:pos x="connsiteX180" y="connsiteY180"/>
                </a:cxn>
                <a:cxn ang="0">
                  <a:pos x="connsiteX181" y="connsiteY181"/>
                </a:cxn>
                <a:cxn ang="0">
                  <a:pos x="connsiteX182" y="connsiteY182"/>
                </a:cxn>
                <a:cxn ang="0">
                  <a:pos x="connsiteX183" y="connsiteY183"/>
                </a:cxn>
                <a:cxn ang="0">
                  <a:pos x="connsiteX184" y="connsiteY184"/>
                </a:cxn>
                <a:cxn ang="0">
                  <a:pos x="connsiteX185" y="connsiteY185"/>
                </a:cxn>
                <a:cxn ang="0">
                  <a:pos x="connsiteX186" y="connsiteY186"/>
                </a:cxn>
                <a:cxn ang="0">
                  <a:pos x="connsiteX187" y="connsiteY187"/>
                </a:cxn>
                <a:cxn ang="0">
                  <a:pos x="connsiteX188" y="connsiteY188"/>
                </a:cxn>
                <a:cxn ang="0">
                  <a:pos x="connsiteX189" y="connsiteY189"/>
                </a:cxn>
                <a:cxn ang="0">
                  <a:pos x="connsiteX190" y="connsiteY190"/>
                </a:cxn>
                <a:cxn ang="0">
                  <a:pos x="connsiteX191" y="connsiteY191"/>
                </a:cxn>
                <a:cxn ang="0">
                  <a:pos x="connsiteX192" y="connsiteY192"/>
                </a:cxn>
                <a:cxn ang="0">
                  <a:pos x="connsiteX193" y="connsiteY193"/>
                </a:cxn>
              </a:cxnLst>
              <a:rect l="l" t="t" r="r" b="b"/>
              <a:pathLst>
                <a:path w="6857455" h="874716">
                  <a:moveTo>
                    <a:pt x="6857455" y="804643"/>
                  </a:moveTo>
                  <a:lnTo>
                    <a:pt x="6857455" y="562246"/>
                  </a:lnTo>
                  <a:lnTo>
                    <a:pt x="6829178" y="551284"/>
                  </a:lnTo>
                  <a:cubicBezTo>
                    <a:pt x="6805745" y="539044"/>
                    <a:pt x="6784885" y="521708"/>
                    <a:pt x="6766024" y="500372"/>
                  </a:cubicBezTo>
                  <a:cubicBezTo>
                    <a:pt x="6755166" y="488179"/>
                    <a:pt x="6746784" y="486845"/>
                    <a:pt x="6734971" y="500944"/>
                  </a:cubicBezTo>
                  <a:cubicBezTo>
                    <a:pt x="6721257" y="517326"/>
                    <a:pt x="6701634" y="510850"/>
                    <a:pt x="6683915" y="507040"/>
                  </a:cubicBezTo>
                  <a:cubicBezTo>
                    <a:pt x="6665629" y="503230"/>
                    <a:pt x="6647148" y="499228"/>
                    <a:pt x="6628860" y="495418"/>
                  </a:cubicBezTo>
                  <a:cubicBezTo>
                    <a:pt x="6615335" y="492752"/>
                    <a:pt x="6601999" y="490466"/>
                    <a:pt x="6588662" y="487227"/>
                  </a:cubicBezTo>
                  <a:cubicBezTo>
                    <a:pt x="6547133" y="477129"/>
                    <a:pt x="6509794" y="480177"/>
                    <a:pt x="6476074" y="511230"/>
                  </a:cubicBezTo>
                  <a:cubicBezTo>
                    <a:pt x="6450356" y="535043"/>
                    <a:pt x="6417399" y="542093"/>
                    <a:pt x="6382345" y="534853"/>
                  </a:cubicBezTo>
                  <a:cubicBezTo>
                    <a:pt x="6377963" y="533901"/>
                    <a:pt x="6372439" y="530091"/>
                    <a:pt x="6369391" y="531615"/>
                  </a:cubicBezTo>
                  <a:cubicBezTo>
                    <a:pt x="6323479" y="553904"/>
                    <a:pt x="6287092" y="514658"/>
                    <a:pt x="6244799" y="512182"/>
                  </a:cubicBezTo>
                  <a:cubicBezTo>
                    <a:pt x="6226130" y="511040"/>
                    <a:pt x="6207079" y="496942"/>
                    <a:pt x="6190315" y="485703"/>
                  </a:cubicBezTo>
                  <a:cubicBezTo>
                    <a:pt x="6167262" y="470271"/>
                    <a:pt x="6146687" y="455412"/>
                    <a:pt x="6115446" y="462270"/>
                  </a:cubicBezTo>
                  <a:cubicBezTo>
                    <a:pt x="6084203" y="469319"/>
                    <a:pt x="6055627" y="456364"/>
                    <a:pt x="6032194" y="434266"/>
                  </a:cubicBezTo>
                  <a:cubicBezTo>
                    <a:pt x="6014287" y="417501"/>
                    <a:pt x="5994665" y="415977"/>
                    <a:pt x="5971042" y="420738"/>
                  </a:cubicBezTo>
                  <a:cubicBezTo>
                    <a:pt x="5941513" y="426645"/>
                    <a:pt x="5910842" y="427027"/>
                    <a:pt x="5880933" y="430646"/>
                  </a:cubicBezTo>
                  <a:cubicBezTo>
                    <a:pt x="5874454" y="431408"/>
                    <a:pt x="5866265" y="434076"/>
                    <a:pt x="5862452" y="438648"/>
                  </a:cubicBezTo>
                  <a:cubicBezTo>
                    <a:pt x="5815779" y="495418"/>
                    <a:pt x="5750055" y="495990"/>
                    <a:pt x="5685283" y="498658"/>
                  </a:cubicBezTo>
                  <a:cubicBezTo>
                    <a:pt x="5646039" y="500372"/>
                    <a:pt x="5606604" y="500372"/>
                    <a:pt x="5567169" y="499420"/>
                  </a:cubicBezTo>
                  <a:cubicBezTo>
                    <a:pt x="5553832" y="499228"/>
                    <a:pt x="5539736" y="496180"/>
                    <a:pt x="5527923" y="490466"/>
                  </a:cubicBezTo>
                  <a:cubicBezTo>
                    <a:pt x="5503348" y="478463"/>
                    <a:pt x="5480680" y="462843"/>
                    <a:pt x="5456292" y="450650"/>
                  </a:cubicBezTo>
                  <a:cubicBezTo>
                    <a:pt x="5447151" y="445886"/>
                    <a:pt x="5435338" y="445696"/>
                    <a:pt x="5424670" y="444934"/>
                  </a:cubicBezTo>
                  <a:cubicBezTo>
                    <a:pt x="5405809" y="443410"/>
                    <a:pt x="5384854" y="447982"/>
                    <a:pt x="5368662" y="441124"/>
                  </a:cubicBezTo>
                  <a:cubicBezTo>
                    <a:pt x="5326559" y="423407"/>
                    <a:pt x="5287123" y="427407"/>
                    <a:pt x="5247118" y="444934"/>
                  </a:cubicBezTo>
                  <a:cubicBezTo>
                    <a:pt x="5191108" y="469509"/>
                    <a:pt x="5138148" y="467605"/>
                    <a:pt x="5088617" y="428742"/>
                  </a:cubicBezTo>
                  <a:cubicBezTo>
                    <a:pt x="5066328" y="411215"/>
                    <a:pt x="5044609" y="419596"/>
                    <a:pt x="5025750" y="433694"/>
                  </a:cubicBezTo>
                  <a:cubicBezTo>
                    <a:pt x="5004032" y="450078"/>
                    <a:pt x="4982885" y="454268"/>
                    <a:pt x="4957930" y="442268"/>
                  </a:cubicBezTo>
                  <a:cubicBezTo>
                    <a:pt x="4952404" y="439600"/>
                    <a:pt x="4944594" y="440933"/>
                    <a:pt x="4938116" y="441886"/>
                  </a:cubicBezTo>
                  <a:cubicBezTo>
                    <a:pt x="4901158" y="446648"/>
                    <a:pt x="4864009" y="454650"/>
                    <a:pt x="4833910" y="421693"/>
                  </a:cubicBezTo>
                  <a:cubicBezTo>
                    <a:pt x="4828004" y="415214"/>
                    <a:pt x="4818097" y="412549"/>
                    <a:pt x="4810095" y="408167"/>
                  </a:cubicBezTo>
                  <a:cubicBezTo>
                    <a:pt x="4776566" y="390258"/>
                    <a:pt x="4777900" y="391974"/>
                    <a:pt x="4747991" y="413691"/>
                  </a:cubicBezTo>
                  <a:cubicBezTo>
                    <a:pt x="4732369" y="425121"/>
                    <a:pt x="4710842" y="436742"/>
                    <a:pt x="4692745" y="435790"/>
                  </a:cubicBezTo>
                  <a:cubicBezTo>
                    <a:pt x="4583584" y="430075"/>
                    <a:pt x="4479758" y="457508"/>
                    <a:pt x="4375933" y="483417"/>
                  </a:cubicBezTo>
                  <a:cubicBezTo>
                    <a:pt x="4311923" y="499420"/>
                    <a:pt x="4249436" y="500372"/>
                    <a:pt x="4185426" y="484179"/>
                  </a:cubicBezTo>
                  <a:cubicBezTo>
                    <a:pt x="4139133" y="472367"/>
                    <a:pt x="4095315" y="491800"/>
                    <a:pt x="4052072" y="505134"/>
                  </a:cubicBezTo>
                  <a:cubicBezTo>
                    <a:pt x="4043117" y="507799"/>
                    <a:pt x="4034735" y="518278"/>
                    <a:pt x="4029973" y="527233"/>
                  </a:cubicBezTo>
                  <a:cubicBezTo>
                    <a:pt x="4012826" y="558858"/>
                    <a:pt x="3984441" y="563810"/>
                    <a:pt x="3948626" y="550666"/>
                  </a:cubicBezTo>
                  <a:cubicBezTo>
                    <a:pt x="3920241" y="540377"/>
                    <a:pt x="3894332" y="526661"/>
                    <a:pt x="3871280" y="502275"/>
                  </a:cubicBezTo>
                  <a:cubicBezTo>
                    <a:pt x="3844229" y="473701"/>
                    <a:pt x="3816224" y="441124"/>
                    <a:pt x="3774312" y="429122"/>
                  </a:cubicBezTo>
                  <a:cubicBezTo>
                    <a:pt x="3756214" y="423979"/>
                    <a:pt x="3740593" y="423217"/>
                    <a:pt x="3721543" y="428552"/>
                  </a:cubicBezTo>
                  <a:cubicBezTo>
                    <a:pt x="3684583" y="438837"/>
                    <a:pt x="3647436" y="446078"/>
                    <a:pt x="3612763" y="414263"/>
                  </a:cubicBezTo>
                  <a:cubicBezTo>
                    <a:pt x="3593712" y="396736"/>
                    <a:pt x="3567994" y="385496"/>
                    <a:pt x="3537323" y="389878"/>
                  </a:cubicBezTo>
                  <a:cubicBezTo>
                    <a:pt x="3499031" y="395402"/>
                    <a:pt x="3464168" y="381496"/>
                    <a:pt x="3431593" y="360921"/>
                  </a:cubicBezTo>
                  <a:cubicBezTo>
                    <a:pt x="3419971" y="353491"/>
                    <a:pt x="3405682" y="349301"/>
                    <a:pt x="3392158" y="345681"/>
                  </a:cubicBezTo>
                  <a:cubicBezTo>
                    <a:pt x="3360915" y="337298"/>
                    <a:pt x="3329480" y="329868"/>
                    <a:pt x="3297856" y="323010"/>
                  </a:cubicBezTo>
                  <a:cubicBezTo>
                    <a:pt x="3271948" y="317296"/>
                    <a:pt x="3245849" y="313104"/>
                    <a:pt x="3219748" y="308151"/>
                  </a:cubicBezTo>
                  <a:cubicBezTo>
                    <a:pt x="3191173" y="302817"/>
                    <a:pt x="3168502" y="290433"/>
                    <a:pt x="3156692" y="261668"/>
                  </a:cubicBezTo>
                  <a:cubicBezTo>
                    <a:pt x="3152882" y="252524"/>
                    <a:pt x="3143737" y="245283"/>
                    <a:pt x="3136497" y="237663"/>
                  </a:cubicBezTo>
                  <a:cubicBezTo>
                    <a:pt x="3131355" y="232139"/>
                    <a:pt x="3124495" y="227947"/>
                    <a:pt x="3119733" y="222233"/>
                  </a:cubicBezTo>
                  <a:cubicBezTo>
                    <a:pt x="3094776" y="192132"/>
                    <a:pt x="3070201" y="161843"/>
                    <a:pt x="3045436" y="131742"/>
                  </a:cubicBezTo>
                  <a:cubicBezTo>
                    <a:pt x="3042958" y="128884"/>
                    <a:pt x="3040292" y="125455"/>
                    <a:pt x="3037054" y="124121"/>
                  </a:cubicBezTo>
                  <a:cubicBezTo>
                    <a:pt x="3003525" y="110215"/>
                    <a:pt x="2969614" y="97070"/>
                    <a:pt x="2936466" y="82400"/>
                  </a:cubicBezTo>
                  <a:cubicBezTo>
                    <a:pt x="2923702" y="76686"/>
                    <a:pt x="2910558" y="69637"/>
                    <a:pt x="2901031" y="59731"/>
                  </a:cubicBezTo>
                  <a:cubicBezTo>
                    <a:pt x="2879314" y="37250"/>
                    <a:pt x="2859502" y="12866"/>
                    <a:pt x="2828259" y="3149"/>
                  </a:cubicBezTo>
                  <a:cubicBezTo>
                    <a:pt x="2819114" y="293"/>
                    <a:pt x="2808256" y="-1231"/>
                    <a:pt x="2799492" y="1245"/>
                  </a:cubicBezTo>
                  <a:cubicBezTo>
                    <a:pt x="2763867" y="11532"/>
                    <a:pt x="2729005" y="24296"/>
                    <a:pt x="2693570" y="35154"/>
                  </a:cubicBezTo>
                  <a:cubicBezTo>
                    <a:pt x="2671092" y="41823"/>
                    <a:pt x="2650707" y="49825"/>
                    <a:pt x="2639847" y="73448"/>
                  </a:cubicBezTo>
                  <a:cubicBezTo>
                    <a:pt x="2636801" y="80114"/>
                    <a:pt x="2628226" y="87354"/>
                    <a:pt x="2621178" y="88688"/>
                  </a:cubicBezTo>
                  <a:cubicBezTo>
                    <a:pt x="2575839" y="97260"/>
                    <a:pt x="2531069" y="101451"/>
                    <a:pt x="2489348" y="72304"/>
                  </a:cubicBezTo>
                  <a:cubicBezTo>
                    <a:pt x="2480585" y="66017"/>
                    <a:pt x="2464201" y="66017"/>
                    <a:pt x="2452580" y="68683"/>
                  </a:cubicBezTo>
                  <a:cubicBezTo>
                    <a:pt x="2407811" y="78590"/>
                    <a:pt x="2365328" y="82020"/>
                    <a:pt x="2326464" y="50395"/>
                  </a:cubicBezTo>
                  <a:cubicBezTo>
                    <a:pt x="2321892" y="46585"/>
                    <a:pt x="2307224" y="50015"/>
                    <a:pt x="2300365" y="54777"/>
                  </a:cubicBezTo>
                  <a:cubicBezTo>
                    <a:pt x="2234259" y="101261"/>
                    <a:pt x="2198064" y="102405"/>
                    <a:pt x="2130434" y="58397"/>
                  </a:cubicBezTo>
                  <a:cubicBezTo>
                    <a:pt x="2126052" y="55539"/>
                    <a:pt x="2120337" y="52301"/>
                    <a:pt x="2118621" y="47919"/>
                  </a:cubicBezTo>
                  <a:cubicBezTo>
                    <a:pt x="2107001" y="19914"/>
                    <a:pt x="2082236" y="19152"/>
                    <a:pt x="2057659" y="16866"/>
                  </a:cubicBezTo>
                  <a:cubicBezTo>
                    <a:pt x="2030608" y="14390"/>
                    <a:pt x="2003555" y="11152"/>
                    <a:pt x="1976314" y="8865"/>
                  </a:cubicBezTo>
                  <a:cubicBezTo>
                    <a:pt x="1971550" y="8483"/>
                    <a:pt x="1966216" y="10007"/>
                    <a:pt x="1961454" y="11724"/>
                  </a:cubicBezTo>
                  <a:cubicBezTo>
                    <a:pt x="1943165" y="18010"/>
                    <a:pt x="1925449" y="27154"/>
                    <a:pt x="1906588" y="30964"/>
                  </a:cubicBezTo>
                  <a:cubicBezTo>
                    <a:pt x="1865821" y="39156"/>
                    <a:pt x="1826385" y="55539"/>
                    <a:pt x="1783330" y="48871"/>
                  </a:cubicBezTo>
                  <a:cubicBezTo>
                    <a:pt x="1775902" y="47729"/>
                    <a:pt x="1767327" y="53253"/>
                    <a:pt x="1759327" y="55349"/>
                  </a:cubicBezTo>
                  <a:cubicBezTo>
                    <a:pt x="1744849" y="58969"/>
                    <a:pt x="1730750" y="64111"/>
                    <a:pt x="1716082" y="65445"/>
                  </a:cubicBezTo>
                  <a:cubicBezTo>
                    <a:pt x="1677218" y="68875"/>
                    <a:pt x="1637975" y="71924"/>
                    <a:pt x="1598920" y="72114"/>
                  </a:cubicBezTo>
                  <a:cubicBezTo>
                    <a:pt x="1580061" y="72304"/>
                    <a:pt x="1561201" y="65065"/>
                    <a:pt x="1542150" y="62207"/>
                  </a:cubicBezTo>
                  <a:cubicBezTo>
                    <a:pt x="1533578" y="60873"/>
                    <a:pt x="1519669" y="58587"/>
                    <a:pt x="1516813" y="62779"/>
                  </a:cubicBezTo>
                  <a:cubicBezTo>
                    <a:pt x="1494714" y="94592"/>
                    <a:pt x="1463661" y="88496"/>
                    <a:pt x="1432228" y="88116"/>
                  </a:cubicBezTo>
                  <a:cubicBezTo>
                    <a:pt x="1362884" y="87354"/>
                    <a:pt x="1295826" y="60493"/>
                    <a:pt x="1224765" y="71924"/>
                  </a:cubicBezTo>
                  <a:cubicBezTo>
                    <a:pt x="1204191" y="75162"/>
                    <a:pt x="1181330" y="62397"/>
                    <a:pt x="1159231" y="58207"/>
                  </a:cubicBezTo>
                  <a:cubicBezTo>
                    <a:pt x="1147801" y="56111"/>
                    <a:pt x="1135228" y="53633"/>
                    <a:pt x="1124370" y="56301"/>
                  </a:cubicBezTo>
                  <a:cubicBezTo>
                    <a:pt x="1107605" y="60493"/>
                    <a:pt x="1091411" y="68113"/>
                    <a:pt x="1075600" y="75542"/>
                  </a:cubicBezTo>
                  <a:cubicBezTo>
                    <a:pt x="1046261" y="89258"/>
                    <a:pt x="1016162" y="89258"/>
                    <a:pt x="986633" y="79162"/>
                  </a:cubicBezTo>
                  <a:cubicBezTo>
                    <a:pt x="944722" y="64873"/>
                    <a:pt x="903193" y="64873"/>
                    <a:pt x="861089" y="76304"/>
                  </a:cubicBezTo>
                  <a:cubicBezTo>
                    <a:pt x="826990" y="85638"/>
                    <a:pt x="791935" y="92116"/>
                    <a:pt x="759168" y="104689"/>
                  </a:cubicBezTo>
                  <a:cubicBezTo>
                    <a:pt x="744689" y="110215"/>
                    <a:pt x="732497" y="126597"/>
                    <a:pt x="723735" y="140696"/>
                  </a:cubicBezTo>
                  <a:cubicBezTo>
                    <a:pt x="706018" y="169271"/>
                    <a:pt x="674013" y="169081"/>
                    <a:pt x="647532" y="147934"/>
                  </a:cubicBezTo>
                  <a:cubicBezTo>
                    <a:pt x="619717" y="125645"/>
                    <a:pt x="584664" y="112501"/>
                    <a:pt x="552659" y="95926"/>
                  </a:cubicBezTo>
                  <a:cubicBezTo>
                    <a:pt x="549993" y="94592"/>
                    <a:pt x="545039" y="96116"/>
                    <a:pt x="541800" y="97640"/>
                  </a:cubicBezTo>
                  <a:cubicBezTo>
                    <a:pt x="488649" y="122407"/>
                    <a:pt x="433593" y="126979"/>
                    <a:pt x="375107" y="123169"/>
                  </a:cubicBezTo>
                  <a:cubicBezTo>
                    <a:pt x="341960" y="121073"/>
                    <a:pt x="307289" y="137076"/>
                    <a:pt x="273567" y="145458"/>
                  </a:cubicBezTo>
                  <a:cubicBezTo>
                    <a:pt x="269757" y="146410"/>
                    <a:pt x="266519" y="151174"/>
                    <a:pt x="264043" y="154792"/>
                  </a:cubicBezTo>
                  <a:cubicBezTo>
                    <a:pt x="240228" y="190800"/>
                    <a:pt x="208223" y="200706"/>
                    <a:pt x="169360" y="177273"/>
                  </a:cubicBezTo>
                  <a:cubicBezTo>
                    <a:pt x="143643" y="161651"/>
                    <a:pt x="118114" y="158032"/>
                    <a:pt x="89347" y="157460"/>
                  </a:cubicBezTo>
                  <a:cubicBezTo>
                    <a:pt x="71059" y="157078"/>
                    <a:pt x="52962" y="147934"/>
                    <a:pt x="34291" y="145268"/>
                  </a:cubicBezTo>
                  <a:lnTo>
                    <a:pt x="0" y="142056"/>
                  </a:lnTo>
                  <a:lnTo>
                    <a:pt x="0" y="849556"/>
                  </a:lnTo>
                  <a:lnTo>
                    <a:pt x="60652" y="844783"/>
                  </a:lnTo>
                  <a:cubicBezTo>
                    <a:pt x="80251" y="839473"/>
                    <a:pt x="99446" y="832043"/>
                    <a:pt x="119068" y="827281"/>
                  </a:cubicBezTo>
                  <a:cubicBezTo>
                    <a:pt x="137355" y="822899"/>
                    <a:pt x="154501" y="812802"/>
                    <a:pt x="171840" y="804420"/>
                  </a:cubicBezTo>
                  <a:cubicBezTo>
                    <a:pt x="204985" y="788417"/>
                    <a:pt x="240420" y="798514"/>
                    <a:pt x="274329" y="794324"/>
                  </a:cubicBezTo>
                  <a:cubicBezTo>
                    <a:pt x="285188" y="792990"/>
                    <a:pt x="296046" y="791466"/>
                    <a:pt x="306715" y="788798"/>
                  </a:cubicBezTo>
                  <a:cubicBezTo>
                    <a:pt x="335864" y="781749"/>
                    <a:pt x="365583" y="775653"/>
                    <a:pt x="393967" y="765937"/>
                  </a:cubicBezTo>
                  <a:cubicBezTo>
                    <a:pt x="426165" y="755078"/>
                    <a:pt x="457028" y="740600"/>
                    <a:pt x="493793" y="725549"/>
                  </a:cubicBezTo>
                  <a:cubicBezTo>
                    <a:pt x="506557" y="729360"/>
                    <a:pt x="526180" y="739648"/>
                    <a:pt x="546373" y="740600"/>
                  </a:cubicBezTo>
                  <a:cubicBezTo>
                    <a:pt x="611337" y="743838"/>
                    <a:pt x="672107" y="726121"/>
                    <a:pt x="730211" y="698116"/>
                  </a:cubicBezTo>
                  <a:cubicBezTo>
                    <a:pt x="747927" y="689734"/>
                    <a:pt x="766980" y="684210"/>
                    <a:pt x="784889" y="676018"/>
                  </a:cubicBezTo>
                  <a:cubicBezTo>
                    <a:pt x="791173" y="673161"/>
                    <a:pt x="799365" y="667065"/>
                    <a:pt x="800509" y="661349"/>
                  </a:cubicBezTo>
                  <a:cubicBezTo>
                    <a:pt x="807175" y="628201"/>
                    <a:pt x="831942" y="628772"/>
                    <a:pt x="857661" y="626868"/>
                  </a:cubicBezTo>
                  <a:cubicBezTo>
                    <a:pt x="888332" y="624582"/>
                    <a:pt x="918621" y="619248"/>
                    <a:pt x="949102" y="614676"/>
                  </a:cubicBezTo>
                  <a:cubicBezTo>
                    <a:pt x="953104" y="614104"/>
                    <a:pt x="956722" y="610104"/>
                    <a:pt x="960342" y="607435"/>
                  </a:cubicBezTo>
                  <a:cubicBezTo>
                    <a:pt x="965867" y="603435"/>
                    <a:pt x="971011" y="597339"/>
                    <a:pt x="977109" y="595815"/>
                  </a:cubicBezTo>
                  <a:cubicBezTo>
                    <a:pt x="1008350" y="588385"/>
                    <a:pt x="1039783" y="582099"/>
                    <a:pt x="1071218" y="575240"/>
                  </a:cubicBezTo>
                  <a:cubicBezTo>
                    <a:pt x="1078266" y="573716"/>
                    <a:pt x="1085505" y="571812"/>
                    <a:pt x="1091983" y="568764"/>
                  </a:cubicBezTo>
                  <a:cubicBezTo>
                    <a:pt x="1098079" y="565906"/>
                    <a:pt x="1103223" y="560952"/>
                    <a:pt x="1109321" y="557904"/>
                  </a:cubicBezTo>
                  <a:cubicBezTo>
                    <a:pt x="1125892" y="549714"/>
                    <a:pt x="1142851" y="542093"/>
                    <a:pt x="1162279" y="532949"/>
                  </a:cubicBezTo>
                  <a:cubicBezTo>
                    <a:pt x="1173138" y="550094"/>
                    <a:pt x="1187810" y="540377"/>
                    <a:pt x="1206097" y="532187"/>
                  </a:cubicBezTo>
                  <a:cubicBezTo>
                    <a:pt x="1224765" y="523805"/>
                    <a:pt x="1246292" y="521137"/>
                    <a:pt x="1266867" y="518088"/>
                  </a:cubicBezTo>
                  <a:cubicBezTo>
                    <a:pt x="1304588" y="512564"/>
                    <a:pt x="1342499" y="509134"/>
                    <a:pt x="1380219" y="504182"/>
                  </a:cubicBezTo>
                  <a:cubicBezTo>
                    <a:pt x="1388221" y="503038"/>
                    <a:pt x="1397365" y="500944"/>
                    <a:pt x="1403461" y="496180"/>
                  </a:cubicBezTo>
                  <a:cubicBezTo>
                    <a:pt x="1445181" y="464175"/>
                    <a:pt x="1495858" y="455222"/>
                    <a:pt x="1544054" y="458268"/>
                  </a:cubicBezTo>
                  <a:cubicBezTo>
                    <a:pt x="1581965" y="460557"/>
                    <a:pt x="1619114" y="462270"/>
                    <a:pt x="1656644" y="459032"/>
                  </a:cubicBezTo>
                  <a:cubicBezTo>
                    <a:pt x="1659502" y="458841"/>
                    <a:pt x="1663312" y="459223"/>
                    <a:pt x="1665406" y="460747"/>
                  </a:cubicBezTo>
                  <a:cubicBezTo>
                    <a:pt x="1678360" y="470843"/>
                    <a:pt x="1691887" y="471605"/>
                    <a:pt x="1708461" y="473318"/>
                  </a:cubicBezTo>
                  <a:cubicBezTo>
                    <a:pt x="1731894" y="475797"/>
                    <a:pt x="1753421" y="474081"/>
                    <a:pt x="1775140" y="469891"/>
                  </a:cubicBezTo>
                  <a:cubicBezTo>
                    <a:pt x="1790952" y="466843"/>
                    <a:pt x="1806953" y="460557"/>
                    <a:pt x="1821051" y="452554"/>
                  </a:cubicBezTo>
                  <a:cubicBezTo>
                    <a:pt x="1840672" y="441314"/>
                    <a:pt x="1859535" y="436934"/>
                    <a:pt x="1878203" y="451792"/>
                  </a:cubicBezTo>
                  <a:cubicBezTo>
                    <a:pt x="1898396" y="467605"/>
                    <a:pt x="1921257" y="462081"/>
                    <a:pt x="1943547" y="462651"/>
                  </a:cubicBezTo>
                  <a:cubicBezTo>
                    <a:pt x="1953262" y="462843"/>
                    <a:pt x="1963550" y="462461"/>
                    <a:pt x="1972884" y="464937"/>
                  </a:cubicBezTo>
                  <a:cubicBezTo>
                    <a:pt x="1999935" y="471987"/>
                    <a:pt x="2026036" y="482655"/>
                    <a:pt x="2053469" y="487417"/>
                  </a:cubicBezTo>
                  <a:cubicBezTo>
                    <a:pt x="2068710" y="490084"/>
                    <a:pt x="2085664" y="485321"/>
                    <a:pt x="2101477" y="481893"/>
                  </a:cubicBezTo>
                  <a:cubicBezTo>
                    <a:pt x="2117479" y="478273"/>
                    <a:pt x="2133290" y="472749"/>
                    <a:pt x="2148722" y="467033"/>
                  </a:cubicBezTo>
                  <a:cubicBezTo>
                    <a:pt x="2159199" y="463223"/>
                    <a:pt x="2170629" y="459603"/>
                    <a:pt x="2179011" y="452744"/>
                  </a:cubicBezTo>
                  <a:cubicBezTo>
                    <a:pt x="2198064" y="437124"/>
                    <a:pt x="2217685" y="434455"/>
                    <a:pt x="2240165" y="442648"/>
                  </a:cubicBezTo>
                  <a:cubicBezTo>
                    <a:pt x="2243593" y="443982"/>
                    <a:pt x="2247594" y="443982"/>
                    <a:pt x="2251404" y="444172"/>
                  </a:cubicBezTo>
                  <a:cubicBezTo>
                    <a:pt x="2312370" y="448172"/>
                    <a:pt x="2373330" y="450650"/>
                    <a:pt x="2433912" y="456746"/>
                  </a:cubicBezTo>
                  <a:cubicBezTo>
                    <a:pt x="2458485" y="459223"/>
                    <a:pt x="2482107" y="470081"/>
                    <a:pt x="2506302" y="476939"/>
                  </a:cubicBezTo>
                  <a:cubicBezTo>
                    <a:pt x="2511256" y="478273"/>
                    <a:pt x="2516783" y="480369"/>
                    <a:pt x="2521735" y="479415"/>
                  </a:cubicBezTo>
                  <a:cubicBezTo>
                    <a:pt x="2575647" y="469891"/>
                    <a:pt x="2626132" y="483797"/>
                    <a:pt x="2675854" y="502086"/>
                  </a:cubicBezTo>
                  <a:cubicBezTo>
                    <a:pt x="2680996" y="503992"/>
                    <a:pt x="2687282" y="503419"/>
                    <a:pt x="2692998" y="503038"/>
                  </a:cubicBezTo>
                  <a:cubicBezTo>
                    <a:pt x="2709003" y="501706"/>
                    <a:pt x="2726337" y="495038"/>
                    <a:pt x="2740816" y="499037"/>
                  </a:cubicBezTo>
                  <a:cubicBezTo>
                    <a:pt x="2779297" y="510088"/>
                    <a:pt x="2817398" y="523423"/>
                    <a:pt x="2853596" y="540187"/>
                  </a:cubicBezTo>
                  <a:cubicBezTo>
                    <a:pt x="2890365" y="557142"/>
                    <a:pt x="2924464" y="571430"/>
                    <a:pt x="2966565" y="554286"/>
                  </a:cubicBezTo>
                  <a:cubicBezTo>
                    <a:pt x="2984472" y="547045"/>
                    <a:pt x="3008095" y="552190"/>
                    <a:pt x="3028671" y="554094"/>
                  </a:cubicBezTo>
                  <a:cubicBezTo>
                    <a:pt x="3043720" y="555618"/>
                    <a:pt x="3058198" y="564192"/>
                    <a:pt x="3073059" y="564192"/>
                  </a:cubicBezTo>
                  <a:cubicBezTo>
                    <a:pt x="3112686" y="564192"/>
                    <a:pt x="3147927" y="574288"/>
                    <a:pt x="3182219" y="594862"/>
                  </a:cubicBezTo>
                  <a:cubicBezTo>
                    <a:pt x="3195557" y="602863"/>
                    <a:pt x="3216322" y="597529"/>
                    <a:pt x="3233656" y="599625"/>
                  </a:cubicBezTo>
                  <a:cubicBezTo>
                    <a:pt x="3251947" y="602101"/>
                    <a:pt x="3270804" y="604387"/>
                    <a:pt x="3288332" y="609914"/>
                  </a:cubicBezTo>
                  <a:cubicBezTo>
                    <a:pt x="3333672" y="624392"/>
                    <a:pt x="3378441" y="640774"/>
                    <a:pt x="3423591" y="656015"/>
                  </a:cubicBezTo>
                  <a:cubicBezTo>
                    <a:pt x="3460738" y="668590"/>
                    <a:pt x="3497317" y="658683"/>
                    <a:pt x="3534084" y="653349"/>
                  </a:cubicBezTo>
                  <a:cubicBezTo>
                    <a:pt x="3557137" y="649919"/>
                    <a:pt x="3578662" y="641727"/>
                    <a:pt x="3604571" y="653918"/>
                  </a:cubicBezTo>
                  <a:cubicBezTo>
                    <a:pt x="3629338" y="665541"/>
                    <a:pt x="3660771" y="662873"/>
                    <a:pt x="3688586" y="669160"/>
                  </a:cubicBezTo>
                  <a:cubicBezTo>
                    <a:pt x="3712020" y="674494"/>
                    <a:pt x="3734687" y="683068"/>
                    <a:pt x="3757358" y="691450"/>
                  </a:cubicBezTo>
                  <a:cubicBezTo>
                    <a:pt x="3788221" y="702881"/>
                    <a:pt x="3818700" y="714881"/>
                    <a:pt x="3852421" y="709167"/>
                  </a:cubicBezTo>
                  <a:cubicBezTo>
                    <a:pt x="3890714" y="702689"/>
                    <a:pt x="3917001" y="727073"/>
                    <a:pt x="3947104" y="743267"/>
                  </a:cubicBezTo>
                  <a:cubicBezTo>
                    <a:pt x="3967869" y="754316"/>
                    <a:pt x="3990538" y="762509"/>
                    <a:pt x="4013208" y="769367"/>
                  </a:cubicBezTo>
                  <a:cubicBezTo>
                    <a:pt x="4043497" y="778321"/>
                    <a:pt x="4074740" y="783655"/>
                    <a:pt x="4105222" y="792417"/>
                  </a:cubicBezTo>
                  <a:cubicBezTo>
                    <a:pt x="4151325" y="805561"/>
                    <a:pt x="4198001" y="815850"/>
                    <a:pt x="4246006" y="808610"/>
                  </a:cubicBezTo>
                  <a:cubicBezTo>
                    <a:pt x="4268105" y="805372"/>
                    <a:pt x="4288682" y="805561"/>
                    <a:pt x="4310779" y="810326"/>
                  </a:cubicBezTo>
                  <a:cubicBezTo>
                    <a:pt x="4346974" y="818136"/>
                    <a:pt x="4384123" y="819089"/>
                    <a:pt x="4413272" y="848235"/>
                  </a:cubicBezTo>
                  <a:cubicBezTo>
                    <a:pt x="4423558" y="858524"/>
                    <a:pt x="4442037" y="861190"/>
                    <a:pt x="4457087" y="866524"/>
                  </a:cubicBezTo>
                  <a:cubicBezTo>
                    <a:pt x="4474424" y="872812"/>
                    <a:pt x="4487186" y="869572"/>
                    <a:pt x="4496523" y="851284"/>
                  </a:cubicBezTo>
                  <a:cubicBezTo>
                    <a:pt x="4500713" y="843093"/>
                    <a:pt x="4512715" y="835091"/>
                    <a:pt x="4522050" y="833757"/>
                  </a:cubicBezTo>
                  <a:cubicBezTo>
                    <a:pt x="4550055" y="829757"/>
                    <a:pt x="4575773" y="835663"/>
                    <a:pt x="4602824" y="848618"/>
                  </a:cubicBezTo>
                  <a:cubicBezTo>
                    <a:pt x="4628161" y="860810"/>
                    <a:pt x="4659786" y="859476"/>
                    <a:pt x="4688553" y="864238"/>
                  </a:cubicBezTo>
                  <a:cubicBezTo>
                    <a:pt x="4708936" y="867668"/>
                    <a:pt x="4729321" y="874716"/>
                    <a:pt x="4749895" y="874716"/>
                  </a:cubicBezTo>
                  <a:cubicBezTo>
                    <a:pt x="4775424" y="874716"/>
                    <a:pt x="4800761" y="868620"/>
                    <a:pt x="4826480" y="866334"/>
                  </a:cubicBezTo>
                  <a:cubicBezTo>
                    <a:pt x="4846482" y="864430"/>
                    <a:pt x="4866867" y="865192"/>
                    <a:pt x="4886870" y="862906"/>
                  </a:cubicBezTo>
                  <a:cubicBezTo>
                    <a:pt x="4903254" y="861190"/>
                    <a:pt x="4919447" y="856810"/>
                    <a:pt x="4935639" y="853190"/>
                  </a:cubicBezTo>
                  <a:cubicBezTo>
                    <a:pt x="4941546" y="851856"/>
                    <a:pt x="4947452" y="846711"/>
                    <a:pt x="4952784" y="847473"/>
                  </a:cubicBezTo>
                  <a:cubicBezTo>
                    <a:pt x="5005745" y="855666"/>
                    <a:pt x="5043847" y="819089"/>
                    <a:pt x="5088617" y="802896"/>
                  </a:cubicBezTo>
                  <a:cubicBezTo>
                    <a:pt x="5135672" y="785749"/>
                    <a:pt x="5181204" y="759461"/>
                    <a:pt x="5233781" y="767271"/>
                  </a:cubicBezTo>
                  <a:cubicBezTo>
                    <a:pt x="5265596" y="772033"/>
                    <a:pt x="5296267" y="783083"/>
                    <a:pt x="5327893" y="789752"/>
                  </a:cubicBezTo>
                  <a:cubicBezTo>
                    <a:pt x="5339132" y="792038"/>
                    <a:pt x="5351705" y="791656"/>
                    <a:pt x="5362946" y="789370"/>
                  </a:cubicBezTo>
                  <a:cubicBezTo>
                    <a:pt x="5417240" y="778891"/>
                    <a:pt x="5470771" y="777367"/>
                    <a:pt x="5524115" y="794514"/>
                  </a:cubicBezTo>
                  <a:cubicBezTo>
                    <a:pt x="5533257" y="797372"/>
                    <a:pt x="5542974" y="800038"/>
                    <a:pt x="5552500" y="800038"/>
                  </a:cubicBezTo>
                  <a:cubicBezTo>
                    <a:pt x="5604697" y="800038"/>
                    <a:pt x="5655944" y="796038"/>
                    <a:pt x="5705857" y="777367"/>
                  </a:cubicBezTo>
                  <a:cubicBezTo>
                    <a:pt x="5722622" y="771080"/>
                    <a:pt x="5743006" y="775081"/>
                    <a:pt x="5761485" y="773557"/>
                  </a:cubicBezTo>
                  <a:cubicBezTo>
                    <a:pt x="5778629" y="772224"/>
                    <a:pt x="5796156" y="771653"/>
                    <a:pt x="5812731" y="767271"/>
                  </a:cubicBezTo>
                  <a:cubicBezTo>
                    <a:pt x="5836925" y="760795"/>
                    <a:pt x="5859404" y="760033"/>
                    <a:pt x="5884361" y="765747"/>
                  </a:cubicBezTo>
                  <a:cubicBezTo>
                    <a:pt x="5908174" y="771080"/>
                    <a:pt x="5933892" y="768415"/>
                    <a:pt x="5958660" y="768605"/>
                  </a:cubicBezTo>
                  <a:cubicBezTo>
                    <a:pt x="5986282" y="768795"/>
                    <a:pt x="6013906" y="768984"/>
                    <a:pt x="6041528" y="768033"/>
                  </a:cubicBezTo>
                  <a:cubicBezTo>
                    <a:pt x="6052579" y="767653"/>
                    <a:pt x="6065151" y="760033"/>
                    <a:pt x="6074297" y="763081"/>
                  </a:cubicBezTo>
                  <a:cubicBezTo>
                    <a:pt x="6103824" y="773366"/>
                    <a:pt x="6133353" y="760985"/>
                    <a:pt x="6162880" y="766509"/>
                  </a:cubicBezTo>
                  <a:cubicBezTo>
                    <a:pt x="6177360" y="769367"/>
                    <a:pt x="6193743" y="761557"/>
                    <a:pt x="6209364" y="760795"/>
                  </a:cubicBezTo>
                  <a:cubicBezTo>
                    <a:pt x="6234892" y="759461"/>
                    <a:pt x="6260419" y="760033"/>
                    <a:pt x="6285948" y="759651"/>
                  </a:cubicBezTo>
                  <a:cubicBezTo>
                    <a:pt x="6294330" y="759461"/>
                    <a:pt x="6302523" y="758699"/>
                    <a:pt x="6310905" y="758316"/>
                  </a:cubicBezTo>
                  <a:cubicBezTo>
                    <a:pt x="6318335" y="757936"/>
                    <a:pt x="6326145" y="756222"/>
                    <a:pt x="6333194" y="757554"/>
                  </a:cubicBezTo>
                  <a:cubicBezTo>
                    <a:pt x="6358723" y="762318"/>
                    <a:pt x="6383869" y="770129"/>
                    <a:pt x="6409586" y="773177"/>
                  </a:cubicBezTo>
                  <a:cubicBezTo>
                    <a:pt x="6431875" y="775843"/>
                    <a:pt x="6454928" y="772224"/>
                    <a:pt x="6477407" y="774129"/>
                  </a:cubicBezTo>
                  <a:cubicBezTo>
                    <a:pt x="6517032" y="777367"/>
                    <a:pt x="6556657" y="783083"/>
                    <a:pt x="6596283" y="786703"/>
                  </a:cubicBezTo>
                  <a:cubicBezTo>
                    <a:pt x="6604857" y="787465"/>
                    <a:pt x="6613809" y="782701"/>
                    <a:pt x="6622573" y="782321"/>
                  </a:cubicBezTo>
                  <a:cubicBezTo>
                    <a:pt x="6650006" y="781369"/>
                    <a:pt x="6677439" y="781177"/>
                    <a:pt x="6704872" y="780607"/>
                  </a:cubicBezTo>
                  <a:cubicBezTo>
                    <a:pt x="6720493" y="780415"/>
                    <a:pt x="6736305" y="780987"/>
                    <a:pt x="6751738" y="779273"/>
                  </a:cubicBezTo>
                  <a:cubicBezTo>
                    <a:pt x="6772120" y="776987"/>
                    <a:pt x="6790599" y="773557"/>
                    <a:pt x="6809650" y="788417"/>
                  </a:cubicBezTo>
                  <a:cubicBezTo>
                    <a:pt x="6816984" y="794180"/>
                    <a:pt x="6824819" y="797942"/>
                    <a:pt x="6832976" y="800428"/>
                  </a:cubicBezTo>
                  <a:close/>
                </a:path>
              </a:pathLst>
            </a:custGeom>
            <a:blipFill dpi="0" rotWithShape="1">
              <a:blip r:embed="rId3">
                <a:alphaModFix amt="57000"/>
              </a:blip>
              <a:srcRect/>
              <a:tile tx="0" ty="0" sx="100000" sy="100000" flip="none" algn="tl"/>
            </a:blipFill>
            <a:ln>
              <a:noFill/>
            </a:ln>
            <a:effectLst/>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grpSp>
      <p:sp>
        <p:nvSpPr>
          <p:cNvPr id="3" name="Content Placeholder 2">
            <a:extLst>
              <a:ext uri="{FF2B5EF4-FFF2-40B4-BE49-F238E27FC236}">
                <a16:creationId xmlns:a16="http://schemas.microsoft.com/office/drawing/2014/main" id="{13B5382F-2835-4FE1-BAD3-5D58199896F9}"/>
              </a:ext>
            </a:extLst>
          </p:cNvPr>
          <p:cNvSpPr>
            <a:spLocks noGrp="1"/>
          </p:cNvSpPr>
          <p:nvPr>
            <p:ph idx="1"/>
          </p:nvPr>
        </p:nvSpPr>
        <p:spPr>
          <a:xfrm>
            <a:off x="6981826" y="514350"/>
            <a:ext cx="4391024" cy="5975770"/>
          </a:xfrm>
        </p:spPr>
        <p:txBody>
          <a:bodyPr>
            <a:normAutofit/>
          </a:bodyPr>
          <a:lstStyle/>
          <a:p>
            <a:pPr marL="0" indent="0">
              <a:buNone/>
            </a:pPr>
            <a:r>
              <a:rPr lang="en-US" sz="1800" b="1" dirty="0">
                <a:solidFill>
                  <a:schemeClr val="bg1">
                    <a:alpha val="80000"/>
                  </a:schemeClr>
                </a:solidFill>
              </a:rPr>
              <a:t>5. Capsule</a:t>
            </a:r>
            <a:endParaRPr lang="en-US" sz="1800" dirty="0">
              <a:solidFill>
                <a:schemeClr val="bg1">
                  <a:alpha val="80000"/>
                </a:schemeClr>
              </a:solidFill>
            </a:endParaRPr>
          </a:p>
          <a:p>
            <a:r>
              <a:rPr lang="en-US" sz="1800" dirty="0">
                <a:solidFill>
                  <a:schemeClr val="bg1">
                    <a:alpha val="80000"/>
                  </a:schemeClr>
                </a:solidFill>
              </a:rPr>
              <a:t>Remove if feasible</a:t>
            </a:r>
          </a:p>
          <a:p>
            <a:r>
              <a:rPr lang="en-US" sz="1800" dirty="0">
                <a:solidFill>
                  <a:schemeClr val="bg1">
                    <a:alpha val="80000"/>
                  </a:schemeClr>
                </a:solidFill>
              </a:rPr>
              <a:t>If inflamed → defer &amp; refer outpatient</a:t>
            </a:r>
          </a:p>
          <a:p>
            <a:pPr marL="0" indent="0">
              <a:buNone/>
            </a:pPr>
            <a:r>
              <a:rPr lang="en-US" sz="1800" b="1" dirty="0">
                <a:solidFill>
                  <a:schemeClr val="bg1">
                    <a:alpha val="80000"/>
                  </a:schemeClr>
                </a:solidFill>
              </a:rPr>
              <a:t>6. Packing</a:t>
            </a:r>
            <a:endParaRPr lang="en-US" sz="1800" dirty="0">
              <a:solidFill>
                <a:schemeClr val="bg1">
                  <a:alpha val="80000"/>
                </a:schemeClr>
              </a:solidFill>
            </a:endParaRPr>
          </a:p>
          <a:p>
            <a:r>
              <a:rPr lang="en-US" sz="1800" b="1" dirty="0">
                <a:solidFill>
                  <a:schemeClr val="bg1">
                    <a:alpha val="80000"/>
                  </a:schemeClr>
                </a:solidFill>
              </a:rPr>
              <a:t>Not routine</a:t>
            </a:r>
            <a:endParaRPr lang="en-US" sz="1800" dirty="0">
              <a:solidFill>
                <a:schemeClr val="bg1">
                  <a:alpha val="80000"/>
                </a:schemeClr>
              </a:solidFill>
            </a:endParaRPr>
          </a:p>
          <a:p>
            <a:r>
              <a:rPr lang="en-US" sz="1800" dirty="0">
                <a:solidFill>
                  <a:schemeClr val="bg1">
                    <a:alpha val="80000"/>
                  </a:schemeClr>
                </a:solidFill>
              </a:rPr>
              <a:t>Consider only in skin apposition sites (axilla, groin, gluteal cleft)</a:t>
            </a:r>
          </a:p>
          <a:p>
            <a:pPr marL="0" indent="0">
              <a:buNone/>
            </a:pPr>
            <a:r>
              <a:rPr lang="en-US" sz="1800" b="1" dirty="0">
                <a:solidFill>
                  <a:schemeClr val="bg1">
                    <a:alpha val="80000"/>
                  </a:schemeClr>
                </a:solidFill>
              </a:rPr>
              <a:t>7. Dressing</a:t>
            </a:r>
            <a:endParaRPr lang="en-US" sz="1800" dirty="0">
              <a:solidFill>
                <a:schemeClr val="bg1">
                  <a:alpha val="80000"/>
                </a:schemeClr>
              </a:solidFill>
            </a:endParaRPr>
          </a:p>
          <a:p>
            <a:r>
              <a:rPr lang="en-US" sz="1800" dirty="0">
                <a:solidFill>
                  <a:schemeClr val="bg1">
                    <a:alpha val="80000"/>
                  </a:schemeClr>
                </a:solidFill>
              </a:rPr>
              <a:t>Apply antibiotic ointment</a:t>
            </a:r>
          </a:p>
          <a:p>
            <a:r>
              <a:rPr lang="en-US" sz="1800" dirty="0">
                <a:solidFill>
                  <a:schemeClr val="bg1">
                    <a:alpha val="80000"/>
                  </a:schemeClr>
                </a:solidFill>
              </a:rPr>
              <a:t>Cover with sterile dressing</a:t>
            </a:r>
          </a:p>
          <a:p>
            <a:pPr marL="0" indent="0">
              <a:buNone/>
            </a:pPr>
            <a:r>
              <a:rPr lang="en-US" sz="1800" b="1" dirty="0">
                <a:solidFill>
                  <a:schemeClr val="bg1">
                    <a:alpha val="80000"/>
                  </a:schemeClr>
                </a:solidFill>
              </a:rPr>
              <a:t>8. Follow-Up</a:t>
            </a:r>
            <a:endParaRPr lang="en-US" sz="1800" dirty="0">
              <a:solidFill>
                <a:schemeClr val="bg1">
                  <a:alpha val="80000"/>
                </a:schemeClr>
              </a:solidFill>
            </a:endParaRPr>
          </a:p>
          <a:p>
            <a:r>
              <a:rPr lang="en-US" sz="1800" dirty="0">
                <a:solidFill>
                  <a:schemeClr val="bg1">
                    <a:alpha val="80000"/>
                  </a:schemeClr>
                </a:solidFill>
              </a:rPr>
              <a:t>Re-dress daily</a:t>
            </a:r>
          </a:p>
          <a:p>
            <a:r>
              <a:rPr lang="en-US" sz="1800" dirty="0">
                <a:solidFill>
                  <a:schemeClr val="bg1">
                    <a:alpha val="80000"/>
                  </a:schemeClr>
                </a:solidFill>
              </a:rPr>
              <a:t>If packed → remove gradually</a:t>
            </a:r>
          </a:p>
          <a:p>
            <a:r>
              <a:rPr lang="en-US" sz="1800" dirty="0">
                <a:solidFill>
                  <a:schemeClr val="bg1">
                    <a:alpha val="80000"/>
                  </a:schemeClr>
                </a:solidFill>
              </a:rPr>
              <a:t>Otherwise heal by secondary intention</a:t>
            </a:r>
          </a:p>
          <a:p>
            <a:pPr marL="0" indent="0">
              <a:buNone/>
            </a:pPr>
            <a:endParaRPr lang="en-US" sz="600" b="1" dirty="0">
              <a:solidFill>
                <a:schemeClr val="bg1">
                  <a:alpha val="80000"/>
                </a:schemeClr>
              </a:solidFill>
            </a:endParaRPr>
          </a:p>
        </p:txBody>
      </p:sp>
      <p:sp>
        <p:nvSpPr>
          <p:cNvPr id="5" name="Title 4">
            <a:extLst>
              <a:ext uri="{FF2B5EF4-FFF2-40B4-BE49-F238E27FC236}">
                <a16:creationId xmlns:a16="http://schemas.microsoft.com/office/drawing/2014/main" id="{71A9E9DB-631E-0384-378D-E228094EEF1D}"/>
              </a:ext>
            </a:extLst>
          </p:cNvPr>
          <p:cNvSpPr>
            <a:spLocks noGrp="1"/>
          </p:cNvSpPr>
          <p:nvPr>
            <p:ph type="title"/>
          </p:nvPr>
        </p:nvSpPr>
        <p:spPr/>
        <p:txBody>
          <a:bodyPr/>
          <a:lstStyle/>
          <a:p>
            <a:endParaRPr lang="en-US"/>
          </a:p>
        </p:txBody>
      </p:sp>
      <p:pic>
        <p:nvPicPr>
          <p:cNvPr id="4" name="Picture 3" descr="A person's hands in gloves on a person's stomach&#10;&#10;Description automatically generated">
            <a:extLst>
              <a:ext uri="{FF2B5EF4-FFF2-40B4-BE49-F238E27FC236}">
                <a16:creationId xmlns:a16="http://schemas.microsoft.com/office/drawing/2014/main" id="{9D08D36B-2D36-52F5-FC84-541DAFBA855E}"/>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rot="5400000">
            <a:off x="-646658" y="1018903"/>
            <a:ext cx="6426200" cy="4819650"/>
          </a:xfrm>
          <a:prstGeom prst="rect">
            <a:avLst/>
          </a:prstGeom>
        </p:spPr>
      </p:pic>
      <p:sp>
        <p:nvSpPr>
          <p:cNvPr id="6" name="TextBox 5">
            <a:extLst>
              <a:ext uri="{FF2B5EF4-FFF2-40B4-BE49-F238E27FC236}">
                <a16:creationId xmlns:a16="http://schemas.microsoft.com/office/drawing/2014/main" id="{4E94B881-9DB5-AFAB-673D-AFAD06F4F7C7}"/>
              </a:ext>
            </a:extLst>
          </p:cNvPr>
          <p:cNvSpPr txBox="1"/>
          <p:nvPr/>
        </p:nvSpPr>
        <p:spPr>
          <a:xfrm>
            <a:off x="2698229" y="6272496"/>
            <a:ext cx="2124749" cy="369332"/>
          </a:xfrm>
          <a:prstGeom prst="rect">
            <a:avLst/>
          </a:prstGeom>
          <a:noFill/>
        </p:spPr>
        <p:txBody>
          <a:bodyPr wrap="none" rtlCol="0">
            <a:spAutoFit/>
          </a:bodyPr>
          <a:lstStyle/>
          <a:p>
            <a:r>
              <a:rPr lang="en-US" i="1" dirty="0"/>
              <a:t>Authors’ own image.</a:t>
            </a:r>
            <a:endParaRPr lang="en-US" dirty="0"/>
          </a:p>
        </p:txBody>
      </p:sp>
    </p:spTree>
    <p:extLst>
      <p:ext uri="{BB962C8B-B14F-4D97-AF65-F5344CB8AC3E}">
        <p14:creationId xmlns:p14="http://schemas.microsoft.com/office/powerpoint/2010/main" val="31191339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05AE08-3A01-1494-9560-604E9FF6C5C9}"/>
              </a:ext>
            </a:extLst>
          </p:cNvPr>
          <p:cNvSpPr>
            <a:spLocks noGrp="1"/>
          </p:cNvSpPr>
          <p:nvPr>
            <p:ph type="title"/>
          </p:nvPr>
        </p:nvSpPr>
        <p:spPr/>
        <p:txBody>
          <a:bodyPr/>
          <a:lstStyle/>
          <a:p>
            <a:pPr algn="ctr"/>
            <a:r>
              <a:rPr lang="en-US" b="1" dirty="0"/>
              <a:t>Abscess I&amp;D Video</a:t>
            </a:r>
          </a:p>
        </p:txBody>
      </p:sp>
      <p:sp>
        <p:nvSpPr>
          <p:cNvPr id="6" name="Content Placeholder 5">
            <a:extLst>
              <a:ext uri="{FF2B5EF4-FFF2-40B4-BE49-F238E27FC236}">
                <a16:creationId xmlns:a16="http://schemas.microsoft.com/office/drawing/2014/main" id="{42AEED83-4593-04C8-4D29-A207A32F4EA8}"/>
              </a:ext>
            </a:extLst>
          </p:cNvPr>
          <p:cNvSpPr>
            <a:spLocks noGrp="1"/>
          </p:cNvSpPr>
          <p:nvPr>
            <p:ph idx="1"/>
          </p:nvPr>
        </p:nvSpPr>
        <p:spPr/>
        <p:txBody>
          <a:bodyPr/>
          <a:lstStyle/>
          <a:p>
            <a:r>
              <a:rPr lang="en-US" dirty="0">
                <a:hlinkClick r:id="rId3"/>
              </a:rPr>
              <a:t>https://www.youtube.com/watch?v=iSDkvvY3SHc&amp;t=5s</a:t>
            </a:r>
            <a:r>
              <a:rPr lang="en-US" dirty="0"/>
              <a:t> </a:t>
            </a:r>
          </a:p>
        </p:txBody>
      </p:sp>
    </p:spTree>
    <p:extLst>
      <p:ext uri="{BB962C8B-B14F-4D97-AF65-F5344CB8AC3E}">
        <p14:creationId xmlns:p14="http://schemas.microsoft.com/office/powerpoint/2010/main" val="260322535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886343-FFEF-ADE9-7D89-0D524FF6531D}"/>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EF420980-80D4-8B45-5C5F-6E490BFB42FC}"/>
              </a:ext>
            </a:extLst>
          </p:cNvPr>
          <p:cNvSpPr>
            <a:spLocks noGrp="1"/>
          </p:cNvSpPr>
          <p:nvPr>
            <p:ph idx="1"/>
          </p:nvPr>
        </p:nvSpPr>
        <p:spPr/>
        <p:txBody>
          <a:bodyPr>
            <a:normAutofit fontScale="85000" lnSpcReduction="20000"/>
          </a:bodyPr>
          <a:lstStyle/>
          <a:p>
            <a:r>
              <a:rPr lang="en-US" dirty="0"/>
              <a:t>Amundsen GA. Local anesthesia. In: Pfenninger J, Fowler G, eds. </a:t>
            </a:r>
            <a:r>
              <a:rPr lang="en-US" i="1" dirty="0"/>
              <a:t>Pfenninger and Fowler’s Procedures for Primary Care.</a:t>
            </a:r>
            <a:r>
              <a:rPr lang="en-US" dirty="0"/>
              <a:t> 4th ed. Philadelphia, PA: Elsevier; 2020:27-31. Accessed September 11, 2024.</a:t>
            </a:r>
          </a:p>
          <a:p>
            <a:r>
              <a:rPr lang="en-US" dirty="0"/>
              <a:t>Talan DA, Mower WR, Krishnadasan A, et al. Trimethoprim–sulfamethoxazole versus placebo for uncomplicated skin abscess. </a:t>
            </a:r>
            <a:r>
              <a:rPr lang="en-US" i="1" dirty="0"/>
              <a:t>N Engl J Med.</a:t>
            </a:r>
            <a:r>
              <a:rPr lang="en-US" dirty="0"/>
              <a:t> 2016;374(9):823-832. doi:10.1056/NEJMoa1507476</a:t>
            </a:r>
          </a:p>
          <a:p>
            <a:r>
              <a:rPr lang="en-US" dirty="0"/>
              <a:t>Derksen DJ. Incision and drainage of an abscess. In: Pfenninger J, Fowler G, eds. </a:t>
            </a:r>
            <a:r>
              <a:rPr lang="en-US" i="1" dirty="0"/>
              <a:t>Pfenninger and Fowler’s Procedures for Primary Care.</a:t>
            </a:r>
            <a:r>
              <a:rPr lang="en-US" dirty="0"/>
              <a:t> 4th ed. Philadelphia, PA: Elsevier; 2020:1307-1310. Accessed September 11, 2024.</a:t>
            </a:r>
          </a:p>
          <a:p>
            <a:r>
              <a:rPr lang="en-US"/>
              <a:t>Hippo </a:t>
            </a:r>
            <a:r>
              <a:rPr lang="en-US" dirty="0"/>
              <a:t>Education. Urgent Care Bootcamp: Soft Tissue Abscess Drainage. In: </a:t>
            </a:r>
            <a:r>
              <a:rPr lang="en-US" i="1" dirty="0"/>
              <a:t>YouTube.</a:t>
            </a:r>
            <a:r>
              <a:rPr lang="en-US" dirty="0"/>
              <a:t> February 28, 2020. Accessed September 11, 2024. </a:t>
            </a:r>
            <a:r>
              <a:rPr lang="en-US" dirty="0">
                <a:hlinkClick r:id="rId3"/>
              </a:rPr>
              <a:t>https://www.youtube.com/watch?v=iSDkvvY3SHc&amp;t=369s</a:t>
            </a:r>
            <a:endParaRPr lang="en-US" dirty="0"/>
          </a:p>
          <a:p>
            <a:r>
              <a:rPr lang="en-US" i="1" dirty="0"/>
              <a:t>All uncited images are the authors’ own and reproduced with permission.</a:t>
            </a:r>
            <a:endParaRPr lang="en-US" dirty="0"/>
          </a:p>
        </p:txBody>
      </p:sp>
    </p:spTree>
    <p:extLst>
      <p:ext uri="{BB962C8B-B14F-4D97-AF65-F5344CB8AC3E}">
        <p14:creationId xmlns:p14="http://schemas.microsoft.com/office/powerpoint/2010/main" val="23701527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A4AEA7-B8FF-C591-C7AA-E4894CFD1FA5}"/>
              </a:ext>
            </a:extLst>
          </p:cNvPr>
          <p:cNvSpPr>
            <a:spLocks noGrp="1"/>
          </p:cNvSpPr>
          <p:nvPr>
            <p:ph type="title"/>
          </p:nvPr>
        </p:nvSpPr>
        <p:spPr/>
        <p:txBody>
          <a:bodyPr/>
          <a:lstStyle/>
          <a:p>
            <a:pPr algn="ctr"/>
            <a:r>
              <a:rPr lang="en-US" b="1" dirty="0"/>
              <a:t>Learning Objectives</a:t>
            </a:r>
          </a:p>
        </p:txBody>
      </p:sp>
      <p:sp>
        <p:nvSpPr>
          <p:cNvPr id="3" name="Content Placeholder 2">
            <a:extLst>
              <a:ext uri="{FF2B5EF4-FFF2-40B4-BE49-F238E27FC236}">
                <a16:creationId xmlns:a16="http://schemas.microsoft.com/office/drawing/2014/main" id="{29F330A3-78FD-35B1-2A41-D50B4690DE94}"/>
              </a:ext>
            </a:extLst>
          </p:cNvPr>
          <p:cNvSpPr>
            <a:spLocks noGrp="1"/>
          </p:cNvSpPr>
          <p:nvPr>
            <p:ph idx="1"/>
          </p:nvPr>
        </p:nvSpPr>
        <p:spPr/>
        <p:txBody>
          <a:bodyPr/>
          <a:lstStyle/>
          <a:p>
            <a:pPr marL="0" indent="0">
              <a:buNone/>
            </a:pPr>
            <a:r>
              <a:rPr lang="en-US" dirty="0"/>
              <a:t>After this session, learners will be able to:</a:t>
            </a:r>
          </a:p>
          <a:p>
            <a:r>
              <a:rPr lang="en-US" dirty="0"/>
              <a:t>Identify the clinical features, risk factors, and common pathogens (including MRSA*) associated with cutaneous abscesses.</a:t>
            </a:r>
          </a:p>
          <a:p>
            <a:r>
              <a:rPr lang="en-US" dirty="0"/>
              <a:t>Select the necessary equipment and supplies for performing an incision and drainage (I&amp;D) procedure.</a:t>
            </a:r>
          </a:p>
          <a:p>
            <a:r>
              <a:rPr lang="en-US" dirty="0"/>
              <a:t>Review the stepwise technique of abscess I&amp;D, including anesthesia, incision, drainage, and aftercare.</a:t>
            </a:r>
          </a:p>
          <a:p>
            <a:r>
              <a:rPr lang="en-US" dirty="0"/>
              <a:t>Differentiate evidence-based management strategies (packing vs. no packing, cyst wall removal caveats, antibiotic use).</a:t>
            </a:r>
          </a:p>
        </p:txBody>
      </p:sp>
    </p:spTree>
    <p:extLst>
      <p:ext uri="{BB962C8B-B14F-4D97-AF65-F5344CB8AC3E}">
        <p14:creationId xmlns:p14="http://schemas.microsoft.com/office/powerpoint/2010/main" val="18522901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BE121D-B3D8-4CF4-8FD3-115D01170831}"/>
              </a:ext>
            </a:extLst>
          </p:cNvPr>
          <p:cNvSpPr>
            <a:spLocks noGrp="1"/>
          </p:cNvSpPr>
          <p:nvPr>
            <p:ph type="title"/>
          </p:nvPr>
        </p:nvSpPr>
        <p:spPr/>
        <p:txBody>
          <a:bodyPr/>
          <a:lstStyle/>
          <a:p>
            <a:pPr algn="ctr"/>
            <a:r>
              <a:rPr lang="en-US" b="1" dirty="0"/>
              <a:t>Lecture Outline</a:t>
            </a:r>
          </a:p>
        </p:txBody>
      </p:sp>
      <p:sp>
        <p:nvSpPr>
          <p:cNvPr id="3" name="Content Placeholder 2">
            <a:extLst>
              <a:ext uri="{FF2B5EF4-FFF2-40B4-BE49-F238E27FC236}">
                <a16:creationId xmlns:a16="http://schemas.microsoft.com/office/drawing/2014/main" id="{75BFEFFA-27A5-4F3B-B775-A13038D06FB7}"/>
              </a:ext>
            </a:extLst>
          </p:cNvPr>
          <p:cNvSpPr>
            <a:spLocks noGrp="1"/>
          </p:cNvSpPr>
          <p:nvPr>
            <p:ph idx="1"/>
          </p:nvPr>
        </p:nvSpPr>
        <p:spPr/>
        <p:txBody>
          <a:bodyPr/>
          <a:lstStyle/>
          <a:p>
            <a:r>
              <a:rPr lang="en-US" dirty="0">
                <a:solidFill>
                  <a:srgbClr val="FF0000"/>
                </a:solidFill>
              </a:rPr>
              <a:t>Local anesthesia</a:t>
            </a:r>
          </a:p>
          <a:p>
            <a:pPr lvl="1"/>
            <a:r>
              <a:rPr lang="en-US" dirty="0">
                <a:solidFill>
                  <a:srgbClr val="FF0000"/>
                </a:solidFill>
              </a:rPr>
              <a:t>Local anesthetic use</a:t>
            </a:r>
          </a:p>
          <a:p>
            <a:pPr lvl="1"/>
            <a:r>
              <a:rPr lang="en-US" dirty="0">
                <a:solidFill>
                  <a:srgbClr val="FF0000"/>
                </a:solidFill>
              </a:rPr>
              <a:t>Field block</a:t>
            </a:r>
          </a:p>
          <a:p>
            <a:r>
              <a:rPr lang="en-US" dirty="0"/>
              <a:t>Cysts and abscesses</a:t>
            </a:r>
          </a:p>
          <a:p>
            <a:pPr lvl="1"/>
            <a:r>
              <a:rPr lang="en-US" dirty="0"/>
              <a:t>Cyst excision</a:t>
            </a:r>
          </a:p>
          <a:p>
            <a:pPr lvl="1"/>
            <a:r>
              <a:rPr lang="en-US" dirty="0"/>
              <a:t>Abscess incision and drainage</a:t>
            </a:r>
          </a:p>
        </p:txBody>
      </p:sp>
    </p:spTree>
    <p:extLst>
      <p:ext uri="{BB962C8B-B14F-4D97-AF65-F5344CB8AC3E}">
        <p14:creationId xmlns:p14="http://schemas.microsoft.com/office/powerpoint/2010/main" val="12361181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CC4164-B11F-4DE1-B8FE-08C0BEC13591}"/>
              </a:ext>
            </a:extLst>
          </p:cNvPr>
          <p:cNvSpPr>
            <a:spLocks noGrp="1"/>
          </p:cNvSpPr>
          <p:nvPr>
            <p:ph type="title"/>
          </p:nvPr>
        </p:nvSpPr>
        <p:spPr/>
        <p:txBody>
          <a:bodyPr/>
          <a:lstStyle/>
          <a:p>
            <a:pPr algn="ctr"/>
            <a:r>
              <a:rPr lang="en-US" b="1" dirty="0"/>
              <a:t>Drawing-up Local Anesthetic</a:t>
            </a:r>
          </a:p>
        </p:txBody>
      </p:sp>
      <p:sp>
        <p:nvSpPr>
          <p:cNvPr id="3" name="Content Placeholder 2">
            <a:extLst>
              <a:ext uri="{FF2B5EF4-FFF2-40B4-BE49-F238E27FC236}">
                <a16:creationId xmlns:a16="http://schemas.microsoft.com/office/drawing/2014/main" id="{786BF20F-FDB4-41CF-B2D2-F22A12552011}"/>
              </a:ext>
            </a:extLst>
          </p:cNvPr>
          <p:cNvSpPr>
            <a:spLocks noGrp="1"/>
          </p:cNvSpPr>
          <p:nvPr>
            <p:ph idx="1"/>
          </p:nvPr>
        </p:nvSpPr>
        <p:spPr>
          <a:xfrm>
            <a:off x="838200" y="1690688"/>
            <a:ext cx="10073640" cy="4895925"/>
          </a:xfrm>
        </p:spPr>
        <p:txBody>
          <a:bodyPr>
            <a:normAutofit fontScale="92500" lnSpcReduction="20000"/>
          </a:bodyPr>
          <a:lstStyle/>
          <a:p>
            <a:pPr marL="0" indent="0">
              <a:buNone/>
            </a:pPr>
            <a:r>
              <a:rPr lang="en-US" b="1" dirty="0"/>
              <a:t>Step 1. Prep Vial</a:t>
            </a:r>
            <a:endParaRPr lang="en-US" dirty="0"/>
          </a:p>
          <a:p>
            <a:r>
              <a:rPr lang="en-US" dirty="0"/>
              <a:t>Wipe top with alcohol (only if previously used)</a:t>
            </a:r>
          </a:p>
          <a:p>
            <a:pPr marL="0" indent="0">
              <a:buNone/>
            </a:pPr>
            <a:r>
              <a:rPr lang="en-US" b="1" dirty="0"/>
              <a:t>Step 2. Prep Syringe</a:t>
            </a:r>
            <a:endParaRPr lang="en-US" dirty="0"/>
          </a:p>
          <a:p>
            <a:r>
              <a:rPr lang="en-US" dirty="0"/>
              <a:t>Draw in air - planned volume</a:t>
            </a:r>
          </a:p>
          <a:p>
            <a:r>
              <a:rPr lang="en-US" dirty="0"/>
              <a:t>Insert 18g needle, inject air</a:t>
            </a:r>
          </a:p>
          <a:p>
            <a:pPr marL="0" indent="0">
              <a:buNone/>
            </a:pPr>
            <a:r>
              <a:rPr lang="en-US" b="1" dirty="0"/>
              <a:t>Step 3. Withdraw Fluid</a:t>
            </a:r>
            <a:endParaRPr lang="en-US" dirty="0"/>
          </a:p>
          <a:p>
            <a:r>
              <a:rPr lang="en-US" dirty="0"/>
              <a:t>Invert vial, withdraw fluid</a:t>
            </a:r>
          </a:p>
          <a:p>
            <a:pPr marL="0" indent="0">
              <a:buNone/>
            </a:pPr>
            <a:r>
              <a:rPr lang="en-US" b="1" dirty="0"/>
              <a:t>Step 4. Final Setup</a:t>
            </a:r>
            <a:endParaRPr lang="en-US" dirty="0"/>
          </a:p>
          <a:p>
            <a:r>
              <a:rPr lang="en-US" dirty="0"/>
              <a:t>Exchange for 27–30g needle (1–1.5 in)</a:t>
            </a:r>
          </a:p>
          <a:p>
            <a:r>
              <a:rPr lang="en-US" dirty="0"/>
              <a:t>Expel air bubbles</a:t>
            </a:r>
          </a:p>
          <a:p>
            <a:pPr marL="0" indent="0">
              <a:buNone/>
            </a:pPr>
            <a:r>
              <a:rPr lang="en-US" i="1" dirty="0"/>
              <a:t>(Optional Sterile Technique: helper wipes &amp; holds vial upside down </a:t>
            </a:r>
            <a:r>
              <a:rPr lang="en-US" i="1" dirty="0">
                <a:sym typeface="Wingdings" pitchFamily="2" charset="2"/>
              </a:rPr>
              <a:t></a:t>
            </a:r>
            <a:r>
              <a:rPr lang="en-US" i="1" dirty="0"/>
              <a:t> anesthetist inserts needle without touching vial)</a:t>
            </a:r>
            <a:endParaRPr lang="en-US" dirty="0"/>
          </a:p>
        </p:txBody>
      </p:sp>
    </p:spTree>
    <p:extLst>
      <p:ext uri="{BB962C8B-B14F-4D97-AF65-F5344CB8AC3E}">
        <p14:creationId xmlns:p14="http://schemas.microsoft.com/office/powerpoint/2010/main" val="36885970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AFCAE1B-529D-4F0A-A85B-F6246687E71B}"/>
              </a:ext>
            </a:extLst>
          </p:cNvPr>
          <p:cNvSpPr>
            <a:spLocks noGrp="1"/>
          </p:cNvSpPr>
          <p:nvPr>
            <p:ph type="title"/>
          </p:nvPr>
        </p:nvSpPr>
        <p:spPr/>
        <p:txBody>
          <a:bodyPr/>
          <a:lstStyle/>
          <a:p>
            <a:pPr algn="ctr"/>
            <a:r>
              <a:rPr lang="en-US" b="1" dirty="0"/>
              <a:t>Field Block</a:t>
            </a:r>
          </a:p>
        </p:txBody>
      </p:sp>
      <p:sp>
        <p:nvSpPr>
          <p:cNvPr id="3" name="Content Placeholder 2">
            <a:extLst>
              <a:ext uri="{FF2B5EF4-FFF2-40B4-BE49-F238E27FC236}">
                <a16:creationId xmlns:a16="http://schemas.microsoft.com/office/drawing/2014/main" id="{5858EEC3-9A2F-4FDB-AE9C-2FBB815F26A3}"/>
              </a:ext>
            </a:extLst>
          </p:cNvPr>
          <p:cNvSpPr>
            <a:spLocks noGrp="1"/>
          </p:cNvSpPr>
          <p:nvPr>
            <p:ph idx="1"/>
          </p:nvPr>
        </p:nvSpPr>
        <p:spPr>
          <a:xfrm>
            <a:off x="838200" y="1557338"/>
            <a:ext cx="10515600" cy="5020946"/>
          </a:xfrm>
        </p:spPr>
        <p:txBody>
          <a:bodyPr>
            <a:normAutofit fontScale="92500" lnSpcReduction="20000"/>
          </a:bodyPr>
          <a:lstStyle/>
          <a:p>
            <a:pPr marL="0" indent="0">
              <a:buNone/>
            </a:pPr>
            <a:r>
              <a:rPr lang="en-US" b="1" dirty="0"/>
              <a:t>Step 1. Prep</a:t>
            </a:r>
            <a:endParaRPr lang="en-US" dirty="0"/>
          </a:p>
          <a:p>
            <a:r>
              <a:rPr lang="en-US" dirty="0"/>
              <a:t>Clean skin: alcohol or povidone-iodine</a:t>
            </a:r>
          </a:p>
          <a:p>
            <a:pPr marL="0" indent="0">
              <a:buNone/>
            </a:pPr>
            <a:r>
              <a:rPr lang="en-US" b="1" dirty="0"/>
              <a:t>Step 2. Injection</a:t>
            </a:r>
            <a:endParaRPr lang="en-US" dirty="0"/>
          </a:p>
          <a:p>
            <a:r>
              <a:rPr lang="en-US" dirty="0"/>
              <a:t>Insert 27–30g needle into subcutaneous tissue</a:t>
            </a:r>
          </a:p>
          <a:p>
            <a:r>
              <a:rPr lang="en-US" dirty="0"/>
              <a:t>Inject small amount → advance → repeat (“field block”)</a:t>
            </a:r>
          </a:p>
          <a:p>
            <a:pPr marL="0" indent="0">
              <a:buNone/>
            </a:pPr>
            <a:r>
              <a:rPr lang="en-US" b="1" dirty="0"/>
              <a:t>Step 3. Pearls</a:t>
            </a:r>
            <a:endParaRPr lang="en-US" dirty="0"/>
          </a:p>
          <a:p>
            <a:r>
              <a:rPr lang="en-US" dirty="0"/>
              <a:t>May advance fully, inject while withdrawing</a:t>
            </a:r>
          </a:p>
          <a:p>
            <a:r>
              <a:rPr lang="en-US" dirty="0"/>
              <a:t>If laceration: enter via wound edge</a:t>
            </a:r>
          </a:p>
          <a:p>
            <a:r>
              <a:rPr lang="en-US" dirty="0"/>
              <a:t>Goal: surround lesion; avoid injecting into lesion</a:t>
            </a:r>
          </a:p>
          <a:p>
            <a:pPr marL="0" indent="0">
              <a:buNone/>
            </a:pPr>
            <a:r>
              <a:rPr lang="en-US" b="1" dirty="0"/>
              <a:t>Step 4. Safety</a:t>
            </a:r>
            <a:endParaRPr lang="en-US" dirty="0"/>
          </a:p>
          <a:p>
            <a:r>
              <a:rPr lang="en-US" dirty="0"/>
              <a:t>Ensure block wide enough for planned repair/excision</a:t>
            </a:r>
          </a:p>
          <a:p>
            <a:r>
              <a:rPr lang="en-US" dirty="0"/>
              <a:t>Avoid epinephrine on: fingers, toes, penis, nose, earlobes, tissue flaps</a:t>
            </a:r>
          </a:p>
        </p:txBody>
      </p:sp>
    </p:spTree>
    <p:extLst>
      <p:ext uri="{BB962C8B-B14F-4D97-AF65-F5344CB8AC3E}">
        <p14:creationId xmlns:p14="http://schemas.microsoft.com/office/powerpoint/2010/main" val="25204512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7BE121D-B3D8-4CF4-8FD3-115D01170831}"/>
              </a:ext>
            </a:extLst>
          </p:cNvPr>
          <p:cNvSpPr>
            <a:spLocks noGrp="1"/>
          </p:cNvSpPr>
          <p:nvPr>
            <p:ph type="title"/>
          </p:nvPr>
        </p:nvSpPr>
        <p:spPr/>
        <p:txBody>
          <a:bodyPr/>
          <a:lstStyle/>
          <a:p>
            <a:pPr algn="ctr"/>
            <a:r>
              <a:rPr lang="en-US" b="1" dirty="0"/>
              <a:t>Lecture Outline</a:t>
            </a:r>
          </a:p>
        </p:txBody>
      </p:sp>
      <p:sp>
        <p:nvSpPr>
          <p:cNvPr id="3" name="Content Placeholder 2">
            <a:extLst>
              <a:ext uri="{FF2B5EF4-FFF2-40B4-BE49-F238E27FC236}">
                <a16:creationId xmlns:a16="http://schemas.microsoft.com/office/drawing/2014/main" id="{75BFEFFA-27A5-4F3B-B775-A13038D06FB7}"/>
              </a:ext>
            </a:extLst>
          </p:cNvPr>
          <p:cNvSpPr>
            <a:spLocks noGrp="1"/>
          </p:cNvSpPr>
          <p:nvPr>
            <p:ph idx="1"/>
          </p:nvPr>
        </p:nvSpPr>
        <p:spPr>
          <a:xfrm>
            <a:off x="838200" y="1825625"/>
            <a:ext cx="10515600" cy="4667250"/>
          </a:xfrm>
        </p:spPr>
        <p:txBody>
          <a:bodyPr>
            <a:normAutofit/>
          </a:bodyPr>
          <a:lstStyle/>
          <a:p>
            <a:r>
              <a:rPr lang="en-US" dirty="0"/>
              <a:t>Local anesthesia</a:t>
            </a:r>
          </a:p>
          <a:p>
            <a:pPr lvl="1"/>
            <a:r>
              <a:rPr lang="en-US" sz="2800" dirty="0"/>
              <a:t>Local anesthetic use</a:t>
            </a:r>
          </a:p>
          <a:p>
            <a:pPr lvl="1"/>
            <a:r>
              <a:rPr lang="en-US" sz="2800" dirty="0"/>
              <a:t>Field block</a:t>
            </a:r>
          </a:p>
          <a:p>
            <a:r>
              <a:rPr lang="en-US" dirty="0">
                <a:solidFill>
                  <a:srgbClr val="FF0000"/>
                </a:solidFill>
              </a:rPr>
              <a:t>Cysts and abscesses</a:t>
            </a:r>
          </a:p>
          <a:p>
            <a:pPr lvl="1"/>
            <a:r>
              <a:rPr lang="en-US" sz="2800" dirty="0">
                <a:solidFill>
                  <a:srgbClr val="FF0000"/>
                </a:solidFill>
              </a:rPr>
              <a:t>Cyst excision</a:t>
            </a:r>
          </a:p>
          <a:p>
            <a:pPr lvl="1"/>
            <a:r>
              <a:rPr lang="en-US" sz="2800" dirty="0">
                <a:solidFill>
                  <a:srgbClr val="FF0000"/>
                </a:solidFill>
              </a:rPr>
              <a:t>Abscess incision and drainage</a:t>
            </a:r>
          </a:p>
        </p:txBody>
      </p:sp>
    </p:spTree>
    <p:extLst>
      <p:ext uri="{BB962C8B-B14F-4D97-AF65-F5344CB8AC3E}">
        <p14:creationId xmlns:p14="http://schemas.microsoft.com/office/powerpoint/2010/main" val="321219450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1041" name="Slide Background">
            <a:extLst>
              <a:ext uri="{FF2B5EF4-FFF2-40B4-BE49-F238E27FC236}">
                <a16:creationId xmlns:a16="http://schemas.microsoft.com/office/drawing/2014/main" id="{9F7D5CDA-D291-4307-BF55-1381FED2963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CE6ECE72-E425-4CAC-9A03-3E5E0BC8D8B0}"/>
              </a:ext>
            </a:extLst>
          </p:cNvPr>
          <p:cNvSpPr>
            <a:spLocks noGrp="1"/>
          </p:cNvSpPr>
          <p:nvPr>
            <p:ph type="title"/>
          </p:nvPr>
        </p:nvSpPr>
        <p:spPr>
          <a:xfrm>
            <a:off x="761800" y="762001"/>
            <a:ext cx="5334197" cy="1708242"/>
          </a:xfrm>
        </p:spPr>
        <p:txBody>
          <a:bodyPr anchor="ctr">
            <a:normAutofit/>
          </a:bodyPr>
          <a:lstStyle/>
          <a:p>
            <a:r>
              <a:rPr lang="en-US" sz="4000" b="1" dirty="0"/>
              <a:t>Cyst and Abscess </a:t>
            </a:r>
          </a:p>
        </p:txBody>
      </p:sp>
      <p:sp>
        <p:nvSpPr>
          <p:cNvPr id="3" name="Content Placeholder 2">
            <a:extLst>
              <a:ext uri="{FF2B5EF4-FFF2-40B4-BE49-F238E27FC236}">
                <a16:creationId xmlns:a16="http://schemas.microsoft.com/office/drawing/2014/main" id="{C01CD695-B92C-4CB9-96A9-39552E876527}"/>
              </a:ext>
            </a:extLst>
          </p:cNvPr>
          <p:cNvSpPr>
            <a:spLocks noGrp="1"/>
          </p:cNvSpPr>
          <p:nvPr>
            <p:ph idx="1"/>
          </p:nvPr>
        </p:nvSpPr>
        <p:spPr>
          <a:xfrm>
            <a:off x="761800" y="1963711"/>
            <a:ext cx="5334197" cy="4691921"/>
          </a:xfrm>
        </p:spPr>
        <p:txBody>
          <a:bodyPr anchor="ctr">
            <a:normAutofit/>
          </a:bodyPr>
          <a:lstStyle/>
          <a:p>
            <a:pPr marL="0" indent="0">
              <a:buNone/>
            </a:pPr>
            <a:r>
              <a:rPr lang="en-US" sz="2000" b="1" dirty="0"/>
              <a:t>Cysts</a:t>
            </a:r>
            <a:endParaRPr lang="en-US" sz="2000" dirty="0"/>
          </a:p>
          <a:p>
            <a:r>
              <a:rPr lang="en-US" sz="2000" dirty="0"/>
              <a:t>Encapsulated pocket of fluid, tissue, secretions, or gas</a:t>
            </a:r>
          </a:p>
          <a:p>
            <a:r>
              <a:rPr lang="en-US" sz="2000" dirty="0"/>
              <a:t>May or may not be infected</a:t>
            </a:r>
          </a:p>
          <a:p>
            <a:r>
              <a:rPr lang="en-US" sz="2000" dirty="0"/>
              <a:t>Examples: sebaceous, pilar (hair follicle), Meibomian (eyelid), ganglion (synovium)</a:t>
            </a:r>
          </a:p>
          <a:p>
            <a:pPr marL="0" indent="0">
              <a:buNone/>
            </a:pPr>
            <a:r>
              <a:rPr lang="en-US" sz="2000" b="1" dirty="0"/>
              <a:t>Abscesses</a:t>
            </a:r>
            <a:endParaRPr lang="en-US" sz="2000" dirty="0"/>
          </a:p>
          <a:p>
            <a:r>
              <a:rPr lang="en-US" sz="2000" dirty="0"/>
              <a:t>Localized infection with pus + inflamed tissue</a:t>
            </a:r>
          </a:p>
          <a:p>
            <a:r>
              <a:rPr lang="en-US" sz="2000" dirty="0"/>
              <a:t>May be encapsulated, may contain foreign bodies, microbes, sebum</a:t>
            </a:r>
          </a:p>
          <a:p>
            <a:r>
              <a:rPr lang="en-US" sz="2000" dirty="0"/>
              <a:t>Examples: furuncle/carbuncle (skin), paronychia (nail fold), felon (finger/toe), hordeolum (eyelid)</a:t>
            </a:r>
          </a:p>
        </p:txBody>
      </p:sp>
      <p:pic>
        <p:nvPicPr>
          <p:cNvPr id="4" name="Picture 3" descr="A dough and some pills on a table&#10;&#10;Description automatically generated">
            <a:extLst>
              <a:ext uri="{FF2B5EF4-FFF2-40B4-BE49-F238E27FC236}">
                <a16:creationId xmlns:a16="http://schemas.microsoft.com/office/drawing/2014/main" id="{E30DB160-941B-24DD-3127-58F59F446CB4}"/>
              </a:ext>
            </a:extLst>
          </p:cNvPr>
          <p:cNvPicPr>
            <a:picLocks noChangeAspect="1"/>
          </p:cNvPicPr>
          <p:nvPr/>
        </p:nvPicPr>
        <p:blipFill>
          <a:blip r:embed="rId3" cstate="print">
            <a:extLst>
              <a:ext uri="{28A0092B-C50C-407E-A947-70E740481C1C}">
                <a14:useLocalDpi xmlns:a14="http://schemas.microsoft.com/office/drawing/2010/main" val="0"/>
              </a:ext>
            </a:extLst>
          </a:blip>
          <a:srcRect r="3424" b="2"/>
          <a:stretch>
            <a:fillRect/>
          </a:stretch>
        </p:blipFill>
        <p:spPr>
          <a:xfrm rot="5400000">
            <a:off x="6090456" y="756455"/>
            <a:ext cx="6868886" cy="5334204"/>
          </a:xfrm>
          <a:prstGeom prst="rect">
            <a:avLst/>
          </a:prstGeom>
          <a:effectLst>
            <a:outerShdw blurRad="127000" dist="50800" dir="10800000" sx="99000" sy="99000" algn="r" rotWithShape="0">
              <a:prstClr val="black">
                <a:alpha val="40000"/>
              </a:prstClr>
            </a:outerShdw>
          </a:effectLst>
        </p:spPr>
      </p:pic>
      <p:sp>
        <p:nvSpPr>
          <p:cNvPr id="5" name="TextBox 4">
            <a:extLst>
              <a:ext uri="{FF2B5EF4-FFF2-40B4-BE49-F238E27FC236}">
                <a16:creationId xmlns:a16="http://schemas.microsoft.com/office/drawing/2014/main" id="{D705FCC5-6EF3-EE16-60CA-90343111F10A}"/>
              </a:ext>
            </a:extLst>
          </p:cNvPr>
          <p:cNvSpPr txBox="1"/>
          <p:nvPr/>
        </p:nvSpPr>
        <p:spPr>
          <a:xfrm>
            <a:off x="7400150" y="6286300"/>
            <a:ext cx="2124749" cy="369332"/>
          </a:xfrm>
          <a:prstGeom prst="rect">
            <a:avLst/>
          </a:prstGeom>
          <a:noFill/>
        </p:spPr>
        <p:txBody>
          <a:bodyPr wrap="none" rtlCol="0">
            <a:spAutoFit/>
          </a:bodyPr>
          <a:lstStyle/>
          <a:p>
            <a:r>
              <a:rPr lang="en-US" i="1" dirty="0"/>
              <a:t>Authors’ own image.</a:t>
            </a:r>
            <a:endParaRPr lang="en-US" dirty="0"/>
          </a:p>
        </p:txBody>
      </p:sp>
    </p:spTree>
    <p:extLst>
      <p:ext uri="{BB962C8B-B14F-4D97-AF65-F5344CB8AC3E}">
        <p14:creationId xmlns:p14="http://schemas.microsoft.com/office/powerpoint/2010/main" val="36718670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2055" name="Rectangle 2054">
            <a:extLst>
              <a:ext uri="{FF2B5EF4-FFF2-40B4-BE49-F238E27FC236}">
                <a16:creationId xmlns:a16="http://schemas.microsoft.com/office/drawing/2014/main" id="{D1D34770-47A8-402C-AF23-2B653F2D88C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12188952"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AD735156-408C-488F-865E-532AC1EEA52F}"/>
              </a:ext>
            </a:extLst>
          </p:cNvPr>
          <p:cNvSpPr>
            <a:spLocks noGrp="1"/>
          </p:cNvSpPr>
          <p:nvPr>
            <p:ph type="title"/>
          </p:nvPr>
        </p:nvSpPr>
        <p:spPr>
          <a:xfrm>
            <a:off x="836680" y="454821"/>
            <a:ext cx="6002110" cy="1495425"/>
          </a:xfrm>
        </p:spPr>
        <p:txBody>
          <a:bodyPr>
            <a:normAutofit/>
          </a:bodyPr>
          <a:lstStyle/>
          <a:p>
            <a:pPr algn="ctr"/>
            <a:r>
              <a:rPr lang="en-US" sz="4000" b="1" dirty="0"/>
              <a:t>Abscess</a:t>
            </a:r>
          </a:p>
        </p:txBody>
      </p:sp>
      <p:sp>
        <p:nvSpPr>
          <p:cNvPr id="3" name="Content Placeholder 2">
            <a:extLst>
              <a:ext uri="{FF2B5EF4-FFF2-40B4-BE49-F238E27FC236}">
                <a16:creationId xmlns:a16="http://schemas.microsoft.com/office/drawing/2014/main" id="{DCCA220F-26B1-4B50-9593-1EF6CAA6A487}"/>
              </a:ext>
            </a:extLst>
          </p:cNvPr>
          <p:cNvSpPr>
            <a:spLocks noGrp="1"/>
          </p:cNvSpPr>
          <p:nvPr>
            <p:ph idx="1"/>
          </p:nvPr>
        </p:nvSpPr>
        <p:spPr>
          <a:xfrm>
            <a:off x="836680" y="1643063"/>
            <a:ext cx="6002110" cy="4491038"/>
          </a:xfrm>
        </p:spPr>
        <p:txBody>
          <a:bodyPr>
            <a:noAutofit/>
          </a:bodyPr>
          <a:lstStyle/>
          <a:p>
            <a:pPr marL="0" indent="0">
              <a:buNone/>
            </a:pPr>
            <a:r>
              <a:rPr lang="en-US" sz="1800" b="1" dirty="0"/>
              <a:t>Etiology</a:t>
            </a:r>
            <a:endParaRPr lang="en-US" sz="1800" dirty="0"/>
          </a:p>
          <a:p>
            <a:r>
              <a:rPr lang="en-US" sz="1800" dirty="0"/>
              <a:t>Usually </a:t>
            </a:r>
            <a:r>
              <a:rPr lang="en-US" sz="1800" i="1" dirty="0"/>
              <a:t>S. aureus</a:t>
            </a:r>
          </a:p>
          <a:p>
            <a:r>
              <a:rPr lang="en-US" sz="1800" dirty="0"/>
              <a:t>Sometimes Strep or mixed flora (site-dependent)</a:t>
            </a:r>
          </a:p>
          <a:p>
            <a:pPr marL="0" indent="0">
              <a:buNone/>
            </a:pPr>
            <a:r>
              <a:rPr lang="en-US" sz="1800" b="1" dirty="0"/>
              <a:t>Treatment</a:t>
            </a:r>
            <a:endParaRPr lang="en-US" sz="1800" dirty="0"/>
          </a:p>
          <a:p>
            <a:r>
              <a:rPr lang="en-US" sz="1800" b="1" dirty="0"/>
              <a:t>Small (&lt;5 mm, superficial):</a:t>
            </a:r>
            <a:r>
              <a:rPr lang="en-US" sz="1800" dirty="0"/>
              <a:t> warm compresses → spontaneous drainage</a:t>
            </a:r>
          </a:p>
          <a:p>
            <a:r>
              <a:rPr lang="en-US" sz="1800" b="1" dirty="0"/>
              <a:t>Mainstay:</a:t>
            </a:r>
            <a:r>
              <a:rPr lang="en-US" sz="1800" dirty="0"/>
              <a:t> Incision &amp; Drainage (I&amp;D)</a:t>
            </a:r>
          </a:p>
          <a:p>
            <a:pPr marL="0" indent="0">
              <a:buNone/>
            </a:pPr>
            <a:r>
              <a:rPr lang="en-US" sz="1800" b="1" dirty="0"/>
              <a:t>Antibiotics</a:t>
            </a:r>
            <a:endParaRPr lang="en-US" sz="1800" dirty="0"/>
          </a:p>
          <a:p>
            <a:r>
              <a:rPr lang="en-US" sz="1800" dirty="0"/>
              <a:t>Add if risk factors for MRSA (colonization, healthcare exposure, recent antibiotics, IV drug user, close contact)</a:t>
            </a:r>
          </a:p>
          <a:p>
            <a:r>
              <a:rPr lang="en-US" sz="1800" dirty="0"/>
              <a:t>Options: TMP-SMX, doxycycline, clindamycin</a:t>
            </a:r>
          </a:p>
          <a:p>
            <a:pPr marL="0" indent="0">
              <a:buNone/>
            </a:pPr>
            <a:r>
              <a:rPr lang="en-US" sz="1800" b="1" dirty="0"/>
              <a:t>Special Locations</a:t>
            </a:r>
            <a:endParaRPr lang="en-US" sz="1800" dirty="0"/>
          </a:p>
          <a:p>
            <a:r>
              <a:rPr lang="en-US" sz="1800" dirty="0"/>
              <a:t>Facial triangle, axilla, perianal → higher risk</a:t>
            </a:r>
          </a:p>
          <a:p>
            <a:r>
              <a:rPr lang="en-US" sz="1800" dirty="0"/>
              <a:t>Perirectal abscess → consider CT pelvis w/ contrast</a:t>
            </a:r>
          </a:p>
        </p:txBody>
      </p:sp>
      <p:pic>
        <p:nvPicPr>
          <p:cNvPr id="4" name="Picture 3" descr="A syringe in a dough&#10;&#10;Description automatically generated">
            <a:extLst>
              <a:ext uri="{FF2B5EF4-FFF2-40B4-BE49-F238E27FC236}">
                <a16:creationId xmlns:a16="http://schemas.microsoft.com/office/drawing/2014/main" id="{1F9E92AA-74A8-B018-1654-42EBEF028074}"/>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rot="5400000">
            <a:off x="5904480" y="1092835"/>
            <a:ext cx="6229350" cy="4672330"/>
          </a:xfrm>
          <a:prstGeom prst="rect">
            <a:avLst/>
          </a:prstGeom>
        </p:spPr>
      </p:pic>
      <p:sp>
        <p:nvSpPr>
          <p:cNvPr id="5" name="TextBox 4">
            <a:extLst>
              <a:ext uri="{FF2B5EF4-FFF2-40B4-BE49-F238E27FC236}">
                <a16:creationId xmlns:a16="http://schemas.microsoft.com/office/drawing/2014/main" id="{41503C3F-D279-1E11-BAF0-DCC1428EC815}"/>
              </a:ext>
            </a:extLst>
          </p:cNvPr>
          <p:cNvSpPr txBox="1"/>
          <p:nvPr/>
        </p:nvSpPr>
        <p:spPr>
          <a:xfrm>
            <a:off x="9230571" y="6146840"/>
            <a:ext cx="2124749" cy="369332"/>
          </a:xfrm>
          <a:prstGeom prst="rect">
            <a:avLst/>
          </a:prstGeom>
          <a:noFill/>
        </p:spPr>
        <p:txBody>
          <a:bodyPr wrap="none" rtlCol="0">
            <a:spAutoFit/>
          </a:bodyPr>
          <a:lstStyle/>
          <a:p>
            <a:r>
              <a:rPr lang="en-US" i="1" dirty="0"/>
              <a:t>Authors’ own image.</a:t>
            </a:r>
            <a:endParaRPr lang="en-US" dirty="0"/>
          </a:p>
        </p:txBody>
      </p:sp>
    </p:spTree>
    <p:extLst>
      <p:ext uri="{BB962C8B-B14F-4D97-AF65-F5344CB8AC3E}">
        <p14:creationId xmlns:p14="http://schemas.microsoft.com/office/powerpoint/2010/main" val="292691921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90" name="!!Rectangle">
            <a:extLst>
              <a:ext uri="{FF2B5EF4-FFF2-40B4-BE49-F238E27FC236}">
                <a16:creationId xmlns:a16="http://schemas.microsoft.com/office/drawing/2014/main" id="{362810D9-2C5A-477D-949C-C191895477F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8467"/>
            <a:ext cx="12191999" cy="6866467"/>
          </a:xfrm>
          <a:prstGeom prst="rect">
            <a:avLst/>
          </a:prstGeom>
          <a:solidFill>
            <a:srgbClr val="00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pic>
        <p:nvPicPr>
          <p:cNvPr id="5" name="Picture 4" descr="A person in gloves using a needle to insert a needle into a human body&#10;&#10;Description automatically generated">
            <a:extLst>
              <a:ext uri="{FF2B5EF4-FFF2-40B4-BE49-F238E27FC236}">
                <a16:creationId xmlns:a16="http://schemas.microsoft.com/office/drawing/2014/main" id="{80B382DC-080D-48BB-277B-84279CD41240}"/>
              </a:ext>
            </a:extLst>
          </p:cNvPr>
          <p:cNvPicPr>
            <a:picLocks noChangeAspect="1"/>
          </p:cNvPicPr>
          <p:nvPr/>
        </p:nvPicPr>
        <p:blipFill>
          <a:blip r:embed="rId3" cstate="print">
            <a:alphaModFix amt="55000"/>
            <a:extLst>
              <a:ext uri="{28A0092B-C50C-407E-A947-70E740481C1C}">
                <a14:useLocalDpi xmlns:a14="http://schemas.microsoft.com/office/drawing/2010/main" val="0"/>
              </a:ext>
            </a:extLst>
          </a:blip>
          <a:srcRect l="15140" r="42672"/>
          <a:stretch>
            <a:fillRect/>
          </a:stretch>
        </p:blipFill>
        <p:spPr>
          <a:xfrm rot="5400000">
            <a:off x="2667000" y="-2676107"/>
            <a:ext cx="6858000" cy="12192000"/>
          </a:xfrm>
          <a:prstGeom prst="rect">
            <a:avLst/>
          </a:prstGeom>
        </p:spPr>
      </p:pic>
      <p:sp>
        <p:nvSpPr>
          <p:cNvPr id="2" name="Title 1">
            <a:extLst>
              <a:ext uri="{FF2B5EF4-FFF2-40B4-BE49-F238E27FC236}">
                <a16:creationId xmlns:a16="http://schemas.microsoft.com/office/drawing/2014/main" id="{6E205B13-3528-4699-9233-F5A5A7AE9BF6}"/>
              </a:ext>
            </a:extLst>
          </p:cNvPr>
          <p:cNvSpPr>
            <a:spLocks noGrp="1"/>
          </p:cNvSpPr>
          <p:nvPr>
            <p:ph type="title"/>
          </p:nvPr>
        </p:nvSpPr>
        <p:spPr>
          <a:xfrm>
            <a:off x="686834" y="591344"/>
            <a:ext cx="3200400" cy="5585619"/>
          </a:xfrm>
        </p:spPr>
        <p:txBody>
          <a:bodyPr>
            <a:normAutofit/>
          </a:bodyPr>
          <a:lstStyle/>
          <a:p>
            <a:r>
              <a:rPr lang="en-US" b="1">
                <a:solidFill>
                  <a:srgbClr val="FFFFFF"/>
                </a:solidFill>
              </a:rPr>
              <a:t>Abscess I&amp;D</a:t>
            </a:r>
          </a:p>
        </p:txBody>
      </p:sp>
      <p:sp>
        <p:nvSpPr>
          <p:cNvPr id="3092" name="Arc 3091">
            <a:extLst>
              <a:ext uri="{FF2B5EF4-FFF2-40B4-BE49-F238E27FC236}">
                <a16:creationId xmlns:a16="http://schemas.microsoft.com/office/drawing/2014/main" id="{081E4A58-353D-44AE-B2FC-2A74E2E400F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V="1">
            <a:off x="7550402" y="2455479"/>
            <a:ext cx="4083433" cy="4083433"/>
          </a:xfrm>
          <a:prstGeom prst="arc">
            <a:avLst/>
          </a:prstGeom>
          <a:ln w="127000" cap="rnd">
            <a:solidFill>
              <a:schemeClr val="accent4"/>
            </a:solidFill>
            <a:prstDash val="dash"/>
          </a:ln>
        </p:spPr>
        <p:style>
          <a:lnRef idx="1">
            <a:schemeClr val="accent1"/>
          </a:lnRef>
          <a:fillRef idx="0">
            <a:schemeClr val="accent1"/>
          </a:fillRef>
          <a:effectRef idx="0">
            <a:schemeClr val="accent1"/>
          </a:effectRef>
          <a:fontRef idx="minor">
            <a:schemeClr val="tx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
        <p:nvSpPr>
          <p:cNvPr id="3" name="Content Placeholder 2">
            <a:extLst>
              <a:ext uri="{FF2B5EF4-FFF2-40B4-BE49-F238E27FC236}">
                <a16:creationId xmlns:a16="http://schemas.microsoft.com/office/drawing/2014/main" id="{13B5382F-2835-4FE1-BAD3-5D58199896F9}"/>
              </a:ext>
            </a:extLst>
          </p:cNvPr>
          <p:cNvSpPr>
            <a:spLocks noGrp="1"/>
          </p:cNvSpPr>
          <p:nvPr>
            <p:ph idx="1"/>
          </p:nvPr>
        </p:nvSpPr>
        <p:spPr>
          <a:xfrm>
            <a:off x="4447308" y="591344"/>
            <a:ext cx="7186527" cy="5947568"/>
          </a:xfrm>
        </p:spPr>
        <p:txBody>
          <a:bodyPr anchor="ctr">
            <a:noAutofit/>
          </a:bodyPr>
          <a:lstStyle/>
          <a:p>
            <a:pPr marL="0" indent="0">
              <a:buNone/>
            </a:pPr>
            <a:r>
              <a:rPr lang="en-US" sz="2000" b="1" dirty="0">
                <a:solidFill>
                  <a:srgbClr val="FFFFFF"/>
                </a:solidFill>
              </a:rPr>
              <a:t>Aseptic Prep</a:t>
            </a:r>
            <a:endParaRPr lang="en-US" sz="2000" dirty="0">
              <a:solidFill>
                <a:srgbClr val="FFFFFF"/>
              </a:solidFill>
            </a:endParaRPr>
          </a:p>
          <a:p>
            <a:r>
              <a:rPr lang="en-US" sz="2000" dirty="0">
                <a:solidFill>
                  <a:srgbClr val="FFFFFF"/>
                </a:solidFill>
              </a:rPr>
              <a:t>Clean with alcohol or povidone-iodine</a:t>
            </a:r>
          </a:p>
          <a:p>
            <a:r>
              <a:rPr lang="en-US" sz="2000" dirty="0">
                <a:solidFill>
                  <a:srgbClr val="FFFFFF"/>
                </a:solidFill>
              </a:rPr>
              <a:t>Apply sterile drape</a:t>
            </a:r>
          </a:p>
          <a:p>
            <a:r>
              <a:rPr lang="en-US" sz="2000" dirty="0">
                <a:solidFill>
                  <a:srgbClr val="FFFFFF"/>
                </a:solidFill>
              </a:rPr>
              <a:t>Use sterile gloves/instruments</a:t>
            </a:r>
          </a:p>
          <a:p>
            <a:pPr marL="0" indent="0">
              <a:buNone/>
            </a:pPr>
            <a:r>
              <a:rPr lang="en-US" sz="2000" b="1" dirty="0">
                <a:solidFill>
                  <a:srgbClr val="FFFFFF"/>
                </a:solidFill>
              </a:rPr>
              <a:t>Anesthesia</a:t>
            </a:r>
            <a:endParaRPr lang="en-US" sz="2000" dirty="0">
              <a:solidFill>
                <a:srgbClr val="FFFFFF"/>
              </a:solidFill>
            </a:endParaRPr>
          </a:p>
          <a:p>
            <a:r>
              <a:rPr lang="en-US" sz="2000" dirty="0">
                <a:solidFill>
                  <a:srgbClr val="FFFFFF"/>
                </a:solidFill>
              </a:rPr>
              <a:t>Field block: 1–2% lidocaine ± epi</a:t>
            </a:r>
          </a:p>
          <a:p>
            <a:pPr marL="0" indent="0">
              <a:buNone/>
            </a:pPr>
            <a:r>
              <a:rPr lang="en-US" sz="2000" b="1" dirty="0">
                <a:solidFill>
                  <a:srgbClr val="FFFFFF"/>
                </a:solidFill>
              </a:rPr>
              <a:t>Incision</a:t>
            </a:r>
            <a:endParaRPr lang="en-US" sz="2000" dirty="0">
              <a:solidFill>
                <a:srgbClr val="FFFFFF"/>
              </a:solidFill>
            </a:endParaRPr>
          </a:p>
          <a:p>
            <a:r>
              <a:rPr lang="en-US" sz="2000" dirty="0">
                <a:solidFill>
                  <a:srgbClr val="FFFFFF"/>
                </a:solidFill>
              </a:rPr>
              <a:t>#11 blade, straight incision</a:t>
            </a:r>
          </a:p>
          <a:p>
            <a:r>
              <a:rPr lang="en-US" sz="2000" dirty="0">
                <a:solidFill>
                  <a:srgbClr val="FFFFFF"/>
                </a:solidFill>
              </a:rPr>
              <a:t>Large abscess → consider elliptical</a:t>
            </a:r>
          </a:p>
          <a:p>
            <a:r>
              <a:rPr lang="en-US" sz="2000" dirty="0">
                <a:solidFill>
                  <a:srgbClr val="FFFFFF"/>
                </a:solidFill>
              </a:rPr>
              <a:t>PPE: gown, face/eye shield</a:t>
            </a:r>
          </a:p>
          <a:p>
            <a:pPr marL="0" indent="0">
              <a:buNone/>
            </a:pPr>
            <a:r>
              <a:rPr lang="en-US" sz="2000" b="1" dirty="0">
                <a:solidFill>
                  <a:srgbClr val="FFFFFF"/>
                </a:solidFill>
              </a:rPr>
              <a:t>Drain</a:t>
            </a:r>
            <a:endParaRPr lang="en-US" sz="2000" dirty="0">
              <a:solidFill>
                <a:srgbClr val="FFFFFF"/>
              </a:solidFill>
            </a:endParaRPr>
          </a:p>
          <a:p>
            <a:r>
              <a:rPr lang="en-US" sz="2000" dirty="0">
                <a:solidFill>
                  <a:srgbClr val="FFFFFF"/>
                </a:solidFill>
              </a:rPr>
              <a:t>Pus often releases spontaneously</a:t>
            </a:r>
          </a:p>
          <a:p>
            <a:r>
              <a:rPr lang="en-US" sz="2000" dirty="0">
                <a:solidFill>
                  <a:srgbClr val="FFFFFF"/>
                </a:solidFill>
              </a:rPr>
              <a:t>Apply pressure + blunt dissection for loculations</a:t>
            </a:r>
          </a:p>
          <a:p>
            <a:r>
              <a:rPr lang="en-US" sz="2000" dirty="0">
                <a:solidFill>
                  <a:srgbClr val="FFFFFF"/>
                </a:solidFill>
              </a:rPr>
              <a:t>Continue until only blood expressed</a:t>
            </a:r>
          </a:p>
          <a:p>
            <a:pPr marL="0" indent="0">
              <a:buNone/>
            </a:pPr>
            <a:r>
              <a:rPr lang="en-US" sz="2000" b="1" dirty="0">
                <a:solidFill>
                  <a:srgbClr val="FFFFFF"/>
                </a:solidFill>
              </a:rPr>
              <a:t>Culture</a:t>
            </a:r>
            <a:endParaRPr lang="en-US" sz="2000" dirty="0">
              <a:solidFill>
                <a:srgbClr val="FFFFFF"/>
              </a:solidFill>
            </a:endParaRPr>
          </a:p>
          <a:p>
            <a:r>
              <a:rPr lang="en-US" sz="2000" dirty="0">
                <a:solidFill>
                  <a:srgbClr val="FFFFFF"/>
                </a:solidFill>
              </a:rPr>
              <a:t>Collect specimen from pus (not skin)</a:t>
            </a:r>
          </a:p>
        </p:txBody>
      </p:sp>
      <p:sp>
        <p:nvSpPr>
          <p:cNvPr id="6" name="TextBox 5">
            <a:extLst>
              <a:ext uri="{FF2B5EF4-FFF2-40B4-BE49-F238E27FC236}">
                <a16:creationId xmlns:a16="http://schemas.microsoft.com/office/drawing/2014/main" id="{E66AFF23-0630-AFB8-AA50-952524BF9DA6}"/>
              </a:ext>
            </a:extLst>
          </p:cNvPr>
          <p:cNvSpPr txBox="1"/>
          <p:nvPr/>
        </p:nvSpPr>
        <p:spPr>
          <a:xfrm>
            <a:off x="177169" y="6407442"/>
            <a:ext cx="2124749" cy="369332"/>
          </a:xfrm>
          <a:prstGeom prst="rect">
            <a:avLst/>
          </a:prstGeom>
          <a:noFill/>
        </p:spPr>
        <p:txBody>
          <a:bodyPr wrap="none" rtlCol="0">
            <a:spAutoFit/>
          </a:bodyPr>
          <a:lstStyle/>
          <a:p>
            <a:r>
              <a:rPr lang="en-US" i="1" dirty="0">
                <a:solidFill>
                  <a:schemeClr val="bg1"/>
                </a:solidFill>
              </a:rPr>
              <a:t>Authors’ own image.</a:t>
            </a:r>
            <a:endParaRPr lang="en-US" dirty="0">
              <a:solidFill>
                <a:schemeClr val="bg1"/>
              </a:solidFill>
            </a:endParaRPr>
          </a:p>
        </p:txBody>
      </p:sp>
    </p:spTree>
    <p:extLst>
      <p:ext uri="{BB962C8B-B14F-4D97-AF65-F5344CB8AC3E}">
        <p14:creationId xmlns:p14="http://schemas.microsoft.com/office/powerpoint/2010/main" val="26203536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17</TotalTime>
  <Words>2092</Words>
  <Application>Microsoft Macintosh PowerPoint</Application>
  <PresentationFormat>Widescreen</PresentationFormat>
  <Paragraphs>171</Paragraphs>
  <Slides>12</Slides>
  <Notes>12</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2</vt:i4>
      </vt:variant>
    </vt:vector>
  </HeadingPairs>
  <TitlesOfParts>
    <vt:vector size="20" baseType="lpstr">
      <vt:lpstr>Arial</vt:lpstr>
      <vt:lpstr>Calibri</vt:lpstr>
      <vt:lpstr>Calibri Light</vt:lpstr>
      <vt:lpstr>Söhne</vt:lpstr>
      <vt:lpstr>Symbol</vt:lpstr>
      <vt:lpstr>Times New Roman</vt:lpstr>
      <vt:lpstr>Wingdings</vt:lpstr>
      <vt:lpstr>Office Theme</vt:lpstr>
      <vt:lpstr>Abscess I&amp;D</vt:lpstr>
      <vt:lpstr>Learning Objectives</vt:lpstr>
      <vt:lpstr>Lecture Outline</vt:lpstr>
      <vt:lpstr>Drawing-up Local Anesthetic</vt:lpstr>
      <vt:lpstr>Field Block</vt:lpstr>
      <vt:lpstr>Lecture Outline</vt:lpstr>
      <vt:lpstr>Cyst and Abscess </vt:lpstr>
      <vt:lpstr>Abscess</vt:lpstr>
      <vt:lpstr>Abscess I&amp;D</vt:lpstr>
      <vt:lpstr>PowerPoint Presentation</vt:lpstr>
      <vt:lpstr>Abscess I&amp;D Video</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bscess I&amp;D Subungual Hematoma Trephination Nail Removal</dc:title>
  <dc:creator>McNeal, Patrick</dc:creator>
  <cp:lastModifiedBy>Wray, Alisa</cp:lastModifiedBy>
  <cp:revision>13</cp:revision>
  <dcterms:created xsi:type="dcterms:W3CDTF">2019-12-16T17:27:39Z</dcterms:created>
  <dcterms:modified xsi:type="dcterms:W3CDTF">2025-10-25T18:34:33Z</dcterms:modified>
</cp:coreProperties>
</file>